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76.jpeg" ContentType="image/jpeg"/>
  <Override PartName="/ppt/media/image53.png" ContentType="image/png"/>
  <Override PartName="/ppt/media/image51.jpeg" ContentType="image/jpeg"/>
  <Override PartName="/ppt/media/image48.png" ContentType="image/png"/>
  <Override PartName="/ppt/media/image47.jpeg" ContentType="image/jpeg"/>
  <Override PartName="/ppt/media/image46.jpeg" ContentType="image/jpeg"/>
  <Override PartName="/ppt/media/image58.png" ContentType="image/png"/>
  <Override PartName="/ppt/media/image45.png" ContentType="image/png"/>
  <Override PartName="/ppt/media/image44.jpeg" ContentType="image/jpeg"/>
  <Override PartName="/ppt/media/image38.png" ContentType="image/png"/>
  <Override PartName="/ppt/media/image42.jpeg" ContentType="image/jpeg"/>
  <Override PartName="/ppt/media/image6.png" ContentType="image/png"/>
  <Override PartName="/ppt/media/image83.png" ContentType="image/png"/>
  <Override PartName="/ppt/media/image41.png" ContentType="image/png"/>
  <Override PartName="/ppt/media/image3.jpeg" ContentType="image/jpeg"/>
  <Override PartName="/ppt/media/image43.jpeg" ContentType="image/jpeg"/>
  <Override PartName="/ppt/media/image28.png" ContentType="image/png"/>
  <Override PartName="/ppt/media/image93.png" ContentType="image/png"/>
  <Override PartName="/ppt/media/image35.png" ContentType="image/png"/>
  <Override PartName="/ppt/media/image34.png" ContentType="image/png"/>
  <Override PartName="/ppt/media/image74.jpeg" ContentType="image/jpeg"/>
  <Override PartName="/ppt/media/image33.jpeg" ContentType="image/jpeg"/>
  <Override PartName="/ppt/media/image32.jpeg" ContentType="image/jpeg"/>
  <Override PartName="/ppt/media/image31.jpeg" ContentType="image/jpeg"/>
  <Override PartName="/ppt/media/image13.png" ContentType="image/png"/>
  <Override PartName="/ppt/media/image52.jpeg" ContentType="image/jpeg"/>
  <Override PartName="/ppt/media/image11.jpeg" ContentType="image/jpeg"/>
  <Override PartName="/ppt/media/image8.png" ContentType="image/png"/>
  <Override PartName="/ppt/media/image49.png" ContentType="image/png"/>
  <Override PartName="/ppt/media/image65.jpeg" ContentType="image/jpeg"/>
  <Override PartName="/ppt/media/image12.png" ContentType="image/png"/>
  <Override PartName="/ppt/media/image37.png" ContentType="image/png"/>
  <Override PartName="/ppt/media/image7.png" ContentType="image/png"/>
  <Override PartName="/ppt/media/image19.png" ContentType="image/png"/>
  <Override PartName="/ppt/media/image20.png" ContentType="image/png"/>
  <Override PartName="/ppt/media/image57.png" ContentType="image/png"/>
  <Override PartName="/ppt/media/image23.png" ContentType="image/png"/>
  <Override PartName="/ppt/media/image60.png" ContentType="image/png"/>
  <Override PartName="/ppt/media/image36.png" ContentType="image/png"/>
  <Override PartName="/ppt/media/image62.png" ContentType="image/png"/>
  <Override PartName="/ppt/media/image96.jpeg" ContentType="image/jpeg"/>
  <Override PartName="/ppt/media/image81.jpeg" ContentType="image/jpeg"/>
  <Override PartName="/ppt/media/image22.jpeg" ContentType="image/jpeg"/>
  <Override PartName="/ppt/media/image9.png" ContentType="image/png"/>
  <Override PartName="/ppt/media/image67.jpeg" ContentType="image/jpeg"/>
  <Override PartName="/ppt/media/image69.png" ContentType="image/png"/>
  <Override PartName="/ppt/media/image68.jpeg" ContentType="image/jpeg"/>
  <Override PartName="/ppt/media/image79.png" ContentType="image/png"/>
  <Override PartName="/ppt/media/image70.jpeg" ContentType="image/jpeg"/>
  <Override PartName="/ppt/media/image78.jpeg" ContentType="image/jpeg"/>
  <Override PartName="/ppt/media/image61.jpeg" ContentType="image/jpeg"/>
  <Override PartName="/ppt/media/image4.jpeg" ContentType="image/jpeg"/>
  <Override PartName="/ppt/media/image40.png" ContentType="image/png"/>
  <Override PartName="/ppt/media/image63.png" ContentType="image/png"/>
  <Override PartName="/ppt/media/image26.jpeg" ContentType="image/jpeg"/>
  <Override PartName="/ppt/media/image85.jpeg" ContentType="image/jpeg"/>
  <Override PartName="/ppt/media/image98.png" ContentType="image/png"/>
  <Override PartName="/ppt/media/image94.jpeg" ContentType="image/jpeg"/>
  <Override PartName="/ppt/media/image77.jpeg" ContentType="image/jpeg"/>
  <Override PartName="/ppt/media/image80.jpeg" ContentType="image/jpeg"/>
  <Override PartName="/ppt/media/image71.jpeg" ContentType="image/jpeg"/>
  <Override PartName="/ppt/media/image82.png" ContentType="image/png"/>
  <Override PartName="/ppt/media/image95.jpeg" ContentType="image/jpeg"/>
  <Override PartName="/ppt/media/image91.jpeg" ContentType="image/jpeg"/>
  <Override PartName="/ppt/media/image39.png" ContentType="image/png"/>
  <Override PartName="/ppt/media/image64.jpeg" ContentType="image/jpeg"/>
  <Override PartName="/ppt/media/image75.jpeg" ContentType="image/jpeg"/>
  <Override PartName="/ppt/media/image90.png" ContentType="image/png"/>
  <Override PartName="/ppt/media/image88.png" ContentType="image/png"/>
  <Override PartName="/ppt/media/image97.jpeg" ContentType="image/jpeg"/>
  <Override PartName="/ppt/media/image87.png" ContentType="image/png"/>
  <Override PartName="/ppt/media/image5.jpeg" ContentType="image/jpeg"/>
  <Override PartName="/ppt/media/image50.png" ContentType="image/png"/>
  <Override PartName="/ppt/media/image18.jpeg" ContentType="image/jpeg"/>
  <Override PartName="/ppt/media/image73.png" ContentType="image/png"/>
  <Override PartName="/ppt/media/image15.png" ContentType="image/png"/>
  <Override PartName="/ppt/media/image92.jpeg" ContentType="image/jpeg"/>
  <Override PartName="/ppt/media/image17.jpeg" ContentType="image/jpeg"/>
  <Override PartName="/ppt/media/image16.jpeg" ContentType="image/jpeg"/>
  <Override PartName="/ppt/media/image86.jpeg" ContentType="image/jpeg"/>
  <Override PartName="/ppt/media/image27.jpeg" ContentType="image/jpeg"/>
  <Override PartName="/ppt/media/image10.jpeg" ContentType="image/jpeg"/>
  <Override PartName="/ppt/media/image24.jpeg" ContentType="image/jpeg"/>
  <Override PartName="/ppt/media/image66.jpeg" ContentType="image/jpeg"/>
  <Override PartName="/ppt/media/image59.png" ContentType="image/png"/>
  <Override PartName="/ppt/media/image30.png" ContentType="image/png"/>
  <Override PartName="/ppt/media/image25.jpeg" ContentType="image/jpeg"/>
  <Override PartName="/ppt/media/image84.jpeg" ContentType="image/jpeg"/>
  <Override PartName="/ppt/media/image2.png" ContentType="image/png"/>
  <Override PartName="/ppt/media/image14.png" ContentType="image/png"/>
  <Override PartName="/ppt/media/image72.jpeg" ContentType="image/jpeg"/>
  <Override PartName="/ppt/media/image29.jpeg" ContentType="image/jpeg"/>
  <Override PartName="/ppt/media/image1.jpeg" ContentType="image/jpeg"/>
  <Override PartName="/ppt/media/image21.png" ContentType="image/png"/>
  <Override PartName="/ppt/media/image89.jpeg" ContentType="image/jpeg"/>
  <Override PartName="/ppt/presProps.xml" ContentType="application/vnd.openxmlformats-officedocument.presentationml.presProps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54.xml" ContentType="application/vnd.openxmlformats-officedocument.presentationml.slide+xml"/>
  <Override PartName="/ppt/slides/slide53.xml" ContentType="application/vnd.openxmlformats-officedocument.presentationml.slide+xml"/>
  <Override PartName="/ppt/slides/slide52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6.xml" ContentType="application/vnd.openxmlformats-officedocument.presentationml.slide+xml"/>
  <Override PartName="/ppt/slides/slide45.xml" ContentType="application/vnd.openxmlformats-officedocument.presentationml.slide+xml"/>
  <Override PartName="/ppt/slides/slide39.xml" ContentType="application/vnd.openxmlformats-officedocument.presentationml.slide+xml"/>
  <Override PartName="/ppt/slides/slide38.xml" ContentType="application/vnd.openxmlformats-officedocument.presentationml.slide+xml"/>
  <Override PartName="/ppt/slides/slide37.xml" ContentType="application/vnd.openxmlformats-officedocument.presentationml.slide+xml"/>
  <Override PartName="/ppt/slides/slide36.xml" ContentType="application/vnd.openxmlformats-officedocument.presentationml.slide+xml"/>
  <Override PartName="/ppt/slides/slide35.xml" ContentType="application/vnd.openxmlformats-officedocument.presentationml.slide+xml"/>
  <Override PartName="/ppt/slides/slide18.xml" ContentType="application/vnd.openxmlformats-officedocument.presentationml.slide+xml"/>
  <Override PartName="/ppt/slides/slide60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19.xml" ContentType="application/vnd.openxmlformats-officedocument.presentationml.slide+xml"/>
  <Override PartName="/ppt/slides/slide61.xml" ContentType="application/vnd.openxmlformats-officedocument.presentationml.slide+xml"/>
  <Override PartName="/ppt/slides/slide21.xml" ContentType="application/vnd.openxmlformats-officedocument.presentationml.slide+xml"/>
  <Override PartName="/ppt/slides/slide58.xml" ContentType="application/vnd.openxmlformats-officedocument.presentationml.slide+xml"/>
  <Override PartName="/ppt/slides/slide22.xml" ContentType="application/vnd.openxmlformats-officedocument.presentationml.slide+xml"/>
  <Override PartName="/ppt/slides/slide59.xml" ContentType="application/vnd.openxmlformats-officedocument.presentationml.slide+xml"/>
  <Override PartName="/ppt/slides/slide23.xml" ContentType="application/vnd.openxmlformats-officedocument.presentationml.slide+xml"/>
  <Override PartName="/ppt/slides/slide73.xml" ContentType="application/vnd.openxmlformats-officedocument.presentationml.slide+xml"/>
  <Override PartName="/ppt/slides/slide1.xml" ContentType="application/vnd.openxmlformats-officedocument.presentationml.slide+xml"/>
  <Override PartName="/ppt/slides/slide24.xml" ContentType="application/vnd.openxmlformats-officedocument.presentationml.slide+xml"/>
  <Override PartName="/ppt/slides/slide72.xml" ContentType="application/vnd.openxmlformats-officedocument.presentationml.slide+xml"/>
  <Override PartName="/ppt/slides/slide71.xml" ContentType="application/vnd.openxmlformats-officedocument.presentationml.slide+xml"/>
  <Override PartName="/ppt/slides/slide29.xml" ContentType="application/vnd.openxmlformats-officedocument.presentationml.slide+xml"/>
  <Override PartName="/ppt/slides/slide69.xml" ContentType="application/vnd.openxmlformats-officedocument.presentationml.slide+xml"/>
  <Override PartName="/ppt/slides/slide32.xml" ContentType="application/vnd.openxmlformats-officedocument.presentationml.slide+xml"/>
  <Override PartName="/ppt/slides/slide70.xml" ContentType="application/vnd.openxmlformats-officedocument.presentationml.slide+xml"/>
  <Override PartName="/ppt/slides/slide28.xml" ContentType="application/vnd.openxmlformats-officedocument.presentationml.slide+xml"/>
  <Override PartName="/ppt/slides/slide68.xml" ContentType="application/vnd.openxmlformats-officedocument.presentationml.slide+xml"/>
  <Override PartName="/ppt/slides/slide31.xml" ContentType="application/vnd.openxmlformats-officedocument.presentationml.slide+xml"/>
  <Override PartName="/ppt/slides/slide67.xml" ContentType="application/vnd.openxmlformats-officedocument.presentationml.slide+xml"/>
  <Override PartName="/ppt/slides/slide30.xml" ContentType="application/vnd.openxmlformats-officedocument.presentationml.slide+xml"/>
  <Override PartName="/ppt/slides/slide66.xml" ContentType="application/vnd.openxmlformats-officedocument.presentationml.slide+xml"/>
  <Override PartName="/ppt/slides/slide65.xml" ContentType="application/vnd.openxmlformats-officedocument.presentationml.slide+xml"/>
  <Override PartName="/ppt/slides/slide27.xml" ContentType="application/vnd.openxmlformats-officedocument.presentationml.slide+xml"/>
  <Override PartName="/ppt/slides/slide64.xml" ContentType="application/vnd.openxmlformats-officedocument.presentationml.slide+xml"/>
  <Override PartName="/ppt/slides/slide26.xml" ContentType="application/vnd.openxmlformats-officedocument.presentationml.slide+xml"/>
  <Override PartName="/ppt/slides/slide63.xml" ContentType="application/vnd.openxmlformats-officedocument.presentationml.slide+xml"/>
  <Override PartName="/ppt/slides/slide25.xml" ContentType="application/vnd.openxmlformats-officedocument.presentationml.slide+xml"/>
  <Override PartName="/ppt/slides/slide62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14.xml" ContentType="application/vnd.openxmlformats-officedocument.presentationml.slide+xml"/>
  <Override PartName="/ppt/slides/slide7.xml" ContentType="application/vnd.openxmlformats-officedocument.presentationml.slide+xml"/>
  <Override PartName="/ppt/slides/slide42.xml" ContentType="application/vnd.openxmlformats-officedocument.presentationml.slide+xml"/>
  <Override PartName="/ppt/slides/slide3.xml" ContentType="application/vnd.openxmlformats-officedocument.presentationml.slide+xml"/>
  <Override PartName="/ppt/slides/slide10.xml" ContentType="application/vnd.openxmlformats-officedocument.presentationml.slide+xml"/>
  <Override PartName="/ppt/slides/slide47.xml" ContentType="application/vnd.openxmlformats-officedocument.presentationml.slide+xml"/>
  <Override PartName="/ppt/slides/slide15.xml" ContentType="application/vnd.openxmlformats-officedocument.presentationml.slide+xml"/>
  <Override PartName="/ppt/slides/slide8.xml" ContentType="application/vnd.openxmlformats-officedocument.presentationml.slide+xml"/>
  <Override PartName="/ppt/slides/slide43.xml" ContentType="application/vnd.openxmlformats-officedocument.presentationml.slide+xml"/>
  <Override PartName="/ppt/slides/slide4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16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5.xml" ContentType="application/vnd.openxmlformats-officedocument.presentationml.slide+xml"/>
  <Override PartName="/ppt/slides/slide12.xml" ContentType="application/vnd.openxmlformats-officedocument.presentationml.slide+xml"/>
  <Override PartName="/ppt/slides/slide49.xml" ContentType="application/vnd.openxmlformats-officedocument.presentationml.slide+xml"/>
  <Override PartName="/ppt/slides/_rels/slide34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49.xml.rels" ContentType="application/vnd.openxmlformats-package.relationships+xml"/>
  <Override PartName="/ppt/slides/_rels/slide33.xml.rels" ContentType="application/vnd.openxmlformats-package.relationships+xml"/>
  <Override PartName="/ppt/slides/_rels/slide29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48.xml.rels" ContentType="application/vnd.openxmlformats-package.relationships+xml"/>
  <Override PartName="/ppt/slides/_rels/slide64.xml.rels" ContentType="application/vnd.openxmlformats-package.relationships+xml"/>
  <Override PartName="/ppt/slides/_rels/slide61.xml.rels" ContentType="application/vnd.openxmlformats-package.relationships+xml"/>
  <Override PartName="/ppt/slides/_rels/slide57.xml.rels" ContentType="application/vnd.openxmlformats-package.relationships+xml"/>
  <Override PartName="/ppt/slides/_rels/slide67.xml.rels" ContentType="application/vnd.openxmlformats-package.relationships+xml"/>
  <Override PartName="/ppt/slides/_rels/slide71.xml.rels" ContentType="application/vnd.openxmlformats-package.relationships+xml"/>
  <Override PartName="/ppt/slides/_rels/slide28.xml.rels" ContentType="application/vnd.openxmlformats-package.relationships+xml"/>
  <Override PartName="/ppt/slides/_rels/slide44.xml.rels" ContentType="application/vnd.openxmlformats-package.relationships+xml"/>
  <Override PartName="/ppt/slides/_rels/slide9.xml.rels" ContentType="application/vnd.openxmlformats-package.relationships+xml"/>
  <Override PartName="/ppt/slides/_rels/slide37.xml.rels" ContentType="application/vnd.openxmlformats-package.relationships+xml"/>
  <Override PartName="/ppt/slides/_rels/slide3.xml.rels" ContentType="application/vnd.openxmlformats-package.relationships+xml"/>
  <Override PartName="/ppt/slides/_rels/slide27.xml.rels" ContentType="application/vnd.openxmlformats-package.relationships+xml"/>
  <Override PartName="/ppt/slides/_rels/slide43.xml.rels" ContentType="application/vnd.openxmlformats-package.relationships+xml"/>
  <Override PartName="/ppt/slides/_rels/slide8.xml.rels" ContentType="application/vnd.openxmlformats-package.relationships+xml"/>
  <Override PartName="/ppt/slides/_rels/slide2.xml.rels" ContentType="application/vnd.openxmlformats-package.relationships+xml"/>
  <Override PartName="/ppt/slides/_rels/slide36.xml.rels" ContentType="application/vnd.openxmlformats-package.relationships+xml"/>
  <Override PartName="/ppt/slides/_rels/slide65.xml.rels" ContentType="application/vnd.openxmlformats-package.relationships+xml"/>
  <Override PartName="/ppt/slides/_rels/slide58.xml.rels" ContentType="application/vnd.openxmlformats-package.relationships+xml"/>
  <Override PartName="/ppt/slides/_rels/slide13.xml.rels" ContentType="application/vnd.openxmlformats-package.relationships+xml"/>
  <Override PartName="/ppt/slides/_rels/slide42.xml.rels" ContentType="application/vnd.openxmlformats-package.relationships+xml"/>
  <Override PartName="/ppt/slides/_rels/slide7.xml.rels" ContentType="application/vnd.openxmlformats-package.relationships+xml"/>
  <Override PartName="/ppt/slides/_rels/slide35.xml.rels" ContentType="application/vnd.openxmlformats-package.relationships+xml"/>
  <Override PartName="/ppt/slides/_rels/slide51.xml.rels" ContentType="application/vnd.openxmlformats-package.relationships+xml"/>
  <Override PartName="/ppt/slides/_rels/slide55.xml.rels" ContentType="application/vnd.openxmlformats-package.relationships+xml"/>
  <Override PartName="/ppt/slides/_rels/slide54.xml.rels" ContentType="application/vnd.openxmlformats-package.relationships+xml"/>
  <Override PartName="/ppt/slides/_rels/slide63.xml.rels" ContentType="application/vnd.openxmlformats-package.relationships+xml"/>
  <Override PartName="/ppt/slides/_rels/slide70.xml.rels" ContentType="application/vnd.openxmlformats-package.relationships+xml"/>
  <Override PartName="/ppt/slides/_rels/slide47.xml.rels" ContentType="application/vnd.openxmlformats-package.relationships+xml"/>
  <Override PartName="/ppt/slides/_rels/slide4.xml.rels" ContentType="application/vnd.openxmlformats-package.relationships+xml"/>
  <Override PartName="/ppt/slides/_rels/slide53.xml.rels" ContentType="application/vnd.openxmlformats-package.relationships+xml"/>
  <Override PartName="/ppt/slides/_rels/slide46.xml.rels" ContentType="application/vnd.openxmlformats-package.relationships+xml"/>
  <Override PartName="/ppt/slides/_rels/slide62.xml.rels" ContentType="application/vnd.openxmlformats-package.relationships+xml"/>
  <Override PartName="/ppt/slides/_rels/slide50.xml.rels" ContentType="application/vnd.openxmlformats-package.relationships+xml"/>
  <Override PartName="/ppt/slides/_rels/slide52.xml.rels" ContentType="application/vnd.openxmlformats-package.relationships+xml"/>
  <Override PartName="/ppt/slides/_rels/slide14.xml.rels" ContentType="application/vnd.openxmlformats-package.relationships+xml"/>
  <Override PartName="/ppt/slides/_rels/slide45.xml.rels" ContentType="application/vnd.openxmlformats-package.relationships+xml"/>
  <Override PartName="/ppt/slides/_rels/slide19.xml.rels" ContentType="application/vnd.openxmlformats-package.relationships+xml"/>
  <Override PartName="/ppt/slides/_rels/slide23.xml.rels" ContentType="application/vnd.openxmlformats-package.relationships+xml"/>
  <Override PartName="/ppt/slides/_rels/slide38.xml.rels" ContentType="application/vnd.openxmlformats-package.relationships+xml"/>
  <Override PartName="/ppt/slides/_rels/slide30.xml.rels" ContentType="application/vnd.openxmlformats-package.relationships+xml"/>
  <Override PartName="/ppt/slides/_rels/slide39.xml.rels" ContentType="application/vnd.openxmlformats-package.relationships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5.xml.rels" ContentType="application/vnd.openxmlformats-package.relationships+xml"/>
  <Override PartName="/ppt/slides/_rels/slide20.xml.rels" ContentType="application/vnd.openxmlformats-package.relationships+xml"/>
  <Override PartName="/ppt/slides/_rels/slide16.xml.rels" ContentType="application/vnd.openxmlformats-package.relationships+xml"/>
  <Override PartName="/ppt/slides/_rels/slide1.xml.rels" ContentType="application/vnd.openxmlformats-package.relationships+xml"/>
  <Override PartName="/ppt/slides/_rels/slide32.xml.rels" ContentType="application/vnd.openxmlformats-package.relationships+xml"/>
  <Override PartName="/ppt/slides/_rels/slide26.xml.rels" ContentType="application/vnd.openxmlformats-package.relationships+xml"/>
  <Override PartName="/ppt/slides/_rels/slide21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10.xml.rels" ContentType="application/vnd.openxmlformats-package.relationships+xml"/>
  <Override PartName="/ppt/slides/_rels/slide59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_rels/slide66.xml.rels" ContentType="application/vnd.openxmlformats-package.relationships+xml"/>
  <Override PartName="/ppt/slides/_rels/slide22.xml.rels" ContentType="application/vnd.openxmlformats-package.relationships+xml"/>
  <Override PartName="/ppt/slides/_rels/slide18.xml.rels" ContentType="application/vnd.openxmlformats-package.relationships+xml"/>
  <Override PartName="/ppt/slides/_rels/slide12.xml.rels" ContentType="application/vnd.openxmlformats-package.relationships+xml"/>
  <Override PartName="/ppt/slides/_rels/slide69.xml.rels" ContentType="application/vnd.openxmlformats-package.relationships+xml"/>
  <Override PartName="/ppt/slides/_rels/slide73.xml.rels" ContentType="application/vnd.openxmlformats-package.relationships+xml"/>
  <Override PartName="/ppt/slides/_rels/slide68.xml.rels" ContentType="application/vnd.openxmlformats-package.relationships+xml"/>
  <Override PartName="/ppt/slides/_rels/slide72.xml.rels" ContentType="application/vnd.openxmlformats-package.relationships+xml"/>
  <Override PartName="/ppt/slides/slide6.xml" ContentType="application/vnd.openxmlformats-officedocument.presentationml.slide+xml"/>
  <Override PartName="/ppt/slides/slide13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  <p:sldId id="312" r:id="rId59"/>
    <p:sldId id="313" r:id="rId60"/>
    <p:sldId id="314" r:id="rId61"/>
    <p:sldId id="315" r:id="rId62"/>
    <p:sldId id="316" r:id="rId63"/>
    <p:sldId id="317" r:id="rId64"/>
    <p:sldId id="318" r:id="rId65"/>
    <p:sldId id="319" r:id="rId66"/>
    <p:sldId id="320" r:id="rId67"/>
    <p:sldId id="321" r:id="rId68"/>
    <p:sldId id="322" r:id="rId69"/>
    <p:sldId id="323" r:id="rId70"/>
    <p:sldId id="324" r:id="rId71"/>
    <p:sldId id="325" r:id="rId72"/>
    <p:sldId id="326" r:id="rId73"/>
    <p:sldId id="327" r:id="rId74"/>
    <p:sldId id="328" r:id="rId7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slide" Target="slides/slide53.xml"/><Relationship Id="rId56" Type="http://schemas.openxmlformats.org/officeDocument/2006/relationships/slide" Target="slides/slide54.xml"/><Relationship Id="rId57" Type="http://schemas.openxmlformats.org/officeDocument/2006/relationships/slide" Target="slides/slide55.xml"/><Relationship Id="rId58" Type="http://schemas.openxmlformats.org/officeDocument/2006/relationships/slide" Target="slides/slide56.xml"/><Relationship Id="rId59" Type="http://schemas.openxmlformats.org/officeDocument/2006/relationships/slide" Target="slides/slide57.xml"/><Relationship Id="rId60" Type="http://schemas.openxmlformats.org/officeDocument/2006/relationships/slide" Target="slides/slide58.xml"/><Relationship Id="rId61" Type="http://schemas.openxmlformats.org/officeDocument/2006/relationships/slide" Target="slides/slide59.xml"/><Relationship Id="rId62" Type="http://schemas.openxmlformats.org/officeDocument/2006/relationships/slide" Target="slides/slide60.xml"/><Relationship Id="rId63" Type="http://schemas.openxmlformats.org/officeDocument/2006/relationships/slide" Target="slides/slide61.xml"/><Relationship Id="rId64" Type="http://schemas.openxmlformats.org/officeDocument/2006/relationships/slide" Target="slides/slide62.xml"/><Relationship Id="rId65" Type="http://schemas.openxmlformats.org/officeDocument/2006/relationships/slide" Target="slides/slide63.xml"/><Relationship Id="rId66" Type="http://schemas.openxmlformats.org/officeDocument/2006/relationships/slide" Target="slides/slide64.xml"/><Relationship Id="rId67" Type="http://schemas.openxmlformats.org/officeDocument/2006/relationships/slide" Target="slides/slide65.xml"/><Relationship Id="rId68" Type="http://schemas.openxmlformats.org/officeDocument/2006/relationships/slide" Target="slides/slide66.xml"/><Relationship Id="rId69" Type="http://schemas.openxmlformats.org/officeDocument/2006/relationships/slide" Target="slides/slide67.xml"/><Relationship Id="rId70" Type="http://schemas.openxmlformats.org/officeDocument/2006/relationships/slide" Target="slides/slide68.xml"/><Relationship Id="rId71" Type="http://schemas.openxmlformats.org/officeDocument/2006/relationships/slide" Target="slides/slide69.xml"/><Relationship Id="rId72" Type="http://schemas.openxmlformats.org/officeDocument/2006/relationships/slide" Target="slides/slide70.xml"/><Relationship Id="rId73" Type="http://schemas.openxmlformats.org/officeDocument/2006/relationships/slide" Target="slides/slide71.xml"/><Relationship Id="rId74" Type="http://schemas.openxmlformats.org/officeDocument/2006/relationships/slide" Target="slides/slide72.xml"/><Relationship Id="rId75" Type="http://schemas.openxmlformats.org/officeDocument/2006/relationships/slide" Target="slides/slide73.xml"/><Relationship Id="rId7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3D4CA8-4A68-4AFE-A9F4-B910E49F3F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935DCF-AA59-4F9E-95BF-D4AD2DF80F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CCB17-9443-489A-8119-4D2F0A9272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FBA8B8-D611-43CC-B0C7-ECFF24C037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9B50F5-0B00-481E-8CB7-F1B0621BAAE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CBC33-770E-4414-B815-642BE30978F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8595F-DC5B-4753-A0F3-45E74DD82F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438F7-BA97-46F9-84DD-12DB2079B8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C7691-C0A2-466F-A974-194692237C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51B76-4F49-44BA-BDD6-98CB623AFC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4DE2D-2678-40E7-9667-1110B54B4D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BB38E9-903E-4FB0-9AB1-63E784F6B7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F44949-74D8-46FC-8041-F32CC61FA0D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11.jpe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jpeg"/><Relationship Id="rId2" Type="http://schemas.openxmlformats.org/officeDocument/2006/relationships/image" Target="../media/image17.jpeg"/><Relationship Id="rId3" Type="http://schemas.openxmlformats.org/officeDocument/2006/relationships/image" Target="../media/image18.jpeg"/><Relationship Id="rId4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image" Target="../media/image20.png"/><Relationship Id="rId3" Type="http://schemas.openxmlformats.org/officeDocument/2006/relationships/image" Target="../media/image21.png"/><Relationship Id="rId4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22.jpe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4.jpeg"/><Relationship Id="rId2" Type="http://schemas.openxmlformats.org/officeDocument/2006/relationships/image" Target="../media/image25.jpeg"/><Relationship Id="rId3" Type="http://schemas.openxmlformats.org/officeDocument/2006/relationships/image" Target="../media/image26.jpeg"/><Relationship Id="rId4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7.jpeg"/><Relationship Id="rId2" Type="http://schemas.openxmlformats.org/officeDocument/2006/relationships/image" Target="../media/image28.png"/><Relationship Id="rId3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9.jpeg"/><Relationship Id="rId2" Type="http://schemas.openxmlformats.org/officeDocument/2006/relationships/image" Target="../media/image30.png"/><Relationship Id="rId3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31.jpeg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32.jpeg"/><Relationship Id="rId2" Type="http://schemas.openxmlformats.org/officeDocument/2006/relationships/image" Target="../media/image33.jpeg"/><Relationship Id="rId3" Type="http://schemas.openxmlformats.org/officeDocument/2006/relationships/image" Target="../media/image34.png"/><Relationship Id="rId4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36.png"/><Relationship Id="rId2" Type="http://schemas.openxmlformats.org/officeDocument/2006/relationships/image" Target="../media/image37.png"/><Relationship Id="rId3" Type="http://schemas.openxmlformats.org/officeDocument/2006/relationships/image" Target="../media/image38.png"/><Relationship Id="rId4" Type="http://schemas.openxmlformats.org/officeDocument/2006/relationships/image" Target="../media/image39.png"/><Relationship Id="rId5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4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42.jpeg"/><Relationship Id="rId2" Type="http://schemas.openxmlformats.org/officeDocument/2006/relationships/image" Target="../media/image43.jpeg"/><Relationship Id="rId3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44.jpeg"/><Relationship Id="rId2" Type="http://schemas.openxmlformats.org/officeDocument/2006/relationships/image" Target="../media/image45.png"/><Relationship Id="rId3" Type="http://schemas.openxmlformats.org/officeDocument/2006/relationships/image" Target="../media/image43.jpeg"/><Relationship Id="rId4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46.jpeg"/><Relationship Id="rId2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47.jpeg"/><Relationship Id="rId2" Type="http://schemas.openxmlformats.org/officeDocument/2006/relationships/image" Target="../media/image48.png"/><Relationship Id="rId3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49.png"/><Relationship Id="rId2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image" Target="../media/image51.jpeg"/><Relationship Id="rId3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52.jpeg"/><Relationship Id="rId2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53.png"/><Relationship Id="rId2" Type="http://schemas.openxmlformats.org/officeDocument/2006/relationships/image" Target="../media/image54.png"/><Relationship Id="rId3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55.png"/><Relationship Id="rId2" Type="http://schemas.openxmlformats.org/officeDocument/2006/relationships/image" Target="../media/image56.png"/><Relationship Id="rId3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59.png"/><Relationship Id="rId2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image" Target="../media/image61.jpeg"/><Relationship Id="rId3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62.png"/><Relationship Id="rId2" Type="http://schemas.openxmlformats.org/officeDocument/2006/relationships/slideLayout" Target="../slideLayouts/slideLayout1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slideLayout" Target="../slideLayouts/slideLayout1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64.jpeg"/><Relationship Id="rId2" Type="http://schemas.openxmlformats.org/officeDocument/2006/relationships/slideLayout" Target="../slideLayouts/slideLayout1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65.jpeg"/><Relationship Id="rId2" Type="http://schemas.openxmlformats.org/officeDocument/2006/relationships/image" Target="../media/image66.jpeg"/><Relationship Id="rId3" Type="http://schemas.openxmlformats.org/officeDocument/2006/relationships/slideLayout" Target="../slideLayouts/slideLayout1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67.jpeg"/><Relationship Id="rId2" Type="http://schemas.openxmlformats.org/officeDocument/2006/relationships/image" Target="../media/image68.jpeg"/><Relationship Id="rId3" Type="http://schemas.openxmlformats.org/officeDocument/2006/relationships/slideLayout" Target="../slideLayouts/slideLayout1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69.png"/><Relationship Id="rId2" Type="http://schemas.openxmlformats.org/officeDocument/2006/relationships/image" Target="../media/image70.jpe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71.jpeg"/><Relationship Id="rId2" Type="http://schemas.openxmlformats.org/officeDocument/2006/relationships/slideLayout" Target="../slideLayouts/slideLayout1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72.jpeg"/><Relationship Id="rId2" Type="http://schemas.openxmlformats.org/officeDocument/2006/relationships/slideLayout" Target="../slideLayouts/slideLayout1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73.png"/><Relationship Id="rId2" Type="http://schemas.openxmlformats.org/officeDocument/2006/relationships/slideLayout" Target="../slideLayouts/slideLayout1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74.jpeg"/><Relationship Id="rId2" Type="http://schemas.openxmlformats.org/officeDocument/2006/relationships/image" Target="../media/image75.jpeg"/><Relationship Id="rId3" Type="http://schemas.openxmlformats.org/officeDocument/2006/relationships/slideLayout" Target="../slideLayouts/slideLayout1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76.jpeg"/><Relationship Id="rId2" Type="http://schemas.openxmlformats.org/officeDocument/2006/relationships/slideLayout" Target="../slideLayouts/slideLayout1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77.jpeg"/><Relationship Id="rId2" Type="http://schemas.openxmlformats.org/officeDocument/2006/relationships/image" Target="../media/image78.jpeg"/><Relationship Id="rId3" Type="http://schemas.openxmlformats.org/officeDocument/2006/relationships/slideLayout" Target="../slideLayouts/slideLayout1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image" Target="../media/image79.png"/><Relationship Id="rId2" Type="http://schemas.openxmlformats.org/officeDocument/2006/relationships/slideLayout" Target="../slideLayouts/slideLayout1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image" Target="../media/image80.jpeg"/><Relationship Id="rId2" Type="http://schemas.openxmlformats.org/officeDocument/2006/relationships/slideLayout" Target="../slideLayouts/slideLayout1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81.jpe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image" Target="../media/image82.png"/><Relationship Id="rId2" Type="http://schemas.openxmlformats.org/officeDocument/2006/relationships/image" Target="../media/image83.png"/><Relationship Id="rId3" Type="http://schemas.openxmlformats.org/officeDocument/2006/relationships/slideLayout" Target="../slideLayouts/slideLayout1.xml"/>
</Relationships>
</file>

<file path=ppt/slides/_rels/slide61.xml.rels><?xml version="1.0" encoding="UTF-8"?>
<Relationships xmlns="http://schemas.openxmlformats.org/package/2006/relationships"><Relationship Id="rId1" Type="http://schemas.openxmlformats.org/officeDocument/2006/relationships/image" Target="../media/image84.jpeg"/><Relationship Id="rId2" Type="http://schemas.openxmlformats.org/officeDocument/2006/relationships/image" Target="../media/image85.jpeg"/><Relationship Id="rId3" Type="http://schemas.openxmlformats.org/officeDocument/2006/relationships/image" Target="../media/image86.jpeg"/><Relationship Id="rId4" Type="http://schemas.openxmlformats.org/officeDocument/2006/relationships/slideLayout" Target="../slideLayouts/slideLayout1.xml"/>
</Relationships>
</file>

<file path=ppt/slides/_rels/slide62.xml.rels><?xml version="1.0" encoding="UTF-8"?>
<Relationships xmlns="http://schemas.openxmlformats.org/package/2006/relationships"><Relationship Id="rId1" Type="http://schemas.openxmlformats.org/officeDocument/2006/relationships/image" Target="../media/image87.png"/><Relationship Id="rId2" Type="http://schemas.openxmlformats.org/officeDocument/2006/relationships/image" Target="../media/image88.png"/><Relationship Id="rId3" Type="http://schemas.openxmlformats.org/officeDocument/2006/relationships/image" Target="../media/image89.jpeg"/><Relationship Id="rId4" Type="http://schemas.openxmlformats.org/officeDocument/2006/relationships/slideLayout" Target="../slideLayouts/slideLayout1.xml"/>
</Relationships>
</file>

<file path=ppt/slides/_rels/slide63.xml.rels><?xml version="1.0" encoding="UTF-8"?>
<Relationships xmlns="http://schemas.openxmlformats.org/package/2006/relationships"><Relationship Id="rId1" Type="http://schemas.openxmlformats.org/officeDocument/2006/relationships/image" Target="../media/image90.png"/><Relationship Id="rId2" Type="http://schemas.openxmlformats.org/officeDocument/2006/relationships/slideLayout" Target="../slideLayouts/slideLayout1.xml"/>
</Relationships>
</file>

<file path=ppt/slides/_rels/slide64.xml.rels><?xml version="1.0" encoding="UTF-8"?>
<Relationships xmlns="http://schemas.openxmlformats.org/package/2006/relationships"><Relationship Id="rId1" Type="http://schemas.openxmlformats.org/officeDocument/2006/relationships/image" Target="../media/image91.jpeg"/><Relationship Id="rId2" Type="http://schemas.openxmlformats.org/officeDocument/2006/relationships/image" Target="../media/image92.jpeg"/><Relationship Id="rId3" Type="http://schemas.openxmlformats.org/officeDocument/2006/relationships/slideLayout" Target="../slideLayouts/slideLayout1.xml"/>
</Relationships>
</file>

<file path=ppt/slides/_rels/slide65.xml.rels><?xml version="1.0" encoding="UTF-8"?>
<Relationships xmlns="http://schemas.openxmlformats.org/package/2006/relationships"><Relationship Id="rId1" Type="http://schemas.openxmlformats.org/officeDocument/2006/relationships/image" Target="../media/image93.png"/><Relationship Id="rId2" Type="http://schemas.openxmlformats.org/officeDocument/2006/relationships/slideLayout" Target="../slideLayouts/slideLayout1.xml"/>
</Relationships>
</file>

<file path=ppt/slides/_rels/slide6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7.xml.rels><?xml version="1.0" encoding="UTF-8"?>
<Relationships xmlns="http://schemas.openxmlformats.org/package/2006/relationships"><Relationship Id="rId1" Type="http://schemas.openxmlformats.org/officeDocument/2006/relationships/image" Target="../media/image94.jpeg"/><Relationship Id="rId2" Type="http://schemas.openxmlformats.org/officeDocument/2006/relationships/slideLayout" Target="../slideLayouts/slideLayout1.xml"/>
</Relationships>
</file>

<file path=ppt/slides/_rels/slide68.xml.rels><?xml version="1.0" encoding="UTF-8"?>
<Relationships xmlns="http://schemas.openxmlformats.org/package/2006/relationships"><Relationship Id="rId1" Type="http://schemas.openxmlformats.org/officeDocument/2006/relationships/image" Target="../media/image95.jpeg"/><Relationship Id="rId2" Type="http://schemas.openxmlformats.org/officeDocument/2006/relationships/slideLayout" Target="../slideLayouts/slideLayout1.xml"/>
</Relationships>
</file>

<file path=ppt/slides/_rels/slide69.xml.rels><?xml version="1.0" encoding="UTF-8"?>
<Relationships xmlns="http://schemas.openxmlformats.org/package/2006/relationships"><Relationship Id="rId1" Type="http://schemas.openxmlformats.org/officeDocument/2006/relationships/image" Target="../media/image96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70.xml.rels><?xml version="1.0" encoding="UTF-8"?>
<Relationships xmlns="http://schemas.openxmlformats.org/package/2006/relationships"><Relationship Id="rId1" Type="http://schemas.openxmlformats.org/officeDocument/2006/relationships/image" Target="../media/image96.jpeg"/><Relationship Id="rId2" Type="http://schemas.openxmlformats.org/officeDocument/2006/relationships/slideLayout" Target="../slideLayouts/slideLayout3.xml"/>
</Relationships>
</file>

<file path=ppt/slides/_rels/slide7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2.xml.rels><?xml version="1.0" encoding="UTF-8"?>
<Relationships xmlns="http://schemas.openxmlformats.org/package/2006/relationships"><Relationship Id="rId1" Type="http://schemas.openxmlformats.org/officeDocument/2006/relationships/image" Target="../media/image97.jpeg"/><Relationship Id="rId2" Type="http://schemas.openxmlformats.org/officeDocument/2006/relationships/slideLayout" Target="../slideLayouts/slideLayout1.xml"/>
</Relationships>
</file>

<file path=ppt/slides/_rels/slide73.xml.rels><?xml version="1.0" encoding="UTF-8"?>
<Relationships xmlns="http://schemas.openxmlformats.org/package/2006/relationships"><Relationship Id="rId1" Type="http://schemas.openxmlformats.org/officeDocument/2006/relationships/image" Target="../media/image98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971640" y="189000"/>
          <a:ext cx="7127640" cy="6264360"/>
        </p:xfrm>
        <a:graphic>
          <a:graphicData uri="http://schemas.openxmlformats.org/drawingml/2006/table">
            <a:tbl>
              <a:tblPr/>
              <a:tblGrid>
                <a:gridCol w="7127640"/>
              </a:tblGrid>
              <a:tr h="6264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HOLISTIC AND EPISTEMOLOGIC REVIEW OF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PERIPHERAL NERVE REPAIR AND REGENERATI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PROF G. BRUNELLI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ACOLTÀ DI MEDICINA , UNIVERSITÀ DI BRESCI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TERNATIONAL SYMPOSIUM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PERIPHERAL NERVE REPAIR AND REGENERATI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4-5 DEC, 2009, TORINO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RGANISERS: </a:t>
                      </a: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ATTISTON, GEUNA, PERROTEAU AND TOS</a:t>
                      </a: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38160">
                      <a:solidFill>
                        <a:srgbClr val="00cc99"/>
                      </a:solidFill>
                    </a:lnL>
                    <a:lnR w="38160">
                      <a:solidFill>
                        <a:srgbClr val="00cc99"/>
                      </a:solidFill>
                    </a:lnR>
                    <a:lnT w="38160">
                      <a:solidFill>
                        <a:srgbClr val="00cc99"/>
                      </a:solidFill>
                    </a:lnT>
                    <a:lnB w="38160">
                      <a:solidFill>
                        <a:srgbClr val="00cc99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179280" y="3716280"/>
            <a:ext cx="81378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1619280" y="549360"/>
            <a:ext cx="5545080" cy="23032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44" name=""/>
          <p:cNvSpPr/>
          <p:nvPr/>
        </p:nvSpPr>
        <p:spPr>
          <a:xfrm>
            <a:off x="3352320" y="6165720"/>
            <a:ext cx="2849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BA, UN SECOLO FA,PIAZZA UMBERTO 1°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7003080" y="632304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GGI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8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E GROWTH CONE OF AN AXON FINDS THE GUIDE-MOLECU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AT TELL IT THE ROAD TO BE FOLLOW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BY GROWING  AXON  IS  WRAPPED UP BY  SCHWANN CELLS WHICH PRODUC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N INSULATING   MYELINIC WINDIN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79" name="" descr=""/>
          <p:cNvPicPr/>
          <p:nvPr/>
        </p:nvPicPr>
        <p:blipFill>
          <a:blip r:embed="rId1"/>
          <a:stretch/>
        </p:blipFill>
        <p:spPr>
          <a:xfrm>
            <a:off x="2268360" y="1197000"/>
            <a:ext cx="4175280" cy="1944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80" name="" descr=""/>
          <p:cNvPicPr/>
          <p:nvPr/>
        </p:nvPicPr>
        <p:blipFill>
          <a:blip r:embed="rId2"/>
          <a:stretch/>
        </p:blipFill>
        <p:spPr>
          <a:xfrm>
            <a:off x="2340000" y="4221000"/>
            <a:ext cx="4103640" cy="2016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1" name=""/>
          <p:cNvGraphicFramePr/>
          <p:nvPr/>
        </p:nvGraphicFramePr>
        <p:xfrm>
          <a:off x="755640" y="404640"/>
          <a:ext cx="7867800" cy="5793120"/>
        </p:xfrm>
        <a:graphic>
          <a:graphicData uri="http://schemas.openxmlformats.org/drawingml/2006/table">
            <a:tbl>
              <a:tblPr/>
              <a:tblGrid>
                <a:gridCol w="7867800"/>
              </a:tblGrid>
              <a:tr h="5793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ESE GUIDE MOLECULES EXERT  A </a:t>
                      </a:r>
                      <a:r>
                        <a:rPr b="1" lang="en-US" sz="24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SELECTIVE CHEMOTAXIS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ON THE GROWING AXONS IN EMBRY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S WELL AS ON THE REGROWING AXONS AFTER AN INTERRUPTION IN ADULTS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I DEMONSTRATED SUCH A SELECTIVE CHEMOTAXI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MORE THAN 30 YEARS AGO BY PUTTING 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 SENSORY NERVE  AND A MOTOR ONE INTO A VE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sp>
        <p:nvSpPr>
          <p:cNvPr id="82" name=""/>
          <p:cNvSpPr/>
          <p:nvPr/>
        </p:nvSpPr>
        <p:spPr>
          <a:xfrm>
            <a:off x="3761640" y="4025880"/>
            <a:ext cx="1825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NELLA VEN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83" name="" descr=""/>
          <p:cNvPicPr/>
          <p:nvPr/>
        </p:nvPicPr>
        <p:blipFill>
          <a:blip r:embed="rId1"/>
          <a:stretch/>
        </p:blipFill>
        <p:spPr>
          <a:xfrm>
            <a:off x="2556000" y="3213000"/>
            <a:ext cx="4535280" cy="2592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4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FTER A MIXING OF THE AXONS INSIDE THE VEIN, 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WHEN GETTING OUT, MOTOR AXONS WENT TO THE MOTOR NERV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 </a:t>
                      </a: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WHEREAS THE SENSORY ONES WENT TO THE SENSORY NERV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ENTRY                                           EXIT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 </a:t>
                      </a:r>
                      <a:r>
                        <a:rPr b="0" lang="en-US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SENSORY                                                                                 SENSORY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  </a:t>
                      </a:r>
                      <a:r>
                        <a:rPr b="0" lang="en-US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MOTOR                                                                                   MOTOR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COLORAZIONE BRUNA                                                                                                                         COLORAZIONE BRUN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85" name="" descr=""/>
          <p:cNvPicPr/>
          <p:nvPr/>
        </p:nvPicPr>
        <p:blipFill>
          <a:blip r:embed="rId1"/>
          <a:stretch/>
        </p:blipFill>
        <p:spPr>
          <a:xfrm>
            <a:off x="2124000" y="2708280"/>
            <a:ext cx="4897440" cy="3600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86" name=""/>
          <p:cNvSpPr/>
          <p:nvPr/>
        </p:nvSpPr>
        <p:spPr>
          <a:xfrm>
            <a:off x="3708360" y="4025880"/>
            <a:ext cx="24717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INSIDE VEIN 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00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7" name=""/>
          <p:cNvGraphicFramePr/>
          <p:nvPr/>
        </p:nvGraphicFramePr>
        <p:xfrm>
          <a:off x="152280" y="152280"/>
          <a:ext cx="8839440" cy="65167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516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LUNDBORG EXPERIMENT (1980)  GENERIC TROPISM ( NERVE TO NERVE 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REGEBERATING AXONS GO FROM ONE NERVE STUMP TO THE OTHER  DIRECTLY , NOT IN  FAAN-LIKE WA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PECIAL MOLECULES EXPLAINING THE SELECTIVE TROPISM </a:t>
                      </a:r>
                      <a:r>
                        <a:rPr b="1" lang="en-US" sz="12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(BRUNELLI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88" name="" descr=""/>
          <p:cNvPicPr/>
          <p:nvPr/>
        </p:nvPicPr>
        <p:blipFill>
          <a:blip r:embed="rId1">
            <a:lum contrast="30000"/>
          </a:blip>
          <a:stretch/>
        </p:blipFill>
        <p:spPr>
          <a:xfrm>
            <a:off x="395280" y="3429000"/>
            <a:ext cx="4105440" cy="2448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89" name="" descr=""/>
          <p:cNvPicPr/>
          <p:nvPr/>
        </p:nvPicPr>
        <p:blipFill>
          <a:blip r:embed="rId2"/>
          <a:stretch/>
        </p:blipFill>
        <p:spPr>
          <a:xfrm>
            <a:off x="4788000" y="3429000"/>
            <a:ext cx="3960720" cy="2448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90" name="" descr=""/>
          <p:cNvPicPr/>
          <p:nvPr/>
        </p:nvPicPr>
        <p:blipFill>
          <a:blip r:embed="rId3"/>
          <a:stretch/>
        </p:blipFill>
        <p:spPr>
          <a:xfrm>
            <a:off x="2556000" y="404640"/>
            <a:ext cx="3816360" cy="2016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91" name=""/>
          <p:cNvSpPr/>
          <p:nvPr/>
        </p:nvSpPr>
        <p:spPr>
          <a:xfrm rot="873000">
            <a:off x="4067280" y="1125360"/>
            <a:ext cx="976320" cy="144720"/>
          </a:xfrm>
          <a:prstGeom prst="rightArrow">
            <a:avLst>
              <a:gd name="adj1" fmla="val 50000"/>
              <a:gd name="adj2" fmla="val 168657"/>
            </a:avLst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2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T IS ALSO IOMPORTANT THAT THERE BE  A SUBSTRATE  (LAMININE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N WHICH THE GROWT CONE MAY STITCH  AND PROGRES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93" name="" descr=""/>
          <p:cNvPicPr/>
          <p:nvPr/>
        </p:nvPicPr>
        <p:blipFill>
          <a:blip r:embed="rId1"/>
          <a:stretch/>
        </p:blipFill>
        <p:spPr>
          <a:xfrm>
            <a:off x="2411280" y="549360"/>
            <a:ext cx="4032360" cy="25192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94" name="" descr=""/>
          <p:cNvPicPr/>
          <p:nvPr/>
        </p:nvPicPr>
        <p:blipFill>
          <a:blip r:embed="rId2"/>
          <a:stretch/>
        </p:blipFill>
        <p:spPr>
          <a:xfrm>
            <a:off x="2771640" y="4005360"/>
            <a:ext cx="3313080" cy="2376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95" name=""/>
          <p:cNvSpPr/>
          <p:nvPr/>
        </p:nvSpPr>
        <p:spPr>
          <a:xfrm>
            <a:off x="4572000" y="2060640"/>
            <a:ext cx="1851120" cy="792000"/>
          </a:xfrm>
          <a:prstGeom prst="rect">
            <a:avLst/>
          </a:prstGeom>
          <a:solidFill>
            <a:srgbClr val="ffffff"/>
          </a:solidFill>
          <a:ln w="9360">
            <a:solidFill>
              <a:srgbClr val="cc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UNDERSEN E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ARRET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3635280" y="5877000"/>
            <a:ext cx="2449440" cy="504720"/>
          </a:xfrm>
          <a:prstGeom prst="rect">
            <a:avLst/>
          </a:prstGeom>
          <a:solidFill>
            <a:srgbClr val="ffffff"/>
          </a:solidFill>
          <a:ln w="9360">
            <a:solidFill>
              <a:srgbClr val="cc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ROBERTS E PATTON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6570360" y="1287360"/>
            <a:ext cx="1392480" cy="73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2400" spc="-1" strike="noStrike">
                <a:solidFill>
                  <a:srgbClr val="ffff00"/>
                </a:solidFill>
                <a:latin typeface="Arial"/>
              </a:rPr>
              <a:t>C.A.M.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600" spc="-1" strike="noStrike">
                <a:solidFill>
                  <a:srgbClr val="ffff00"/>
                </a:solidFill>
                <a:latin typeface="Arial"/>
              </a:rPr>
              <a:t>OR DIFFUS.</a:t>
            </a:r>
            <a:r>
              <a:rPr b="0" lang="it-IT" sz="1800" spc="-1" strike="noStrike">
                <a:solidFill>
                  <a:srgbClr val="ffff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8" name=""/>
          <p:cNvGraphicFramePr/>
          <p:nvPr/>
        </p:nvGraphicFramePr>
        <p:xfrm>
          <a:off x="179280" y="189000"/>
          <a:ext cx="8856720" cy="6327720"/>
        </p:xfrm>
        <a:graphic>
          <a:graphicData uri="http://schemas.openxmlformats.org/drawingml/2006/table">
            <a:tbl>
              <a:tblPr/>
              <a:tblGrid>
                <a:gridCol w="8856720"/>
              </a:tblGrid>
              <a:tr h="6327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CHEME OF THE ADVANCEMENT  OF A GROWTH CON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INSIDE </a:t>
                      </a:r>
                      <a:r>
                        <a:rPr b="0" lang="en-US" sz="2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 ENDONEURAL TUBE, </a:t>
                      </a:r>
                      <a:r>
                        <a:rPr b="0" lang="en-US" sz="1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ABOVE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SUBSTRATE</a:t>
                      </a:r>
                      <a:r>
                        <a:rPr b="0" lang="en-US" sz="2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A SCHWANN CELL AND OF ITS  TENASCINS AND  INTEGRI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99" name="" descr=""/>
          <p:cNvPicPr/>
          <p:nvPr/>
        </p:nvPicPr>
        <p:blipFill>
          <a:blip r:embed="rId1"/>
          <a:stretch/>
        </p:blipFill>
        <p:spPr>
          <a:xfrm>
            <a:off x="755640" y="404640"/>
            <a:ext cx="7704000" cy="47530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00" name=""/>
          <p:cNvSpPr/>
          <p:nvPr/>
        </p:nvSpPr>
        <p:spPr>
          <a:xfrm>
            <a:off x="395280" y="765000"/>
            <a:ext cx="1440000" cy="216000"/>
          </a:xfrm>
          <a:prstGeom prst="rightArrow">
            <a:avLst>
              <a:gd name="adj1" fmla="val 50000"/>
              <a:gd name="adj2" fmla="val 166667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1" name=""/>
          <p:cNvGraphicFramePr/>
          <p:nvPr/>
        </p:nvGraphicFramePr>
        <p:xfrm>
          <a:off x="152280" y="260280"/>
          <a:ext cx="8839440" cy="65023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5138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                                                                                       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NEURON : SCHEMATIC DRAW                                                   PHOTO AT M.E.S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                                                            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: SOMA,   B: DENDRITES,  C: AXON  D : SINAPSE                                     AND AT  M.E.T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5003640" y="2997360"/>
            <a:ext cx="3670560" cy="2304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03" name="" descr=""/>
          <p:cNvPicPr/>
          <p:nvPr/>
        </p:nvPicPr>
        <p:blipFill>
          <a:blip r:embed="rId2"/>
          <a:stretch/>
        </p:blipFill>
        <p:spPr>
          <a:xfrm>
            <a:off x="5003640" y="476280"/>
            <a:ext cx="3672000" cy="2232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04" name="" descr=""/>
          <p:cNvPicPr/>
          <p:nvPr/>
        </p:nvPicPr>
        <p:blipFill>
          <a:blip r:embed="rId3"/>
          <a:stretch/>
        </p:blipFill>
        <p:spPr>
          <a:xfrm>
            <a:off x="611280" y="549360"/>
            <a:ext cx="3470040" cy="4680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05" name=""/>
          <p:cNvSpPr/>
          <p:nvPr/>
        </p:nvSpPr>
        <p:spPr>
          <a:xfrm>
            <a:off x="2536920" y="16477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1979640" y="712800"/>
            <a:ext cx="50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ff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2413440" y="28526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ff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2826000" y="37368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ff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9" name=""/>
          <p:cNvGraphicFramePr/>
          <p:nvPr/>
        </p:nvGraphicFramePr>
        <p:xfrm>
          <a:off x="179280" y="333360"/>
          <a:ext cx="8839440" cy="636444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3644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AXON, ELONGATING ABOVE A SCHWANN CELL, IS ENVELOPPED BY I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N THE SCHWANN CELL  ROTATES AROUND THE AXON  SO PRODUCING VARIOUS  LAYERS  OF ITS CELL MEMBRANE  THAT FORM THE MYELINIC SHEATH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1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).  ON THE RIGTH THE MESO-AXON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2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)THE SCHWANN SHEATH IS MADE OF THE CYTOPLASM OF THE CEL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3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)THE ENDONEURAL TUBE IS MADE UP BY THE BASAL MEMBRANE OF THE CEL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10" name="" descr=""/>
          <p:cNvPicPr/>
          <p:nvPr/>
        </p:nvPicPr>
        <p:blipFill>
          <a:blip r:embed="rId1"/>
          <a:stretch/>
        </p:blipFill>
        <p:spPr>
          <a:xfrm>
            <a:off x="395280" y="476280"/>
            <a:ext cx="4105440" cy="1944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11" name="" descr=""/>
          <p:cNvPicPr/>
          <p:nvPr/>
        </p:nvPicPr>
        <p:blipFill>
          <a:blip r:embed="rId2"/>
          <a:stretch/>
        </p:blipFill>
        <p:spPr>
          <a:xfrm>
            <a:off x="4932360" y="476280"/>
            <a:ext cx="3887640" cy="1944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12" name="" descr=""/>
          <p:cNvPicPr/>
          <p:nvPr/>
        </p:nvPicPr>
        <p:blipFill>
          <a:blip r:embed="rId3"/>
          <a:stretch/>
        </p:blipFill>
        <p:spPr>
          <a:xfrm>
            <a:off x="2627280" y="4292640"/>
            <a:ext cx="3745080" cy="2305080"/>
          </a:xfrm>
          <a:prstGeom prst="rect">
            <a:avLst/>
          </a:prstGeom>
          <a:ln w="76320">
            <a:solidFill>
              <a:srgbClr val="ff00ff"/>
            </a:solidFill>
            <a:miter/>
          </a:ln>
        </p:spPr>
      </p:pic>
      <p:sp>
        <p:nvSpPr>
          <p:cNvPr id="113" name=""/>
          <p:cNvSpPr/>
          <p:nvPr/>
        </p:nvSpPr>
        <p:spPr>
          <a:xfrm>
            <a:off x="2826000" y="546408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00ff"/>
                </a:solidFill>
                <a:latin typeface="Arial"/>
              </a:rPr>
              <a:t>1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4913640" y="467208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00ff"/>
                </a:solidFill>
                <a:latin typeface="Arial"/>
              </a:rPr>
              <a:t>2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5777280" y="5680080"/>
            <a:ext cx="3499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00ff"/>
                </a:solidFill>
                <a:latin typeface="Arial"/>
              </a:rPr>
              <a:t>3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8172360" y="3213000"/>
            <a:ext cx="503280" cy="576360"/>
          </a:xfrm>
          <a:custGeom>
            <a:avLst/>
            <a:gdLst>
              <a:gd name="textAreaLeft" fmla="*/ 207360 w 503280"/>
              <a:gd name="textAreaRight" fmla="*/ 295920 w 503280"/>
              <a:gd name="textAreaTop" fmla="*/ 237600 h 576360"/>
              <a:gd name="textAreaBottom" fmla="*/ 338760 h 57636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8906" y="8906"/>
                </a:lnTo>
                <a:lnTo>
                  <a:pt x="10800" y="0"/>
                </a:lnTo>
                <a:lnTo>
                  <a:pt x="12694" y="8906"/>
                </a:lnTo>
                <a:lnTo>
                  <a:pt x="21600" y="10800"/>
                </a:lnTo>
                <a:lnTo>
                  <a:pt x="12694" y="12694"/>
                </a:lnTo>
                <a:lnTo>
                  <a:pt x="10800" y="21600"/>
                </a:lnTo>
                <a:lnTo>
                  <a:pt x="8906" y="12694"/>
                </a:lnTo>
                <a:lnTo>
                  <a:pt x="0" y="10800"/>
                </a:lnTo>
                <a:close/>
              </a:path>
            </a:pathLst>
          </a:cu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7380360" y="1557360"/>
            <a:ext cx="360360" cy="431640"/>
          </a:xfrm>
          <a:custGeom>
            <a:avLst/>
            <a:gdLst>
              <a:gd name="textAreaLeft" fmla="*/ 148320 w 360360"/>
              <a:gd name="textAreaRight" fmla="*/ 212040 w 360360"/>
              <a:gd name="textAreaTop" fmla="*/ 177840 h 431640"/>
              <a:gd name="textAreaBottom" fmla="*/ 253800 h 43164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8900" y="8900"/>
                </a:lnTo>
                <a:lnTo>
                  <a:pt x="10800" y="0"/>
                </a:lnTo>
                <a:lnTo>
                  <a:pt x="12700" y="8900"/>
                </a:lnTo>
                <a:lnTo>
                  <a:pt x="21600" y="10800"/>
                </a:lnTo>
                <a:lnTo>
                  <a:pt x="12700" y="12700"/>
                </a:lnTo>
                <a:lnTo>
                  <a:pt x="10800" y="21600"/>
                </a:lnTo>
                <a:lnTo>
                  <a:pt x="8900" y="12700"/>
                </a:lnTo>
                <a:lnTo>
                  <a:pt x="0" y="10800"/>
                </a:lnTo>
                <a:close/>
              </a:path>
            </a:pathLst>
          </a:custGeom>
          <a:solidFill>
            <a:srgbClr val="ff00ff"/>
          </a:solidFill>
          <a:ln w="7632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9160" bIns="291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8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19" name="" descr=""/>
          <p:cNvPicPr/>
          <p:nvPr/>
        </p:nvPicPr>
        <p:blipFill>
          <a:blip r:embed="rId1">
            <a:lum contrast="12000"/>
          </a:blip>
          <a:stretch/>
        </p:blipFill>
        <p:spPr>
          <a:xfrm>
            <a:off x="2195640" y="404640"/>
            <a:ext cx="4824360" cy="6048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0" name=""/>
          <p:cNvGraphicFramePr/>
          <p:nvPr/>
        </p:nvGraphicFramePr>
        <p:xfrm>
          <a:off x="250920" y="189000"/>
          <a:ext cx="8588160" cy="6288120"/>
        </p:xfrm>
        <a:graphic>
          <a:graphicData uri="http://schemas.openxmlformats.org/drawingml/2006/table">
            <a:tbl>
              <a:tblPr/>
              <a:tblGrid>
                <a:gridCol w="8588160"/>
              </a:tblGrid>
              <a:tr h="6288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EACH MYELINATED AXON IS WRAPPED AROUND BY ONE SCHWANN CELL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 IN THE TRACTS BETWEEN TWO RANVIER NODES )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EREAS SEVERAL UNMYELINATED AXONS ARE WRAPPED AROUND BY ONLY ONE SCHWANN CELL.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21" name="" descr=""/>
          <p:cNvPicPr/>
          <p:nvPr/>
        </p:nvPicPr>
        <p:blipFill>
          <a:blip r:embed="rId1"/>
          <a:stretch/>
        </p:blipFill>
        <p:spPr>
          <a:xfrm>
            <a:off x="2050920" y="476280"/>
            <a:ext cx="5256360" cy="4464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22" name=""/>
          <p:cNvSpPr/>
          <p:nvPr/>
        </p:nvSpPr>
        <p:spPr>
          <a:xfrm>
            <a:off x="2556000" y="3284640"/>
            <a:ext cx="2087280" cy="1439640"/>
          </a:xfrm>
          <a:prstGeom prst="rect">
            <a:avLst/>
          </a:prstGeom>
          <a:solidFill>
            <a:srgbClr val="ffffff"/>
          </a:solidFill>
          <a:ln w="9360">
            <a:solidFill>
              <a:srgbClr val="cc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UN ASSONE MIELINATO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=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UNA CELLUL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I SCHWANN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4932360" y="3284640"/>
            <a:ext cx="2066760" cy="1439640"/>
          </a:xfrm>
          <a:prstGeom prst="rect">
            <a:avLst/>
          </a:prstGeom>
          <a:solidFill>
            <a:srgbClr val="ffffff"/>
          </a:solidFill>
          <a:ln w="9360">
            <a:solidFill>
              <a:srgbClr val="cc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ARECCHI ASSON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MIELINIC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=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N UNA SOLA  CELL.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I SCHWANN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"/>
          <p:cNvGraphicFramePr/>
          <p:nvPr/>
        </p:nvGraphicFramePr>
        <p:xfrm>
          <a:off x="971640" y="836640"/>
          <a:ext cx="7127640" cy="4908600"/>
        </p:xfrm>
        <a:graphic>
          <a:graphicData uri="http://schemas.openxmlformats.org/drawingml/2006/table">
            <a:tbl>
              <a:tblPr/>
              <a:tblGrid>
                <a:gridCol w="7127640"/>
              </a:tblGrid>
              <a:tr h="49269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HOLISTIC AND EPISTEMOLOGIC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ffff"/>
                          </a:solidFill>
                          <a:latin typeface="Arial"/>
                        </a:rPr>
                        <a:t>IN THE LANGUAGE THAT MY MOTHER TEACHED ME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00ffff"/>
                          </a:solidFill>
                          <a:latin typeface="Arial"/>
                        </a:rPr>
                        <a:t>MEANS </a:t>
                      </a:r>
                      <a:r>
                        <a:rPr b="1" lang="en-US" sz="2400" spc="-1" strike="noStrike">
                          <a:solidFill>
                            <a:srgbClr val="00ffff"/>
                          </a:solidFill>
                          <a:latin typeface="Arial"/>
                        </a:rPr>
                        <a:t>GLOBAL AND SCIENTIFIC</a:t>
                      </a:r>
                      <a:r>
                        <a:rPr b="0" lang="en-US" sz="2000" spc="-1" strike="noStrike">
                          <a:solidFill>
                            <a:srgbClr val="00ffff"/>
                          </a:solidFill>
                          <a:latin typeface="Arial"/>
                        </a:rPr>
                        <a:t>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EXPERIMENTAL DATA AND CLINICAL OBSERVATIONS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THE LAST YEARS ARE SO MANY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AT  AT FIRST SIGHT  IT DID NOT SEEM NECESSARY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UCH A RESEARCH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38160">
                      <a:solidFill>
                        <a:srgbClr val="00cc99"/>
                      </a:solidFill>
                    </a:lnL>
                    <a:lnR w="38160">
                      <a:solidFill>
                        <a:srgbClr val="00cc99"/>
                      </a:solidFill>
                    </a:lnR>
                    <a:lnT w="38160">
                      <a:solidFill>
                        <a:srgbClr val="00cc99"/>
                      </a:solidFill>
                    </a:lnT>
                    <a:lnB w="38160">
                      <a:solidFill>
                        <a:srgbClr val="00cc99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7" name=""/>
          <p:cNvSpPr/>
          <p:nvPr/>
        </p:nvSpPr>
        <p:spPr>
          <a:xfrm>
            <a:off x="179280" y="3716280"/>
            <a:ext cx="81378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352320" y="6165720"/>
            <a:ext cx="2849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BA, UN SECOLO FA,PIAZZA UMBERTO 1°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7003080" y="632304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GGI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4" name=""/>
          <p:cNvGraphicFramePr/>
          <p:nvPr/>
        </p:nvGraphicFramePr>
        <p:xfrm>
          <a:off x="250920" y="189000"/>
          <a:ext cx="8588160" cy="6480000"/>
        </p:xfrm>
        <a:graphic>
          <a:graphicData uri="http://schemas.openxmlformats.org/drawingml/2006/table">
            <a:tbl>
              <a:tblPr/>
              <a:tblGrid>
                <a:gridCol w="8588160"/>
              </a:tblGrid>
              <a:tr h="6480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RANVIER NODES  AT  SCANNING ELECTRON MICROSCOPE: (QUICK-FREEZING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THE RANVIER NODE THE AXON IS BARE, WITHOUT INSULATION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MODEST ELECTRICAL  CHARGE REMAIAJNING AFTER THE  CROSSING OF THE INTERNODAL SEGMENT IS SUFFICIENT TO OPEN THE SODIUM CHANNEL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ITH A GREAT INFLUX OF JONS  AN REPOLARISATION  OF THE MEMBRANE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RESTORATION OF THE ACION POTENTI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25" name="" descr=""/>
          <p:cNvPicPr/>
          <p:nvPr/>
        </p:nvPicPr>
        <p:blipFill>
          <a:blip r:embed="rId1">
            <a:lum contrast="24000"/>
          </a:blip>
          <a:stretch/>
        </p:blipFill>
        <p:spPr>
          <a:xfrm>
            <a:off x="2268360" y="2781360"/>
            <a:ext cx="4824720" cy="1871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26" name="" descr=""/>
          <p:cNvPicPr/>
          <p:nvPr/>
        </p:nvPicPr>
        <p:blipFill>
          <a:blip r:embed="rId2"/>
          <a:stretch/>
        </p:blipFill>
        <p:spPr>
          <a:xfrm>
            <a:off x="755640" y="333360"/>
            <a:ext cx="3529080" cy="1944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27" name="" descr=""/>
          <p:cNvPicPr/>
          <p:nvPr/>
        </p:nvPicPr>
        <p:blipFill>
          <a:blip r:embed="rId3">
            <a:lum contrast="36000"/>
          </a:blip>
          <a:stretch/>
        </p:blipFill>
        <p:spPr>
          <a:xfrm>
            <a:off x="5076720" y="333360"/>
            <a:ext cx="3384720" cy="1944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8" name=""/>
          <p:cNvGraphicFramePr/>
          <p:nvPr/>
        </p:nvGraphicFramePr>
        <p:xfrm>
          <a:off x="250920" y="189000"/>
          <a:ext cx="8588160" cy="6288120"/>
        </p:xfrm>
        <a:graphic>
          <a:graphicData uri="http://schemas.openxmlformats.org/drawingml/2006/table">
            <a:tbl>
              <a:tblPr/>
              <a:tblGrid>
                <a:gridCol w="8588160"/>
              </a:tblGrid>
              <a:tr h="6288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PERIPHERAL NERVES ARE CONSTITUTED BY </a:t>
                      </a:r>
                      <a:r>
                        <a:rPr b="0" lang="en-US" sz="14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MOTOR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, </a:t>
                      </a:r>
                      <a:r>
                        <a:rPr b="0" lang="en-US" sz="1400" spc="-1" strike="noStrike">
                          <a:solidFill>
                            <a:srgbClr val="33ccff"/>
                          </a:solidFill>
                          <a:latin typeface="Arial"/>
                        </a:rPr>
                        <a:t>SENSORY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 AND </a:t>
                      </a:r>
                      <a:r>
                        <a:rPr b="0" lang="en-US" sz="1400" spc="-1" strike="noStrike">
                          <a:solidFill>
                            <a:srgbClr val="ffcc00"/>
                          </a:solidFill>
                          <a:latin typeface="Arial"/>
                        </a:rPr>
                        <a:t>AUTONOMIC</a:t>
                      </a: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 AX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GROUPED IN FASCICLES  WRAPPED UP BY PERINEURIUM  THAT MANTAINS IN THE PERIPHERY THE BRAIN BLOOD BARRIER  PRESENT IN THE BRA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ff"/>
                          </a:solidFill>
                          <a:latin typeface="Arial"/>
                        </a:rPr>
                        <a:t>AND ARE IMMERSED IN THE INTERNAL EPINEURIUM  AMONG THE CONNECTIVE SEPTA   COMING FROM THE EXTERNAL EPINEURIUM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29" name="" descr=""/>
          <p:cNvPicPr/>
          <p:nvPr/>
        </p:nvPicPr>
        <p:blipFill>
          <a:blip r:embed="rId1">
            <a:lum bright="6000"/>
          </a:blip>
          <a:stretch/>
        </p:blipFill>
        <p:spPr>
          <a:xfrm>
            <a:off x="4643280" y="620640"/>
            <a:ext cx="4048200" cy="4032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30" name="" descr=""/>
          <p:cNvPicPr/>
          <p:nvPr/>
        </p:nvPicPr>
        <p:blipFill>
          <a:blip r:embed="rId2"/>
          <a:stretch/>
        </p:blipFill>
        <p:spPr>
          <a:xfrm>
            <a:off x="395280" y="620640"/>
            <a:ext cx="4103640" cy="4032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31" name=""/>
          <p:cNvSpPr/>
          <p:nvPr/>
        </p:nvSpPr>
        <p:spPr>
          <a:xfrm>
            <a:off x="4643280" y="3645000"/>
            <a:ext cx="2376720" cy="936360"/>
          </a:xfrm>
          <a:prstGeom prst="rect">
            <a:avLst/>
          </a:prstGeom>
          <a:solidFill>
            <a:srgbClr val="ffffff"/>
          </a:solidFill>
          <a:ln w="9360">
            <a:solidFill>
              <a:srgbClr val="cc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5867280" y="5300640"/>
            <a:ext cx="976320" cy="216000"/>
          </a:xfrm>
          <a:prstGeom prst="rightArrow">
            <a:avLst>
              <a:gd name="adj1" fmla="val 50000"/>
              <a:gd name="adj2" fmla="val 113000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 rot="19948200">
            <a:off x="5796000" y="3357360"/>
            <a:ext cx="976320" cy="144360"/>
          </a:xfrm>
          <a:prstGeom prst="rightArrow">
            <a:avLst>
              <a:gd name="adj1" fmla="val 50000"/>
              <a:gd name="adj2" fmla="val 169077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4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E</a:t>
                      </a:r>
                      <a:r>
                        <a:rPr b="1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: EPINEURIUM</a:t>
                      </a:r>
                      <a:r>
                        <a:rPr b="1" lang="en-US" sz="12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EI</a:t>
                      </a:r>
                      <a:r>
                        <a:rPr b="1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: INTERNAL EPINEURIIU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33ccff"/>
                          </a:solidFill>
                          <a:latin typeface="Arial"/>
                        </a:rPr>
                        <a:t>P</a:t>
                      </a:r>
                      <a:r>
                        <a:rPr b="1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: PERINEURIUM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2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EN</a:t>
                      </a:r>
                      <a:r>
                        <a:rPr b="1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: ENDONEURIUM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35" name="" descr=""/>
          <p:cNvPicPr/>
          <p:nvPr/>
        </p:nvPicPr>
        <p:blipFill>
          <a:blip r:embed="rId1">
            <a:lum contrast="42000"/>
          </a:blip>
          <a:stretch/>
        </p:blipFill>
        <p:spPr>
          <a:xfrm>
            <a:off x="755640" y="1268280"/>
            <a:ext cx="3743280" cy="36734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36" name="" descr=""/>
          <p:cNvPicPr/>
          <p:nvPr/>
        </p:nvPicPr>
        <p:blipFill>
          <a:blip r:embed="rId2"/>
          <a:stretch/>
        </p:blipFill>
        <p:spPr>
          <a:xfrm>
            <a:off x="4859280" y="1268280"/>
            <a:ext cx="3743280" cy="3672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37" name=""/>
          <p:cNvSpPr/>
          <p:nvPr/>
        </p:nvSpPr>
        <p:spPr>
          <a:xfrm>
            <a:off x="1744560" y="4143240"/>
            <a:ext cx="5601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ff0066"/>
                </a:solidFill>
                <a:latin typeface="Arial"/>
              </a:rPr>
              <a:t>E.I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1979640" y="2852640"/>
            <a:ext cx="927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33ccff"/>
                </a:solidFill>
                <a:latin typeface="Arial"/>
              </a:rPr>
              <a:t>P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2484360" y="3206880"/>
            <a:ext cx="6904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ff0066"/>
                </a:solidFill>
                <a:latin typeface="Arial"/>
              </a:rPr>
              <a:t>En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826920" y="3879720"/>
            <a:ext cx="9367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3300"/>
                </a:solidFill>
                <a:latin typeface="Arial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1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808080"/>
                          </a:solidFill>
                          <a:latin typeface="Arial"/>
                        </a:rPr>
                        <a:t>STRUTTURA DI UN NEURONE 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THE CEDLL BODY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RE IS THE CYTOPLASM,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NUCLEUS WITH ITS NUCLEULUS,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VARIOUS CYTOPLASMIC  ORGANELS</a:t>
                      </a: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:</a:t>
                      </a:r>
                      <a:r>
                        <a:rPr b="0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 GOLG APPARATUS,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SMOOTH ENDOPLASMIC RETICLE,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ROUGH ENDOPLASMIC RETICLE,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VESCIC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EUROTUBUL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EUROFILAMEN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MYTOCONDRIA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DENDRITES ARE COVERED WITH </a:t>
                      </a: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SPIN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.E. THE POST SYNAPTIC ORGANELS 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ICH RECEIVE THE CONTACT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THE VARIOUS AXONAL ENDINGS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42" name="" descr=""/>
          <p:cNvPicPr/>
          <p:nvPr/>
        </p:nvPicPr>
        <p:blipFill>
          <a:blip r:embed="rId1">
            <a:grayscl/>
            <a:lum contrast="18000"/>
          </a:blip>
          <a:stretch/>
        </p:blipFill>
        <p:spPr>
          <a:xfrm>
            <a:off x="324000" y="476280"/>
            <a:ext cx="4464000" cy="59054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3" name=""/>
          <p:cNvGraphicFramePr/>
          <p:nvPr/>
        </p:nvGraphicFramePr>
        <p:xfrm>
          <a:off x="539640" y="620640"/>
          <a:ext cx="7993080" cy="5400720"/>
        </p:xfrm>
        <a:graphic>
          <a:graphicData uri="http://schemas.openxmlformats.org/drawingml/2006/table">
            <a:tbl>
              <a:tblPr/>
              <a:tblGrid>
                <a:gridCol w="7993080"/>
              </a:tblGrid>
              <a:tr h="5400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44" name="" descr=""/>
          <p:cNvPicPr/>
          <p:nvPr/>
        </p:nvPicPr>
        <p:blipFill>
          <a:blip r:embed="rId1">
            <a:lum contrast="18000"/>
          </a:blip>
          <a:stretch/>
        </p:blipFill>
        <p:spPr>
          <a:xfrm>
            <a:off x="971640" y="692280"/>
            <a:ext cx="3284280" cy="2520720"/>
          </a:xfrm>
          <a:prstGeom prst="rect">
            <a:avLst/>
          </a:prstGeom>
          <a:ln w="0">
            <a:noFill/>
          </a:ln>
        </p:spPr>
      </p:pic>
      <p:pic>
        <p:nvPicPr>
          <p:cNvPr id="145" name="" descr=""/>
          <p:cNvPicPr/>
          <p:nvPr/>
        </p:nvPicPr>
        <p:blipFill>
          <a:blip r:embed="rId2">
            <a:lum contrast="24000"/>
          </a:blip>
          <a:stretch/>
        </p:blipFill>
        <p:spPr>
          <a:xfrm>
            <a:off x="4859280" y="692280"/>
            <a:ext cx="3456000" cy="2520720"/>
          </a:xfrm>
          <a:prstGeom prst="rect">
            <a:avLst/>
          </a:prstGeom>
          <a:ln w="0">
            <a:noFill/>
          </a:ln>
        </p:spPr>
      </p:pic>
      <p:pic>
        <p:nvPicPr>
          <p:cNvPr id="146" name="" descr=""/>
          <p:cNvPicPr/>
          <p:nvPr/>
        </p:nvPicPr>
        <p:blipFill>
          <a:blip r:embed="rId3"/>
          <a:stretch/>
        </p:blipFill>
        <p:spPr>
          <a:xfrm>
            <a:off x="2050920" y="3429000"/>
            <a:ext cx="5113440" cy="2390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7" name=""/>
          <p:cNvGraphicFramePr/>
          <p:nvPr/>
        </p:nvGraphicFramePr>
        <p:xfrm>
          <a:off x="539640" y="620640"/>
          <a:ext cx="7993080" cy="5400720"/>
        </p:xfrm>
        <a:graphic>
          <a:graphicData uri="http://schemas.openxmlformats.org/drawingml/2006/table">
            <a:tbl>
              <a:tblPr/>
              <a:tblGrid>
                <a:gridCol w="7993080"/>
              </a:tblGrid>
              <a:tr h="5400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EN AN AXON CONTACTS A DENDRITIC SPIN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THE SYNAP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GENES (PROTEINS)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DESCEND ALONG THE DENDRITE UP TO THE CELL,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SE PROTEINS REACH THE NUCLEUS  AND GIVE TO THE D.N.A.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FORMATIONS FOR THE TRANSCRIPTION AND TH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RIBOSOMIC PRODUCTIION  OF MORE PROTEINS IN THE CELL BODY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ICH WILL THEN BE TAGGED BY SIGNALS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THEIR AMINOACIDIC SEQUENC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OR THEIR DESTINA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UNCTION OF THESE PROTEINS  DEPEND O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IR AMINOACIDIC PRIMARY SEQUENC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UT ALSO ON  THEIR CORRECT “FOLDING”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AT OCCURS UNDER THE GUIDE OF  </a:t>
                      </a: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“CHAPERONS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”, ( VARIOUS ENZYMES )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8" name=""/>
          <p:cNvGraphicFramePr/>
          <p:nvPr/>
        </p:nvGraphicFramePr>
        <p:xfrm>
          <a:off x="468360" y="404640"/>
          <a:ext cx="8351640" cy="6048720"/>
        </p:xfrm>
        <a:graphic>
          <a:graphicData uri="http://schemas.openxmlformats.org/drawingml/2006/table">
            <a:tbl>
              <a:tblPr/>
              <a:tblGrid>
                <a:gridCol w="8351640"/>
              </a:tblGrid>
              <a:tr h="6048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EUR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 </a:t>
                      </a: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S A  </a:t>
                      </a:r>
                      <a:r>
                        <a:rPr b="1" lang="en-US" sz="2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SECRETING CELL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AT PRODUCES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A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)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CYTOPLASMIC SUBSTANC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FOR MANTAINING OR REPAIRIN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ITS CYTOSKELETO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AN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B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) 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NEUROTRASMITTER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( DIFFERENT ACCORDING   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TO THE TYPE OF NEURONS)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     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THESE SUBSTANC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      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ARE SENT FROM THE BODY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      </a:t>
                      </a:r>
                      <a:r>
                        <a:rPr b="0" lang="en-US" sz="1400" spc="-1" strike="noStrike">
                          <a:solidFill>
                            <a:srgbClr val="ffff99"/>
                          </a:solidFill>
                          <a:latin typeface="Arial"/>
                        </a:rPr>
                        <a:t>TO THE PERIPHER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49" name="" descr=""/>
          <p:cNvPicPr/>
          <p:nvPr/>
        </p:nvPicPr>
        <p:blipFill>
          <a:blip r:embed="rId1"/>
          <a:stretch/>
        </p:blipFill>
        <p:spPr>
          <a:xfrm>
            <a:off x="4716360" y="620640"/>
            <a:ext cx="3743280" cy="5616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0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MOTOR AXONS    END   WITH AN ELEFANT-FOOT LIKE  ENDING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AT CONTACT THE  MUSCLES IN THE NEUROMUSOLAR JOIN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.E. MOTOR END PLATES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HERE SHOWN AT LIGHT MICROSCOPY,AT ELECTRON MICROSCOPY AND  BY A SCHE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51" name="" descr=""/>
          <p:cNvPicPr/>
          <p:nvPr/>
        </p:nvPicPr>
        <p:blipFill>
          <a:blip r:embed="rId1"/>
          <a:stretch/>
        </p:blipFill>
        <p:spPr>
          <a:xfrm>
            <a:off x="684360" y="333360"/>
            <a:ext cx="3816360" cy="2087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52" name="" descr=""/>
          <p:cNvPicPr/>
          <p:nvPr/>
        </p:nvPicPr>
        <p:blipFill>
          <a:blip r:embed="rId2"/>
          <a:stretch/>
        </p:blipFill>
        <p:spPr>
          <a:xfrm>
            <a:off x="4859280" y="333360"/>
            <a:ext cx="3745080" cy="2087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53" name="" descr=""/>
          <p:cNvPicPr/>
          <p:nvPr/>
        </p:nvPicPr>
        <p:blipFill>
          <a:blip r:embed="rId3"/>
          <a:stretch/>
        </p:blipFill>
        <p:spPr>
          <a:xfrm>
            <a:off x="684360" y="2637000"/>
            <a:ext cx="3816360" cy="2304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54" name="" descr=""/>
          <p:cNvPicPr/>
          <p:nvPr/>
        </p:nvPicPr>
        <p:blipFill>
          <a:blip r:embed="rId4"/>
          <a:stretch/>
        </p:blipFill>
        <p:spPr>
          <a:xfrm>
            <a:off x="4859280" y="2637000"/>
            <a:ext cx="3745080" cy="2304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5" name=""/>
          <p:cNvGraphicFramePr/>
          <p:nvPr/>
        </p:nvGraphicFramePr>
        <p:xfrm>
          <a:off x="0" y="189000"/>
          <a:ext cx="8839080" cy="6288120"/>
        </p:xfrm>
        <a:graphic>
          <a:graphicData uri="http://schemas.openxmlformats.org/drawingml/2006/table">
            <a:tbl>
              <a:tblPr/>
              <a:tblGrid>
                <a:gridCol w="8839080"/>
              </a:tblGrid>
              <a:tr h="6288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INAPTOGENESIS:    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 POSSIBLE MODEL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A NEUROMUSCOLAR JOIN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EN A MOTOR AXON GET IN TOUCH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ITH A MUSCLE,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GRIN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MAKE THE RECEPTOR OF ACh  CONVERG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UNDER   THE NERVE ENDING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Ch RECEPTORS  AND AGRIN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ORM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BASAL LAMINA OF THE SYNAP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BOVE WHICH THE VESICLES OF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NEUROTRANSMITTER    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GROUP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56" name="" descr=""/>
          <p:cNvPicPr/>
          <p:nvPr/>
        </p:nvPicPr>
        <p:blipFill>
          <a:blip r:embed="rId1"/>
          <a:stretch/>
        </p:blipFill>
        <p:spPr>
          <a:xfrm>
            <a:off x="755640" y="333360"/>
            <a:ext cx="2735280" cy="6120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57" name=""/>
          <p:cNvSpPr/>
          <p:nvPr/>
        </p:nvSpPr>
        <p:spPr>
          <a:xfrm>
            <a:off x="3348000" y="333360"/>
            <a:ext cx="792360" cy="6120000"/>
          </a:xfrm>
          <a:prstGeom prst="rect">
            <a:avLst/>
          </a:prstGeom>
          <a:solidFill>
            <a:srgbClr val="00006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8" name=""/>
          <p:cNvGraphicFramePr/>
          <p:nvPr/>
        </p:nvGraphicFramePr>
        <p:xfrm>
          <a:off x="179280" y="189000"/>
          <a:ext cx="8785440" cy="6480000"/>
        </p:xfrm>
        <a:graphic>
          <a:graphicData uri="http://schemas.openxmlformats.org/drawingml/2006/table">
            <a:tbl>
              <a:tblPr/>
              <a:tblGrid>
                <a:gridCol w="8785440"/>
              </a:tblGrid>
              <a:tr h="6480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ORMAL FUNCTION OF A NEURON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CYTOSOLIC SUBSTANCES   AN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EUROTRANSMITTERS  ARE SENT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O PERIPHERY BY MEANS OF 2 TYP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AXONAL FLOW: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NE FAST AND ONE SLOW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 SPEED  DEPENDS O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MOLECULAR WEIGH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THE SUBSTANCE TO BE TRANSPORT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  RETROGRADE  AXON FLOW ALSO EXIS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AKING TO THE NEURON CEL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UBSTANCES  HALF DEMOLISH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SYNAPSE  AND SUBSTANC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PRODUCED BY TARGET ORGA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LEVEL OF TH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ERVE ENDING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59" name="" descr=""/>
          <p:cNvPicPr/>
          <p:nvPr/>
        </p:nvPicPr>
        <p:blipFill>
          <a:blip r:embed="rId1"/>
          <a:stretch/>
        </p:blipFill>
        <p:spPr>
          <a:xfrm>
            <a:off x="468360" y="404640"/>
            <a:ext cx="3960720" cy="59770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60" name=""/>
          <p:cNvSpPr/>
          <p:nvPr/>
        </p:nvSpPr>
        <p:spPr>
          <a:xfrm>
            <a:off x="2987640" y="2781360"/>
            <a:ext cx="216000" cy="976320"/>
          </a:xfrm>
          <a:prstGeom prst="upArrow">
            <a:avLst>
              <a:gd name="adj1" fmla="val 50000"/>
              <a:gd name="adj2" fmla="val 113000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 flipH="1">
            <a:off x="1834560" y="2924280"/>
            <a:ext cx="215640" cy="976320"/>
          </a:xfrm>
          <a:prstGeom prst="downArrow">
            <a:avLst>
              <a:gd name="adj1" fmla="val 50000"/>
              <a:gd name="adj2" fmla="val 113189"/>
            </a:avLst>
          </a:prstGeom>
          <a:solidFill>
            <a:srgbClr val="ff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757440" y="3068640"/>
            <a:ext cx="11088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RAPIDO E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LENTO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"/>
          <p:cNvGraphicFramePr/>
          <p:nvPr/>
        </p:nvGraphicFramePr>
        <p:xfrm>
          <a:off x="250920" y="476280"/>
          <a:ext cx="8569080" cy="5776920"/>
        </p:xfrm>
        <a:graphic>
          <a:graphicData uri="http://schemas.openxmlformats.org/drawingml/2006/table">
            <a:tbl>
              <a:tblPr/>
              <a:tblGrid>
                <a:gridCol w="8569080"/>
              </a:tblGrid>
              <a:tr h="5859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S A MATTER OF FACT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RE ARE THOUSANDS OF STUDIES ON PERPHERAL NERVE REGENERATION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DONE ON </a:t>
                      </a:r>
                      <a:r>
                        <a:rPr b="0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DIFFERENT </a:t>
                      </a: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IMALS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N </a:t>
                      </a:r>
                      <a:r>
                        <a:rPr b="0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DIFFERENT </a:t>
                      </a: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ERVES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</a:t>
                      </a:r>
                      <a:r>
                        <a:rPr b="0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DIFFERENT </a:t>
                      </a: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GES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ITH </a:t>
                      </a:r>
                      <a:r>
                        <a:rPr b="0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DIFFERENT</a:t>
                      </a: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TYPES OF LESIONS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ITH  </a:t>
                      </a:r>
                      <a:r>
                        <a:rPr b="0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DIFFERENT</a:t>
                      </a: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TIME OF FOLLOW-UP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ITH </a:t>
                      </a:r>
                      <a:r>
                        <a:rPr b="0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DIFFERENT</a:t>
                      </a: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METHODS OF EVALUATION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REFORE I THINK IT IS WORTH TO DRAW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HOLISTIC AND EPISTEMOLOGIC  CONSIDERATIONS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USEFUL TO IMPROVE THE CLINICAL TREATMENT OF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NERVE LESIONS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38160">
                      <a:solidFill>
                        <a:srgbClr val="00cc99"/>
                      </a:solidFill>
                    </a:lnL>
                    <a:lnR w="38160">
                      <a:solidFill>
                        <a:srgbClr val="00cc99"/>
                      </a:solidFill>
                    </a:lnR>
                    <a:lnT w="38160">
                      <a:solidFill>
                        <a:srgbClr val="00cc99"/>
                      </a:solidFill>
                    </a:lnT>
                    <a:lnB w="38160">
                      <a:solidFill>
                        <a:srgbClr val="00cc99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1" name=""/>
          <p:cNvSpPr/>
          <p:nvPr/>
        </p:nvSpPr>
        <p:spPr>
          <a:xfrm>
            <a:off x="179280" y="3716280"/>
            <a:ext cx="81378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3352320" y="6165720"/>
            <a:ext cx="2849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BA, UN SECOLO FA,PIAZZA UMBERTO 1°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7003080" y="632304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GGI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3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SUBSTANCES TRANSPORTED BY MEANS OF ORTHOGRADE FLOW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RE TAKEN BY  </a:t>
                      </a:r>
                      <a:r>
                        <a:rPr b="1" lang="it-IT" sz="18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KINESIN MOLECULE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WHILE THOSE TRANSPORTED BY THE RETROGRADE FLOW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RE TAKEN  BY    </a:t>
                      </a:r>
                      <a:r>
                        <a:rPr b="1" lang="it-IT" sz="18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DINEIN MOLECULES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SE MOLECULES TAKE THE PROTEIN VESCICL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ND , HANGIN ON  MICROTUBULS. TRANSPORT   VESCICLES IN ONE OR ANOTHER DIREC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64" name="" descr=""/>
          <p:cNvPicPr/>
          <p:nvPr/>
        </p:nvPicPr>
        <p:blipFill>
          <a:blip r:embed="rId1"/>
          <a:stretch/>
        </p:blipFill>
        <p:spPr>
          <a:xfrm>
            <a:off x="2843280" y="333360"/>
            <a:ext cx="3960720" cy="2448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65" name="" descr=""/>
          <p:cNvPicPr/>
          <p:nvPr/>
        </p:nvPicPr>
        <p:blipFill>
          <a:blip r:embed="rId2"/>
          <a:stretch/>
        </p:blipFill>
        <p:spPr>
          <a:xfrm>
            <a:off x="2987640" y="4869000"/>
            <a:ext cx="3456000" cy="16160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66" name=""/>
          <p:cNvSpPr/>
          <p:nvPr/>
        </p:nvSpPr>
        <p:spPr>
          <a:xfrm>
            <a:off x="4932360" y="4941720"/>
            <a:ext cx="863640" cy="142920"/>
          </a:xfrm>
          <a:prstGeom prst="rect">
            <a:avLst/>
          </a:prstGeom>
          <a:solidFill>
            <a:srgbClr val="ffffff"/>
          </a:solidFill>
          <a:ln w="9360">
            <a:solidFill>
              <a:srgbClr val="cc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5076720" y="5516640"/>
            <a:ext cx="914400" cy="144360"/>
          </a:xfrm>
          <a:prstGeom prst="rect">
            <a:avLst/>
          </a:prstGeom>
          <a:solidFill>
            <a:srgbClr val="ffffff"/>
          </a:solidFill>
          <a:ln w="9360">
            <a:solidFill>
              <a:srgbClr val="cc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4932360" y="6237360"/>
            <a:ext cx="863640" cy="144360"/>
          </a:xfrm>
          <a:prstGeom prst="rect">
            <a:avLst/>
          </a:prstGeom>
          <a:solidFill>
            <a:srgbClr val="ffffff"/>
          </a:solidFill>
          <a:ln w="9360">
            <a:solidFill>
              <a:srgbClr val="cc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5221800" y="5013360"/>
            <a:ext cx="1189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A KANDEL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0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71" name="" descr=""/>
          <p:cNvPicPr/>
          <p:nvPr/>
        </p:nvPicPr>
        <p:blipFill>
          <a:blip r:embed="rId1"/>
          <a:stretch/>
        </p:blipFill>
        <p:spPr>
          <a:xfrm>
            <a:off x="971640" y="260280"/>
            <a:ext cx="7129440" cy="31672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72" name="" descr=""/>
          <p:cNvPicPr/>
          <p:nvPr/>
        </p:nvPicPr>
        <p:blipFill>
          <a:blip r:embed="rId2"/>
          <a:stretch/>
        </p:blipFill>
        <p:spPr>
          <a:xfrm>
            <a:off x="2124000" y="3573360"/>
            <a:ext cx="4608720" cy="2880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73" name=""/>
          <p:cNvSpPr/>
          <p:nvPr/>
        </p:nvSpPr>
        <p:spPr>
          <a:xfrm rot="19523400">
            <a:off x="4066920" y="4941360"/>
            <a:ext cx="1049400" cy="238320"/>
          </a:xfrm>
          <a:prstGeom prst="leftArrow">
            <a:avLst>
              <a:gd name="adj1" fmla="val 50000"/>
              <a:gd name="adj2" fmla="val 110083"/>
            </a:avLst>
          </a:prstGeom>
          <a:solidFill>
            <a:srgbClr val="ff3300"/>
          </a:solidFill>
          <a:ln w="7632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74" name="" descr=""/>
          <p:cNvPicPr/>
          <p:nvPr/>
        </p:nvPicPr>
        <p:blipFill>
          <a:blip r:embed="rId3"/>
          <a:stretch/>
        </p:blipFill>
        <p:spPr>
          <a:xfrm>
            <a:off x="7020000" y="4581360"/>
            <a:ext cx="1727280" cy="1008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75" name=""/>
          <p:cNvSpPr/>
          <p:nvPr/>
        </p:nvSpPr>
        <p:spPr>
          <a:xfrm>
            <a:off x="5364000" y="1484280"/>
            <a:ext cx="976320" cy="289080"/>
          </a:xfrm>
          <a:prstGeom prst="rightArrow">
            <a:avLst>
              <a:gd name="adj1" fmla="val 50000"/>
              <a:gd name="adj2" fmla="val 84433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2411280" y="1989000"/>
            <a:ext cx="976320" cy="287640"/>
          </a:xfrm>
          <a:prstGeom prst="leftArrow">
            <a:avLst>
              <a:gd name="adj1" fmla="val 50000"/>
              <a:gd name="adj2" fmla="val 84856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7" name=""/>
          <p:cNvGraphicFramePr/>
          <p:nvPr/>
        </p:nvGraphicFramePr>
        <p:xfrm>
          <a:off x="324000" y="404640"/>
          <a:ext cx="8569080" cy="6475680"/>
        </p:xfrm>
        <a:graphic>
          <a:graphicData uri="http://schemas.openxmlformats.org/drawingml/2006/table">
            <a:tbl>
              <a:tblPr/>
              <a:tblGrid>
                <a:gridCol w="8569080"/>
              </a:tblGrid>
              <a:tr h="6138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ACTION POTENTIAL FORMS AT </a:t>
                      </a:r>
                      <a:r>
                        <a:rPr b="1" lang="en-US" sz="2000" spc="-1" strike="noStrike">
                          <a:solidFill>
                            <a:srgbClr val="ff0066"/>
                          </a:solidFill>
                          <a:latin typeface="Arial"/>
                        </a:rPr>
                        <a:t>HILLOC,</a:t>
                      </a:r>
                      <a:r>
                        <a:rPr b="1" lang="en-US" sz="2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ERE THE AXON EMERGES FROM THE NEURON BODY, WHEN THE CHEMICAL STIMULATION REACHES THE ACTION POTENTIAL GENERATING THRESHOLD.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         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A RESTING NEURON THE INFLUX OF JONS    </a:t>
                      </a:r>
                      <a:r>
                        <a:rPr b="1" lang="en-US" sz="18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N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S BALANCED BY THE EFFLUX OF  </a:t>
                      </a:r>
                      <a:r>
                        <a:rPr b="1" lang="en-US" sz="20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K</a:t>
                      </a:r>
                      <a:r>
                        <a:rPr b="1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 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J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CHEMICAL STIMULUS  INTRODUCES THE OPENING OF  THE  </a:t>
                      </a:r>
                      <a:r>
                        <a:rPr b="1" lang="en-US" sz="20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NA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CHANNELS  WITH ENORMOUS INFLUX  OF </a:t>
                      </a:r>
                      <a:r>
                        <a:rPr b="0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NA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JONS AND 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DEPOLARISATION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OF THE CELL MEMBRAN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O ORIGINATING THE ELECTRICAL ACTION POTENTI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AT DIFFUSES ALONG THE AXON UP TO ITS TERMINAL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  <a:tr h="337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78" name="" descr=""/>
          <p:cNvPicPr/>
          <p:nvPr/>
        </p:nvPicPr>
        <p:blipFill>
          <a:blip r:embed="rId1"/>
          <a:stretch/>
        </p:blipFill>
        <p:spPr>
          <a:xfrm>
            <a:off x="2843280" y="3933720"/>
            <a:ext cx="3449520" cy="2411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9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S THE ACTION POTENTIAL GETS THE SYNAPSE, IL PROVOK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OPENING OF THE </a:t>
                      </a:r>
                      <a:r>
                        <a:rPr b="0" lang="en-US" sz="16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CALCIUM CHANNELS OF THE PRESYNAPTIC BUTTON</a:t>
                      </a:r>
                      <a:r>
                        <a:rPr b="0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CALCIUM ENTERS THE NERVE ENDING AND  PRODUCES THE FUSION OF THE VESCICLES MEMBRANES  WITH THE AXOLEMMA AND THE  LEAKAGE OF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00ff00"/>
                          </a:solidFill>
                          <a:latin typeface="Arial"/>
                        </a:rPr>
                        <a:t>ACh</a:t>
                      </a:r>
                      <a:r>
                        <a:rPr b="0" lang="en-US" sz="2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INTO THE SYNAPTIC CLEFT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Ch HOLDS  ON POSTSYNAPTIC RECEPTORS OPENING THE  </a:t>
                      </a:r>
                      <a:r>
                        <a:rPr b="0" lang="en-US" sz="2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NA</a:t>
                      </a:r>
                      <a:r>
                        <a:rPr b="0" lang="en-US" sz="2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CHANNEL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 CHIMICAL AND  ELETTRICAL)  WITH GREAT INFLUX OF NA  INTO THE MUSCLE,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REPOLARISATION OF THE MEBRANE 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REFORMATION OF THE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CTION POTENTIAL  AND OF THE ELETTRICAL TRANSMISS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180" name="" descr=""/>
          <p:cNvPicPr/>
          <p:nvPr/>
        </p:nvPicPr>
        <p:blipFill>
          <a:blip r:embed="rId1"/>
          <a:stretch/>
        </p:blipFill>
        <p:spPr>
          <a:xfrm>
            <a:off x="539640" y="404640"/>
            <a:ext cx="3745080" cy="3168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81" name="" descr=""/>
          <p:cNvPicPr/>
          <p:nvPr/>
        </p:nvPicPr>
        <p:blipFill>
          <a:blip r:embed="rId2"/>
          <a:stretch/>
        </p:blipFill>
        <p:spPr>
          <a:xfrm>
            <a:off x="4716360" y="404640"/>
            <a:ext cx="3745080" cy="3168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2" name=""/>
          <p:cNvGraphicFramePr/>
          <p:nvPr/>
        </p:nvGraphicFramePr>
        <p:xfrm>
          <a:off x="395280" y="380880"/>
          <a:ext cx="8172360" cy="6288120"/>
        </p:xfrm>
        <a:graphic>
          <a:graphicData uri="http://schemas.openxmlformats.org/drawingml/2006/table">
            <a:tbl>
              <a:tblPr/>
              <a:tblGrid>
                <a:gridCol w="8172360"/>
              </a:tblGrid>
              <a:tr h="6288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S REGARDS THE REPAIR OF A NERVE LES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E MUST HAVE IN MIND THAT IN PERIPHERAL NERV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RE IS A DISPOSITION OF AXONS AND OF FASCICL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AT IS VERY DIFFERENT AT THE LIMB ROOT AND  DISTALLY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THE PRECOLLATERAL TRACT MOTOR AND SENSORY AXONS ARE MIX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EREAS IN THE COLLATERAL TRACT THE AXON THAT WILL LEAVE THE NERVE TRUNK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ITH COLLATERAL BRANCHES ARE 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FINALIZED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S WELL AS TEY ARE IN THE  PRETERMINAL AND TERMINAL TRACTS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83" name="" descr=""/>
          <p:cNvPicPr/>
          <p:nvPr/>
        </p:nvPicPr>
        <p:blipFill>
          <a:blip r:embed="rId1"/>
          <a:stretch/>
        </p:blipFill>
        <p:spPr>
          <a:xfrm>
            <a:off x="3059280" y="2852640"/>
            <a:ext cx="3168360" cy="3672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4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CLASSICAL DRAWINGS FROM SUNDERLAN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HOWING THE FASCICULAR EXANGES  AT THE INTERIOR OF A NERVE TRUNK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THE DIFFERENCES OF THE FASCICULAR MAPSI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TRANSVERSE SECTIONS OF THE RADIAL NERVE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0066"/>
                          </a:solidFill>
                          <a:latin typeface="Arial"/>
                        </a:rPr>
                        <a:t>A PART  0,8 mm  FROM ONE ANOTHER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85" name="" descr=""/>
          <p:cNvPicPr/>
          <p:nvPr/>
        </p:nvPicPr>
        <p:blipFill>
          <a:blip r:embed="rId1"/>
          <a:stretch/>
        </p:blipFill>
        <p:spPr>
          <a:xfrm>
            <a:off x="1116000" y="496800"/>
            <a:ext cx="2305080" cy="37242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86" name="" descr=""/>
          <p:cNvPicPr/>
          <p:nvPr/>
        </p:nvPicPr>
        <p:blipFill>
          <a:blip r:embed="rId2">
            <a:lum bright="6000"/>
          </a:blip>
          <a:stretch/>
        </p:blipFill>
        <p:spPr>
          <a:xfrm>
            <a:off x="4356000" y="549360"/>
            <a:ext cx="3454560" cy="3671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7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CONDUCTION VELOCITY OF A NERVE FIBRE  IS DIFFERENT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OR MYELINATED FIBRES ( V= 6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·Ø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AN UNMYELINATED ONE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 ( V = ROOT OF Ø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00ff"/>
                          </a:solidFill>
                          <a:latin typeface="Arial"/>
                          <a:ea typeface="Arial"/>
                        </a:rPr>
                        <a:t>IN MYELINATED AXONS  CONDUCTION IS NOT SEQUENTIAL BUT SALTATORY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FROM ONE RANVIER NODE TO THE  SUBSEQUENT ON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THAT’S WHY THE SPEED IS SO FAS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684360" y="62028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\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89" name="" descr=""/>
          <p:cNvPicPr/>
          <p:nvPr/>
        </p:nvPicPr>
        <p:blipFill>
          <a:blip r:embed="rId1"/>
          <a:stretch/>
        </p:blipFill>
        <p:spPr>
          <a:xfrm>
            <a:off x="2411280" y="765000"/>
            <a:ext cx="4608720" cy="3095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0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ELEMENTARY NERVE LESIONS ARE DISTINGUISHED IN :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NEUROAPRAXIA,  AXONOTHMESIS AND  NEUROTHMESI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 WE MUST ADD THE  </a:t>
                      </a:r>
                      <a:r>
                        <a:rPr b="0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RADICULAR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AVULSION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AND THE AVULSIONS OF A NERVE  FROM THE MUSCULAR BELLY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684360" y="62028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\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92" name="" descr=""/>
          <p:cNvPicPr/>
          <p:nvPr/>
        </p:nvPicPr>
        <p:blipFill>
          <a:blip r:embed="rId1"/>
          <a:stretch/>
        </p:blipFill>
        <p:spPr>
          <a:xfrm>
            <a:off x="5292720" y="1916280"/>
            <a:ext cx="3166920" cy="46432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193" name="" descr=""/>
          <p:cNvPicPr/>
          <p:nvPr/>
        </p:nvPicPr>
        <p:blipFill>
          <a:blip r:embed="rId2"/>
          <a:stretch/>
        </p:blipFill>
        <p:spPr>
          <a:xfrm>
            <a:off x="755640" y="1844640"/>
            <a:ext cx="3745080" cy="46753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194" name=""/>
          <p:cNvSpPr/>
          <p:nvPr/>
        </p:nvSpPr>
        <p:spPr>
          <a:xfrm rot="19423200">
            <a:off x="4284720" y="3141720"/>
            <a:ext cx="234720" cy="976320"/>
          </a:xfrm>
          <a:prstGeom prst="upArrow">
            <a:avLst>
              <a:gd name="adj1" fmla="val 50000"/>
              <a:gd name="adj2" fmla="val 103988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5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EN AN AXON IS INTERRUPTED ITS MOTHER CELL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S ALARMED  BY VARIOUS MECHANISMS :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A)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THE LACK OF RETURN OF NEUROTRANSMITTERS PARTIALLY DEMOLISHED AT PERIPHERY,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B)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THE RETURN OF UNDEMOLISHED NEUROTRANSMITTERS,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C)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THE ARRIVAL OF CATABOLIC ENZIMES FROM THE SITE OF THE LES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  </a:t>
                      </a:r>
                      <a:r>
                        <a:rPr b="0" lang="en-US" sz="1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D)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LACK OF MOLECULES COMING FROM THE TARGET ORGA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196" name="" descr=""/>
          <p:cNvPicPr/>
          <p:nvPr/>
        </p:nvPicPr>
        <p:blipFill>
          <a:blip r:embed="rId1"/>
          <a:stretch/>
        </p:blipFill>
        <p:spPr>
          <a:xfrm>
            <a:off x="4932360" y="333360"/>
            <a:ext cx="3384720" cy="4032360"/>
          </a:xfrm>
          <a:prstGeom prst="rect">
            <a:avLst/>
          </a:prstGeom>
          <a:ln w="0">
            <a:noFill/>
          </a:ln>
        </p:spPr>
      </p:pic>
      <p:pic>
        <p:nvPicPr>
          <p:cNvPr id="197" name="" descr=""/>
          <p:cNvPicPr/>
          <p:nvPr/>
        </p:nvPicPr>
        <p:blipFill>
          <a:blip r:embed="rId2"/>
          <a:stretch/>
        </p:blipFill>
        <p:spPr>
          <a:xfrm>
            <a:off x="826920" y="333360"/>
            <a:ext cx="3527640" cy="4032360"/>
          </a:xfrm>
          <a:prstGeom prst="rect">
            <a:avLst/>
          </a:prstGeom>
          <a:ln w="0">
            <a:noFill/>
          </a:ln>
        </p:spPr>
      </p:pic>
      <p:sp>
        <p:nvSpPr>
          <p:cNvPr id="198" name=""/>
          <p:cNvSpPr/>
          <p:nvPr/>
        </p:nvSpPr>
        <p:spPr>
          <a:xfrm rot="2491200">
            <a:off x="4642920" y="3573000"/>
            <a:ext cx="2089440" cy="142920"/>
          </a:xfrm>
          <a:prstGeom prst="rect">
            <a:avLst/>
          </a:prstGeom>
          <a:solidFill>
            <a:srgbClr val="ff0000"/>
          </a:solidFill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9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CELL START A  FEVERISH  REPARATIVE  CONDITION,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SSUMES  LIQUIDS,  SWELLS, THE SATELLITE CELLS INCREASE IN NUMBER     DERIVING NUTRIENTS FROM CAPILLARIES, ALL THE SOMATIC  AND DENDRITIC SYNAPSES ( USELESS DURING DENERVATION) DETACH,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UCLEUS IS PUSHED TO PERIPHERY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ALL THE PLASMATIC ORGANELS HIPERTROPHY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00" name="" descr=""/>
          <p:cNvPicPr/>
          <p:nvPr/>
        </p:nvPicPr>
        <p:blipFill>
          <a:blip r:embed="rId1"/>
          <a:stretch/>
        </p:blipFill>
        <p:spPr>
          <a:xfrm>
            <a:off x="900000" y="333360"/>
            <a:ext cx="7201080" cy="4103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"/>
          <p:cNvGraphicFramePr/>
          <p:nvPr/>
        </p:nvGraphicFramePr>
        <p:xfrm>
          <a:off x="900000" y="1413000"/>
          <a:ext cx="7128000" cy="4620960"/>
        </p:xfrm>
        <a:graphic>
          <a:graphicData uri="http://schemas.openxmlformats.org/drawingml/2006/table">
            <a:tbl>
              <a:tblPr/>
              <a:tblGrid>
                <a:gridCol w="7128000"/>
              </a:tblGrid>
              <a:tr h="46915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REGENERATING PROCESSES OF NERVES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MITATE  THE FIRST - FORMATION PROCESSES OF NERVES  IN EMBRYOS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S WELL AS THOSE OF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IMALS OF A LOWER EVOLUTIONARY SCALE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REFORE I WILL HINT TO THE EMBRYONIC EVOLUTION OF NERVES AND TO THE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POSTRAUMATIC  REGENERATION  ALTERATIONS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 NEURON BODY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 AXONS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38160">
                      <a:solidFill>
                        <a:srgbClr val="00cc99"/>
                      </a:solidFill>
                    </a:lnL>
                    <a:lnR w="38160">
                      <a:solidFill>
                        <a:srgbClr val="00cc99"/>
                      </a:solidFill>
                    </a:lnR>
                    <a:lnT w="38160">
                      <a:solidFill>
                        <a:srgbClr val="00cc99"/>
                      </a:solidFill>
                    </a:lnT>
                    <a:lnB w="38160">
                      <a:solidFill>
                        <a:srgbClr val="00cc99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5" name=""/>
          <p:cNvSpPr/>
          <p:nvPr/>
        </p:nvSpPr>
        <p:spPr>
          <a:xfrm>
            <a:off x="-5076720" y="2565360"/>
            <a:ext cx="813744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352320" y="6165720"/>
            <a:ext cx="2849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BA, UN SECOLO FA,PIAZZA UMBERTO 1°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7003080" y="632304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GGI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1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YNAPSES DETACH AND THEIR PLACE IS TAKEN  BY FIBROUS PROTEINS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ICH WILL RENDER DIFFICULT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FORMATION OF NEW SYNAPSES  AFTER  REPAIR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02" name="" descr=""/>
          <p:cNvPicPr/>
          <p:nvPr/>
        </p:nvPicPr>
        <p:blipFill>
          <a:blip r:embed="rId1"/>
          <a:stretch/>
        </p:blipFill>
        <p:spPr>
          <a:xfrm>
            <a:off x="2268360" y="549360"/>
            <a:ext cx="4608720" cy="3887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3" name=""/>
          <p:cNvGraphicFramePr/>
          <p:nvPr/>
        </p:nvGraphicFramePr>
        <p:xfrm>
          <a:off x="152280" y="152280"/>
          <a:ext cx="8839440" cy="65167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516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FTER NERVE INTERRUPTION THE MOTHER CELLS OF THE AXONS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 BE THEY  MOTOR NEURON  OF THE GREY ANTERIOR HORNS OR  SENSORY NEURONS OF THE SENSORY GANGLIA )  HAVE ONE ONLY COMMITMENT: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O RECONSTRUCT THEIR CYTOSKELETON . 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REFORE  THEY  </a:t>
                      </a:r>
                      <a:r>
                        <a:rPr b="0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STOP PRODUCING NEUROTRANSMITTERS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( USELESS DURING DENERVATION) AND  </a:t>
                      </a:r>
                      <a:r>
                        <a:rPr b="0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PRODUCE ONLY CYTOSOLIC SUBSTANC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FOR CYTOSKELETON RECONSTRUCT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04" name="" descr=""/>
          <p:cNvPicPr/>
          <p:nvPr/>
        </p:nvPicPr>
        <p:blipFill>
          <a:blip r:embed="rId1"/>
          <a:stretch/>
        </p:blipFill>
        <p:spPr>
          <a:xfrm>
            <a:off x="2843280" y="333360"/>
            <a:ext cx="3456000" cy="4032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5" name=""/>
          <p:cNvGraphicFramePr/>
          <p:nvPr/>
        </p:nvGraphicFramePr>
        <p:xfrm>
          <a:off x="324000" y="189000"/>
          <a:ext cx="8496000" cy="6192720"/>
        </p:xfrm>
        <a:graphic>
          <a:graphicData uri="http://schemas.openxmlformats.org/drawingml/2006/table">
            <a:tbl>
              <a:tblPr/>
              <a:tblGrid>
                <a:gridCol w="8496000"/>
              </a:tblGrid>
              <a:tr h="61927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EN  AN  INTERRUPTION OF AN AXON OCCURS THE MOTHER CELL  RESPONDS ,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cc99"/>
                          </a:solidFill>
                          <a:latin typeface="Arial"/>
                          <a:ea typeface="Arial"/>
                        </a:rPr>
                        <a:t>►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TO STMULI COMING FROM THE AXON: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 </a:t>
                      </a:r>
                      <a:r>
                        <a:rPr b="0" lang="en-US" sz="1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A)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RETURN OF UNDEMOLISHED  NEUROTRANSMITTERSI,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B)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LACK OF RETURN OF UTILISED NEURORANSMITTER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C)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ARRIVAL OF CATABOLIC ENZYMES FROM THE LESON SIT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D)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LACK OF MOLECULES  ORIGINATED AT THE  MOTOR END PLAT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cc99"/>
                          </a:solidFill>
                          <a:latin typeface="Arial"/>
                          <a:ea typeface="Arial"/>
                        </a:rPr>
                        <a:t>►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TO ALTERATIONS OF NEUROTRANSMITTERS ARRIVING TO THE CELL BOD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cc99"/>
                          </a:solidFill>
                          <a:latin typeface="Arial"/>
                          <a:ea typeface="Arial"/>
                        </a:rPr>
                        <a:t>►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TO STIMULI COMING FROM THE 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LOOD CIRCULATION DUE TO ACTIVATION OF ORMONS AND CATECHOLAMINES ( ADRENALINE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SE STIMULI ACTIVATE A GENETIC PROGRAM THAT ALLOWS THE SO CALLE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4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“</a:t>
                      </a:r>
                      <a:r>
                        <a:rPr b="1" lang="en-US" sz="14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RETROGRADE REACTION”</a:t>
                      </a:r>
                      <a:r>
                        <a:rPr b="0" lang="en-US" sz="14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  WHICH DEMANDS A </a:t>
                      </a:r>
                      <a:r>
                        <a:rPr b="1" lang="en-US" sz="14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RNA SYNTHESI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LSO THE  “MICROENVIRONMENT”   IS  INTERESTED 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ERUROGLIA, SATELLITE CELLS, CAPILLARIES ,  NEUROPI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INTERCELLULAR TISSUES AND SPACES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REPARATIVE PROCESS DEPENDS ALSO ON YHE SIZE OF THE</a:t>
                      </a:r>
                      <a:r>
                        <a:rPr b="0" lang="en-US" sz="1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1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“GAP”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ETWEEN THE NERVE STUMP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6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INTERRUPTION OF THE AXON  INTRODUCES THE DISAPPEARANCE   OF THE AXONAL ENDIG AT THE NEUROMUSCOLAR JUNCTION AND OF THE MYELIN SHEATH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MYELIN IS PHAGOCITATED  BY THE SCHWANN CELLS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MUSCOLAR MEBRANE  LOSSES ITS  PECULIAR FOLDIN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FACT THE MOTOR END-PLATE IS </a:t>
                      </a:r>
                      <a:r>
                        <a:rPr b="0" lang="en-US" sz="16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 NOT  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 ANATOMICAL</a:t>
                      </a:r>
                      <a:r>
                        <a:rPr b="0" lang="en-US" sz="1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STRUCTURE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UT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A FUNCTIONAL ATTITUDE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07" name="" descr=""/>
          <p:cNvPicPr/>
          <p:nvPr/>
        </p:nvPicPr>
        <p:blipFill>
          <a:blip r:embed="rId1"/>
          <a:stretch/>
        </p:blipFill>
        <p:spPr>
          <a:xfrm>
            <a:off x="684360" y="476280"/>
            <a:ext cx="3456000" cy="3384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208" name="" descr=""/>
          <p:cNvPicPr/>
          <p:nvPr/>
        </p:nvPicPr>
        <p:blipFill>
          <a:blip r:embed="rId2">
            <a:lum contrast="12000"/>
          </a:blip>
          <a:stretch/>
        </p:blipFill>
        <p:spPr>
          <a:xfrm>
            <a:off x="4859280" y="549360"/>
            <a:ext cx="3384720" cy="33112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09" name=""/>
          <p:cNvSpPr/>
          <p:nvPr/>
        </p:nvSpPr>
        <p:spPr>
          <a:xfrm>
            <a:off x="5724360" y="1052640"/>
            <a:ext cx="976320" cy="215640"/>
          </a:xfrm>
          <a:prstGeom prst="rightArrow">
            <a:avLst>
              <a:gd name="adj1" fmla="val 50000"/>
              <a:gd name="adj2" fmla="val 113189"/>
            </a:avLst>
          </a:prstGeom>
          <a:solidFill>
            <a:srgbClr val="ff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"/>
          <p:cNvSpPr/>
          <p:nvPr/>
        </p:nvSpPr>
        <p:spPr>
          <a:xfrm rot="11135400">
            <a:off x="7235280" y="1684440"/>
            <a:ext cx="215640" cy="976320"/>
          </a:xfrm>
          <a:prstGeom prst="upArrow">
            <a:avLst>
              <a:gd name="adj1" fmla="val 50000"/>
              <a:gd name="adj2" fmla="val 113189"/>
            </a:avLst>
          </a:prstGeom>
          <a:solidFill>
            <a:srgbClr val="66ff3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1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PPEARANCE OF THE FRAGMENTATION OF THE MYELIN SHEATH AND OF THE PHAGOCITATIO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BY  SCHWANN  CELL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IN THE SOCALLED  HERZOLD GLOB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684360" y="62028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\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213" name="" descr=""/>
          <p:cNvPicPr/>
          <p:nvPr/>
        </p:nvPicPr>
        <p:blipFill>
          <a:blip r:embed="rId1"/>
          <a:stretch/>
        </p:blipFill>
        <p:spPr>
          <a:xfrm>
            <a:off x="2340000" y="620640"/>
            <a:ext cx="4319640" cy="3816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4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CHEMATIC APPEARANCE OF THE AXONAL REPAIR AT LESION SITE LEVE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THE FIRST DAYS SCHWANN CELL PROLIPHERATE INSIDE THE ENDONEURAL TUBE 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FTER SOME DAYS THE PROXXIMAL STUMP OF THE AXON  SENDS OUT SOME SPROUT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OME OF WHICH ARE TOO THIN AND WILL BE ELIMINATE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OME OTHER WILL BE STOPPED BY FIBROBLASTIC PROLIFERA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THERS , MORE  HEARTY WILL PROCEED INTO THE ENDONEURAL TUB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WILL BE REMYELINATED EVEN IF WITH LESS THICK  ENVELOPS AND WITH SHORTER INTERNODAL  TRACTS  ( MINOR SPEED OF CONDUCTION)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sp>
        <p:nvSpPr>
          <p:cNvPr id="215" name="PlaceHolder 1"/>
          <p:cNvSpPr>
            <a:spLocks noGrp="1"/>
          </p:cNvSpPr>
          <p:nvPr>
            <p:ph type="title"/>
          </p:nvPr>
        </p:nvSpPr>
        <p:spPr>
          <a:xfrm>
            <a:off x="684360" y="62028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\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216" name="" descr=""/>
          <p:cNvPicPr/>
          <p:nvPr/>
        </p:nvPicPr>
        <p:blipFill>
          <a:blip r:embed="rId1"/>
          <a:stretch/>
        </p:blipFill>
        <p:spPr>
          <a:xfrm>
            <a:off x="1979640" y="404640"/>
            <a:ext cx="5400720" cy="3527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17" name=""/>
          <p:cNvSpPr/>
          <p:nvPr/>
        </p:nvSpPr>
        <p:spPr>
          <a:xfrm>
            <a:off x="7667640" y="5300640"/>
            <a:ext cx="976320" cy="142920"/>
          </a:xfrm>
          <a:prstGeom prst="rightArrow">
            <a:avLst>
              <a:gd name="adj1" fmla="val 50000"/>
              <a:gd name="adj2" fmla="val 170781"/>
            </a:avLst>
          </a:prstGeom>
          <a:solidFill>
            <a:srgbClr val="ff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840" bIns="248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"/>
          <p:cNvSpPr/>
          <p:nvPr/>
        </p:nvSpPr>
        <p:spPr>
          <a:xfrm>
            <a:off x="3995640" y="1700280"/>
            <a:ext cx="687600" cy="144360"/>
          </a:xfrm>
          <a:prstGeom prst="rightArrow">
            <a:avLst>
              <a:gd name="adj1" fmla="val 50000"/>
              <a:gd name="adj2" fmla="val 119077"/>
            </a:avLst>
          </a:prstGeom>
          <a:solidFill>
            <a:srgbClr val="ff33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9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PPEARANCE OF A SCAR BLOCK OF A REGENERATING FASCICL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sp>
        <p:nvSpPr>
          <p:cNvPr id="220" name="PlaceHolder 1"/>
          <p:cNvSpPr>
            <a:spLocks noGrp="1"/>
          </p:cNvSpPr>
          <p:nvPr>
            <p:ph type="title"/>
          </p:nvPr>
        </p:nvSpPr>
        <p:spPr>
          <a:xfrm>
            <a:off x="684360" y="62028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\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221" name="" descr=""/>
          <p:cNvPicPr/>
          <p:nvPr/>
        </p:nvPicPr>
        <p:blipFill>
          <a:blip r:embed="rId1">
            <a:lum contrast="36000"/>
          </a:blip>
          <a:stretch/>
        </p:blipFill>
        <p:spPr>
          <a:xfrm>
            <a:off x="2700360" y="981000"/>
            <a:ext cx="3527280" cy="3527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2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INSIDE AN OLD ENDONEURAL TUBE  (</a:t>
                      </a:r>
                      <a:r>
                        <a:rPr b="0" lang="en-US" sz="16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OUTLINED  IN RED 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ERE ARE VARIOUS AXONAL SPROUT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SOME ARE THICK ENOUGH AND ARE MYELINATED (</a:t>
                      </a:r>
                      <a:r>
                        <a:rPr b="1" lang="en-US" sz="1600" spc="-1" strike="noStrike">
                          <a:solidFill>
                            <a:srgbClr val="ff0066"/>
                          </a:solidFill>
                          <a:latin typeface="Arial"/>
                        </a:rPr>
                        <a:t>A</a:t>
                      </a: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SOME ARE SMALLER  INSIDE A SCHWANN CELL, (</a:t>
                      </a:r>
                      <a:r>
                        <a:rPr b="1" lang="en-US" sz="1600" spc="-1" strike="noStrike">
                          <a:solidFill>
                            <a:srgbClr val="00cc99"/>
                          </a:solidFill>
                          <a:latin typeface="Arial"/>
                        </a:rPr>
                        <a:t>B</a:t>
                      </a: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SOME OTHER VERY THIN AND UNMYELINATED ( </a:t>
                      </a:r>
                      <a:r>
                        <a:rPr b="1" lang="en-US" sz="1600" spc="-1" strike="noStrike">
                          <a:solidFill>
                            <a:srgbClr val="ff0066"/>
                          </a:solidFill>
                          <a:latin typeface="Arial"/>
                        </a:rPr>
                        <a:t>C</a:t>
                      </a: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23" name="" descr=""/>
          <p:cNvPicPr/>
          <p:nvPr/>
        </p:nvPicPr>
        <p:blipFill>
          <a:blip r:embed="rId1"/>
          <a:stretch/>
        </p:blipFill>
        <p:spPr>
          <a:xfrm>
            <a:off x="5148360" y="620640"/>
            <a:ext cx="3004920" cy="2664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224" name="" descr=""/>
          <p:cNvPicPr/>
          <p:nvPr/>
        </p:nvPicPr>
        <p:blipFill>
          <a:blip r:embed="rId2"/>
          <a:stretch/>
        </p:blipFill>
        <p:spPr>
          <a:xfrm>
            <a:off x="611280" y="620640"/>
            <a:ext cx="3544920" cy="26766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25" name=""/>
          <p:cNvSpPr/>
          <p:nvPr/>
        </p:nvSpPr>
        <p:spPr>
          <a:xfrm>
            <a:off x="1457280" y="9748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ff0066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"/>
          <p:cNvSpPr/>
          <p:nvPr/>
        </p:nvSpPr>
        <p:spPr>
          <a:xfrm>
            <a:off x="2411280" y="1844640"/>
            <a:ext cx="513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ff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7" name=""/>
          <p:cNvSpPr/>
          <p:nvPr/>
        </p:nvSpPr>
        <p:spPr>
          <a:xfrm>
            <a:off x="1312200" y="2055960"/>
            <a:ext cx="8298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ff0066"/>
                </a:solidFill>
                <a:latin typeface="Arial"/>
              </a:rPr>
              <a:t>C    C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8" name=""/>
          <p:cNvSpPr/>
          <p:nvPr/>
        </p:nvSpPr>
        <p:spPr>
          <a:xfrm>
            <a:off x="826920" y="2924280"/>
            <a:ext cx="576360" cy="3585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9" name=""/>
          <p:cNvSpPr/>
          <p:nvPr/>
        </p:nvSpPr>
        <p:spPr>
          <a:xfrm rot="1765800">
            <a:off x="3780000" y="3357360"/>
            <a:ext cx="2519280" cy="288720"/>
          </a:xfrm>
          <a:prstGeom prst="leftArrow">
            <a:avLst>
              <a:gd name="adj1" fmla="val 50000"/>
              <a:gd name="adj2" fmla="val 218142"/>
            </a:avLst>
          </a:prstGeom>
          <a:solidFill>
            <a:srgbClr val="ff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0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OR THE MUSCULAR FIBRES THAT HAVE NOT BEEN REINNERVATE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RE IS A COMPENSATORY  MECHANISM THAT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CAN  RESTITUTE A SUFFICIENT FUNCTIO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T IS THE  </a:t>
                      </a:r>
                      <a:r>
                        <a:rPr b="0" lang="en-US" sz="20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ADOPTION PHOENOMENON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Y WHICH THE MUSCULAR  ORPHAN FIBRES MAY BE REINNERVATE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Y MEANS OF NERVE BRANCH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COMING FROM RANVIER NODES OR FROM MOTOR END-PLATES OF REGENERATED AX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31" name="" descr=""/>
          <p:cNvPicPr/>
          <p:nvPr/>
        </p:nvPicPr>
        <p:blipFill>
          <a:blip r:embed="rId1"/>
          <a:stretch/>
        </p:blipFill>
        <p:spPr>
          <a:xfrm>
            <a:off x="611280" y="260280"/>
            <a:ext cx="3816360" cy="37450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232" name="" descr=""/>
          <p:cNvPicPr/>
          <p:nvPr/>
        </p:nvPicPr>
        <p:blipFill>
          <a:blip r:embed="rId2">
            <a:lum bright="-6000"/>
          </a:blip>
          <a:stretch/>
        </p:blipFill>
        <p:spPr>
          <a:xfrm>
            <a:off x="4643280" y="260280"/>
            <a:ext cx="3872160" cy="37450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33" name=""/>
          <p:cNvSpPr/>
          <p:nvPr/>
        </p:nvSpPr>
        <p:spPr>
          <a:xfrm>
            <a:off x="611280" y="260280"/>
            <a:ext cx="3816360" cy="2890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990000"/>
                </a:solidFill>
                <a:latin typeface="Arial"/>
              </a:rPr>
              <a:t>BROWN, HOLLAND &amp; HOPKINS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4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IS PHOENOMENON OCCURS ALSO IN PROGRESSIVE DENERVATIONS ,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IN CASE OF NERVE ENTRAPMENT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( E.G.:  CARPAL TUNNEL  COMPRESSION OF MEDIAN NERVE )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E ADOPTION PHOENOMENON ALLOWS THE FORMATION  OF GIANT MOTOR UNIT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00ff00"/>
                          </a:solidFill>
                          <a:latin typeface="Arial"/>
                        </a:rPr>
                        <a:t>WHICH MASK THE PALSY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A GIVEN POINT, HOWEVER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.</a:t>
                      </a:r>
                      <a:r>
                        <a:rPr b="0" lang="en-US" sz="16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WHEN THE COMPRESSION DETERMINES THE DENERVATION OF THE LAST GIANT UNITS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PALSY  SUDDENLY APPEARS  AND THERE IS NOTHING TO D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35" name="" descr=""/>
          <p:cNvPicPr/>
          <p:nvPr/>
        </p:nvPicPr>
        <p:blipFill>
          <a:blip r:embed="rId1"/>
          <a:stretch/>
        </p:blipFill>
        <p:spPr>
          <a:xfrm>
            <a:off x="5364000" y="476280"/>
            <a:ext cx="2953080" cy="3384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236" name="" descr=""/>
          <p:cNvPicPr/>
          <p:nvPr/>
        </p:nvPicPr>
        <p:blipFill>
          <a:blip r:embed="rId2"/>
          <a:stretch/>
        </p:blipFill>
        <p:spPr>
          <a:xfrm>
            <a:off x="900000" y="476280"/>
            <a:ext cx="2952720" cy="33829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8" name=""/>
          <p:cNvGraphicFramePr/>
          <p:nvPr/>
        </p:nvGraphicFramePr>
        <p:xfrm>
          <a:off x="468360" y="260280"/>
          <a:ext cx="8424360" cy="6264360"/>
        </p:xfrm>
        <a:graphic>
          <a:graphicData uri="http://schemas.openxmlformats.org/drawingml/2006/table">
            <a:tbl>
              <a:tblPr/>
              <a:tblGrid>
                <a:gridCol w="8424360"/>
              </a:tblGrid>
              <a:tr h="6264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NERVOUS SYSTEM ORIGINATES  FROM ECTODERMA  THAT AFTERWARDS CHANGES IN NEURAL TUBE UNDER THE ACTION OF BMP4 (BONE MORPHOGENIC PROTEIN 4</a:t>
                      </a:r>
                      <a:r>
                        <a:rPr b="0" lang="en-US" sz="2000" spc="-1" strike="noStrike">
                          <a:solidFill>
                            <a:srgbClr val="00ffff"/>
                          </a:solidFill>
                          <a:latin typeface="Arial"/>
                        </a:rPr>
                        <a:t>)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38160">
                      <a:solidFill>
                        <a:srgbClr val="00cc99"/>
                      </a:solidFill>
                    </a:lnL>
                    <a:lnR w="38160">
                      <a:solidFill>
                        <a:srgbClr val="00cc99"/>
                      </a:solidFill>
                    </a:lnR>
                    <a:lnT w="38160">
                      <a:solidFill>
                        <a:srgbClr val="00cc99"/>
                      </a:solidFill>
                    </a:lnT>
                    <a:lnB w="38160">
                      <a:solidFill>
                        <a:srgbClr val="00cc99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9" name=""/>
          <p:cNvSpPr/>
          <p:nvPr/>
        </p:nvSpPr>
        <p:spPr>
          <a:xfrm>
            <a:off x="179280" y="3716280"/>
            <a:ext cx="81378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3352320" y="6165720"/>
            <a:ext cx="2849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BA, UN SECOLO FA,PIAZZA UMBERTO 1°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7003080" y="632304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GGI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900000" y="2060640"/>
            <a:ext cx="3527640" cy="4032360"/>
          </a:xfrm>
          <a:prstGeom prst="rect">
            <a:avLst/>
          </a:prstGeom>
          <a:ln w="76320">
            <a:solidFill>
              <a:srgbClr val="ff0000"/>
            </a:solidFill>
            <a:miter/>
          </a:ln>
        </p:spPr>
      </p:pic>
      <p:pic>
        <p:nvPicPr>
          <p:cNvPr id="63" name="" descr=""/>
          <p:cNvPicPr/>
          <p:nvPr/>
        </p:nvPicPr>
        <p:blipFill>
          <a:blip r:embed="rId2"/>
          <a:stretch/>
        </p:blipFill>
        <p:spPr>
          <a:xfrm>
            <a:off x="5148360" y="2060640"/>
            <a:ext cx="3456000" cy="4105080"/>
          </a:xfrm>
          <a:prstGeom prst="rect">
            <a:avLst/>
          </a:prstGeom>
          <a:ln w="76320">
            <a:solidFill>
              <a:srgbClr val="ff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7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238" name="" descr=""/>
          <p:cNvPicPr/>
          <p:nvPr/>
        </p:nvPicPr>
        <p:blipFill>
          <a:blip r:embed="rId1">
            <a:lum contrast="48000"/>
          </a:blip>
          <a:stretch/>
        </p:blipFill>
        <p:spPr>
          <a:xfrm>
            <a:off x="1332000" y="907920"/>
            <a:ext cx="6624720" cy="48261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9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7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 u="sng">
                          <a:solidFill>
                            <a:srgbClr val="ff0000"/>
                          </a:solidFill>
                          <a:uFillTx/>
                          <a:latin typeface="Arial"/>
                        </a:rPr>
                        <a:t>CONSIDERATIONS REGARDING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7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3200" spc="-1" strike="noStrike" u="sng">
                          <a:solidFill>
                            <a:srgbClr val="ff0000"/>
                          </a:solidFill>
                          <a:uFillTx/>
                          <a:latin typeface="Arial"/>
                        </a:rPr>
                        <a:t>THE NERVE REPAIR</a:t>
                      </a:r>
                      <a:endParaRPr b="0" lang="en-US" sz="3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0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PERIPHERAL NERVES  HAVE DIFFERENT INTERNAL STRUCTURES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ICH CONDITION THE TECHNIQUES OF SUTURE AS WELL AS THE RESULT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ICH WILL BE AS BETTER AS  MORE CORRECT IS THE  JUXTAPOSITION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THE VARIOUS FASCICLES HAVING DIFFERENT FUNCTIIONS: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STRUCTURE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MONOFASCICULAR , PAUCIFASCICULAR,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MULTIFASCICULAR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WITH GROUPS OF FASCICLES HAVING THE SAME FUNC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OR MULTIFASCICULAR </a:t>
                      </a: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WITHOUT GROUP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41" name="" descr=""/>
          <p:cNvPicPr/>
          <p:nvPr/>
        </p:nvPicPr>
        <p:blipFill>
          <a:blip r:embed="rId1"/>
          <a:stretch/>
        </p:blipFill>
        <p:spPr>
          <a:xfrm>
            <a:off x="2340000" y="333360"/>
            <a:ext cx="4176720" cy="3384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2" name=""/>
          <p:cNvGraphicFramePr/>
          <p:nvPr/>
        </p:nvGraphicFramePr>
        <p:xfrm>
          <a:off x="152280" y="333360"/>
          <a:ext cx="8839440" cy="612000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126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 PAUCI-FASCICULAR AND GROUPED  MULTIFASCICULAR NERVES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CORRECT  JUXTAPOSITION OF FASCICLES HAVING THE SAME FUNCT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MAY BE GUIDED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Y THE EXTERNAL SHAPE OF THE NERVE,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Y THE POSITION OF THE EPINEURAL VESSEL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Y THE MIRROR MAP OF THE FASCICLES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Y  THE POSITION OF THE BRANCHES THAT WILL BECOME COLLATERAL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43" name="" descr=""/>
          <p:cNvPicPr/>
          <p:nvPr/>
        </p:nvPicPr>
        <p:blipFill>
          <a:blip r:embed="rId1"/>
          <a:stretch/>
        </p:blipFill>
        <p:spPr>
          <a:xfrm>
            <a:off x="2411280" y="549360"/>
            <a:ext cx="4032360" cy="3384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4" name=""/>
          <p:cNvGraphicFramePr/>
          <p:nvPr/>
        </p:nvGraphicFramePr>
        <p:xfrm>
          <a:off x="179280" y="260280"/>
          <a:ext cx="8839440" cy="619308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1930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POSITION OF THE FASCICLES  HAVING  DIFFERENT FUNC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S ALSO RECOGNIZABL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Y LOOKING AT THE INTRANEURAL MAPS OF THE PERIPHERAL NERV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PREPARED  WITH  METICULOUS  DISSECTIONS UNDER THE OPERATING MICROSCOP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Y  SOME  AUTHOR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R  WITH  PATIENT INTRAOPERATORY ELECTRICAL STIMULATIO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THE  INTACT TRUNKS OR CORDS OF  DAMAGED  BRACHIAL PLEXUS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45" name="" descr=""/>
          <p:cNvPicPr/>
          <p:nvPr/>
        </p:nvPicPr>
        <p:blipFill>
          <a:blip r:embed="rId1">
            <a:lum contrast="42000"/>
          </a:blip>
          <a:stretch/>
        </p:blipFill>
        <p:spPr>
          <a:xfrm>
            <a:off x="539640" y="647640"/>
            <a:ext cx="3816360" cy="3573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246" name="" descr=""/>
          <p:cNvPicPr/>
          <p:nvPr/>
        </p:nvPicPr>
        <p:blipFill>
          <a:blip r:embed="rId2">
            <a:lum bright="18000"/>
          </a:blip>
          <a:stretch/>
        </p:blipFill>
        <p:spPr>
          <a:xfrm>
            <a:off x="4932360" y="620640"/>
            <a:ext cx="3745080" cy="35290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47" name=""/>
          <p:cNvSpPr/>
          <p:nvPr/>
        </p:nvSpPr>
        <p:spPr>
          <a:xfrm>
            <a:off x="754560" y="717480"/>
            <a:ext cx="3356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ff0066"/>
                </a:solidFill>
                <a:latin typeface="Arial"/>
              </a:rPr>
              <a:t>CLINICA ORTOP.UNIV.BRESCIA 1985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8" name=""/>
          <p:cNvSpPr/>
          <p:nvPr/>
        </p:nvSpPr>
        <p:spPr>
          <a:xfrm>
            <a:off x="5292720" y="765000"/>
            <a:ext cx="1224000" cy="64800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ff0066"/>
                </a:solidFill>
                <a:latin typeface="Arial"/>
              </a:rPr>
              <a:t>BRUNELLI  1978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9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INTERNAL ARRANGEMENT OF NERVE FIBRES IN PLEXUSES IS VERY  INTRICAT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ECAUSE  THE ANTERIOR MOTOR ROOTS AND THE POSTERIOR SENSORY ON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MUST CROSS-OVER TO FORM MINGLED NERV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FIBRES COMING FROM  C 5 TO T 1 MUST CROSS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ROM  TOP TO BOTTOM TO FORM  NERVES,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 EXTENSORY FIBRES  MUST GO POSTERIORLY  WHEREAS THE FLEXORY AND PRONATORY ONES MUST GO IN FRONT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50" name="" descr=""/>
          <p:cNvPicPr/>
          <p:nvPr/>
        </p:nvPicPr>
        <p:blipFill>
          <a:blip r:embed="rId1"/>
          <a:stretch/>
        </p:blipFill>
        <p:spPr>
          <a:xfrm>
            <a:off x="2268360" y="549360"/>
            <a:ext cx="5042160" cy="3456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1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REFORE IT IS NECESSARY THAT  MOTOR AND SENSORY FASCICLES BE JUXTAPOSED  EXACTLY TO FASCICLES OF THE DISTAL STUMP HAVING THE SAME  MEANING  OTHERWISE  THE FUNCTION WILL NOT BE RESTORED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FACT  SOME AXONS  WILL BE STOPPED  BY SCAR FIBROBLASTS,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THERS  WILL MEET  UNLIKE AXONS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MOTOR INSTEAD THAN SENSORY OR  VICEVERSA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AT IS MORE  EVEN THOSE THAT WILL MEET AXONS OF THE SAME MEANIN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MAY HAVE LIMITED FUNCTION  BECAUSE OF THE FORMATION OF MORE NUMEROUS BUT THINNER AND LESS MYELINATED  AXONS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52" name="" descr=""/>
          <p:cNvPicPr/>
          <p:nvPr/>
        </p:nvPicPr>
        <p:blipFill>
          <a:blip r:embed="rId1">
            <a:lum contrast="24000"/>
          </a:blip>
          <a:stretch/>
        </p:blipFill>
        <p:spPr>
          <a:xfrm>
            <a:off x="324000" y="404640"/>
            <a:ext cx="4176720" cy="3311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253" name="" descr=""/>
          <p:cNvPicPr/>
          <p:nvPr/>
        </p:nvPicPr>
        <p:blipFill>
          <a:blip r:embed="rId2">
            <a:lum bright="6000"/>
          </a:blip>
          <a:stretch/>
        </p:blipFill>
        <p:spPr>
          <a:xfrm>
            <a:off x="4572000" y="404640"/>
            <a:ext cx="4176720" cy="3311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4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4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                                                     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4400" spc="-1" strike="noStrike" u="sng">
                          <a:solidFill>
                            <a:srgbClr val="ff0000"/>
                          </a:solidFill>
                          <a:uFillTx/>
                          <a:latin typeface="Arial"/>
                        </a:rPr>
                        <a:t>   </a:t>
                      </a: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4400" spc="-1" strike="noStrike" u="sng">
                          <a:solidFill>
                            <a:srgbClr val="ff0000"/>
                          </a:solidFill>
                          <a:uFillTx/>
                          <a:latin typeface="Arial"/>
                        </a:rPr>
                        <a:t>                             </a:t>
                      </a: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 C.A.M. OF THE SCHWANN CELLS OF THE DISTAL STUMP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HAVE   DIFFERENT </a:t>
                      </a:r>
                      <a:r>
                        <a:rPr b="1" lang="en-US" sz="20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PHYSICAL  AND CHEMICAL</a:t>
                      </a:r>
                      <a:r>
                        <a:rPr b="0" lang="en-US" sz="20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 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TRUCTUR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ORDER TO  BE SUITABLE FOR  THE MOLECUL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THE GROWTH  CONE OF THE AXONAL SPROUT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HAVING THE SAME DESTIN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55" name="" descr=""/>
          <p:cNvPicPr/>
          <p:nvPr/>
        </p:nvPicPr>
        <p:blipFill>
          <a:blip r:embed="rId1"/>
          <a:stretch/>
        </p:blipFill>
        <p:spPr>
          <a:xfrm>
            <a:off x="2340000" y="981000"/>
            <a:ext cx="4321080" cy="3240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5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7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THE HEALING PROCESS OF NERVES  WE MUST ALSO TAKE INTO CONSIDERATION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ENORMOUS REPARATIVE EFFORT  THAT THE MOTHER CELL HAS TO MAKE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 CELL  OF 268.000 CUBE MICRONS ( 8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µ OF Ø ) (4/3 </a:t>
                      </a:r>
                      <a:r>
                        <a:rPr b="0" lang="el-GR" sz="16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π</a:t>
                      </a:r>
                      <a:r>
                        <a:rPr b="0" lang="it-IT" sz="16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 r 3 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MUST RECONSTRUCT THE CYTOSKELETON  OF AN AXON THAT CAN  BE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6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76,500,000 CUBE MICRONS ( 10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µ OF Ø FOR 1 METER OF LENGTH) (  </a:t>
                      </a:r>
                      <a:r>
                        <a:rPr b="0" lang="el-GR" sz="16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π</a:t>
                      </a:r>
                      <a:r>
                        <a:rPr b="0" lang="it-IT" sz="1600" spc="-1" strike="noStrike">
                          <a:solidFill>
                            <a:srgbClr val="ffff00"/>
                          </a:solidFill>
                          <a:latin typeface="Arial"/>
                          <a:ea typeface="Arial"/>
                        </a:rPr>
                        <a:t> r 2 h 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58" name="" descr=""/>
          <p:cNvPicPr/>
          <p:nvPr/>
        </p:nvPicPr>
        <p:blipFill>
          <a:blip r:embed="rId1">
            <a:lum contrast="36000"/>
          </a:blip>
          <a:stretch/>
        </p:blipFill>
        <p:spPr>
          <a:xfrm>
            <a:off x="2268360" y="333360"/>
            <a:ext cx="4608720" cy="4176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59" name=""/>
          <p:cNvSpPr/>
          <p:nvPr/>
        </p:nvSpPr>
        <p:spPr>
          <a:xfrm>
            <a:off x="2268360" y="4221000"/>
            <a:ext cx="863640" cy="287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0" name=""/>
          <p:cNvGraphicFramePr/>
          <p:nvPr/>
        </p:nvGraphicFramePr>
        <p:xfrm>
          <a:off x="179280" y="152280"/>
          <a:ext cx="8812440" cy="6477120"/>
        </p:xfrm>
        <a:graphic>
          <a:graphicData uri="http://schemas.openxmlformats.org/drawingml/2006/table">
            <a:tbl>
              <a:tblPr/>
              <a:tblGrid>
                <a:gridCol w="8812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HAVING IN MIND ALL THAT WE HAVE SAID, THE BEST TIME FOR SURGICAL NERVE REPAIR   FROM THE THEORETICAL POINT OF VIEW  SHOULD   BE </a:t>
                      </a:r>
                      <a:r>
                        <a:rPr b="0" lang="en-US" sz="12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IN EMERGENCY</a:t>
                      </a: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FOR DISTAL LESIONS AND </a:t>
                      </a:r>
                      <a:r>
                        <a:rPr b="0" lang="en-US" sz="12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DELAYED</a:t>
                      </a: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(20 DAYS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OR PROXIMAL SEVERANCES THAT REQUIRE  THE RECONSTRUCTION OF A GREATER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MOUNT OF CYTOSKELETON.  DELAYED REPAIR ALLOWS ALSO THE REMOVAL OF THE SCA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ORMED IN THE MEANWHILE  AND TO CONNECT   A PROXIMAL STUMP RICH IN NEOFORMED PROTEINS AND READY TO SEND TO PERIPHERY  SOUND AXONAL SPROUTS.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PRACTICALLY. HOWEVER,  VARIOUS CONTINGENT CONSIDERATI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WILL CONDITION THE CHOICE OF REPAIRING TI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61" name="" descr=""/>
          <p:cNvPicPr/>
          <p:nvPr/>
        </p:nvPicPr>
        <p:blipFill>
          <a:blip r:embed="rId1"/>
          <a:stretch/>
        </p:blipFill>
        <p:spPr>
          <a:xfrm>
            <a:off x="2195640" y="333360"/>
            <a:ext cx="4968720" cy="4032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62" name=""/>
          <p:cNvSpPr/>
          <p:nvPr/>
        </p:nvSpPr>
        <p:spPr>
          <a:xfrm>
            <a:off x="6732720" y="333360"/>
            <a:ext cx="431640" cy="358920"/>
          </a:xfrm>
          <a:prstGeom prst="rect">
            <a:avLst/>
          </a:prstGeom>
          <a:solidFill>
            <a:srgbClr val="b2b2b2"/>
          </a:solidFill>
          <a:ln w="9360">
            <a:solidFill>
              <a:srgbClr val="cccc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4" name=""/>
          <p:cNvGraphicFramePr/>
          <p:nvPr/>
        </p:nvGraphicFramePr>
        <p:xfrm>
          <a:off x="611280" y="1197000"/>
          <a:ext cx="8137440" cy="4476600"/>
        </p:xfrm>
        <a:graphic>
          <a:graphicData uri="http://schemas.openxmlformats.org/drawingml/2006/table">
            <a:tbl>
              <a:tblPr/>
              <a:tblGrid>
                <a:gridCol w="8137440"/>
              </a:tblGrid>
              <a:tr h="44766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ROM THE NEURAL TUBE FORM  VARIOUS TYPES OF NEURONS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AN UNBELIEVABLE FAST   RHYITHM,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AT MULTIPLY  IN STREPITOUS QUANTITY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21° DAY, 250.000 NEURONS ARE GENERATED PER MINUTE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THE END OF THE SECOND MONTH NEURONS MIGRATE TO THE CORTEX AND TAKE THEIR DEFINITIVE PLACE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38160">
                      <a:solidFill>
                        <a:srgbClr val="00cc99"/>
                      </a:solidFill>
                    </a:lnL>
                    <a:lnR w="38160">
                      <a:solidFill>
                        <a:srgbClr val="00cc99"/>
                      </a:solidFill>
                    </a:lnR>
                    <a:lnT w="38160">
                      <a:solidFill>
                        <a:srgbClr val="00cc99"/>
                      </a:solidFill>
                    </a:lnT>
                    <a:lnB w="38160">
                      <a:solidFill>
                        <a:srgbClr val="00cc99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5" name=""/>
          <p:cNvSpPr/>
          <p:nvPr/>
        </p:nvSpPr>
        <p:spPr>
          <a:xfrm>
            <a:off x="179280" y="3716280"/>
            <a:ext cx="8137800" cy="336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3352320" y="6165720"/>
            <a:ext cx="284904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LBA, UN SECOLO FA,PIAZZA UMBERTO 1°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7003080" y="632304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GGI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3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YWAY EVEN IF AT TRANSVERSE SECTIONS OF A REPAIRED NERVE  WE CAN COUNT THE SAME NUMBER OF AXONS UPSTREAM AND DOWNSTREAM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OME OF THOSE ARE NOT SOUN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S DEMONSTRATED BY THE FOLLOWING SCHE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64" name="" descr=""/>
          <p:cNvPicPr/>
          <p:nvPr/>
        </p:nvPicPr>
        <p:blipFill>
          <a:blip r:embed="rId1"/>
          <a:stretch/>
        </p:blipFill>
        <p:spPr>
          <a:xfrm>
            <a:off x="395280" y="2133720"/>
            <a:ext cx="4465800" cy="39592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265" name="" descr=""/>
          <p:cNvPicPr/>
          <p:nvPr/>
        </p:nvPicPr>
        <p:blipFill>
          <a:blip r:embed="rId2"/>
          <a:stretch/>
        </p:blipFill>
        <p:spPr>
          <a:xfrm>
            <a:off x="5076720" y="2133720"/>
            <a:ext cx="3672000" cy="396072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6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HISTIORICAL PHOTOGRAF OF EDSHAG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 YEARS ’60IES  ) SHOWING THE CHAOTIC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RRANGEMET OF THE FASCICL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SIDE A NERV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ITH  EPINEURAL SUTUR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PPARENTLY  PERFEC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CHEME OF VARIOUS TYPES OF NERVE SUTUR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PROPOSED ALONG THE YEAR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BEST ONE  IS THAT SHOWN IN </a:t>
                      </a:r>
                      <a:r>
                        <a:rPr b="0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D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PERINEURAL SUTURE OF SINGLE FASCICLES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67" name="" descr=""/>
          <p:cNvPicPr/>
          <p:nvPr/>
        </p:nvPicPr>
        <p:blipFill>
          <a:blip r:embed="rId1"/>
          <a:stretch/>
        </p:blipFill>
        <p:spPr>
          <a:xfrm>
            <a:off x="324000" y="260280"/>
            <a:ext cx="3816360" cy="1974960"/>
          </a:xfrm>
          <a:prstGeom prst="rect">
            <a:avLst/>
          </a:prstGeom>
          <a:ln w="76320">
            <a:solidFill>
              <a:srgbClr val="ff0000"/>
            </a:solidFill>
            <a:miter/>
          </a:ln>
        </p:spPr>
      </p:pic>
      <p:pic>
        <p:nvPicPr>
          <p:cNvPr id="268" name="" descr=""/>
          <p:cNvPicPr/>
          <p:nvPr/>
        </p:nvPicPr>
        <p:blipFill>
          <a:blip r:embed="rId2"/>
          <a:stretch/>
        </p:blipFill>
        <p:spPr>
          <a:xfrm>
            <a:off x="5580000" y="2205000"/>
            <a:ext cx="3311640" cy="4248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269" name="" descr=""/>
          <p:cNvPicPr/>
          <p:nvPr/>
        </p:nvPicPr>
        <p:blipFill>
          <a:blip r:embed="rId3">
            <a:lum contrast="24000"/>
          </a:blip>
          <a:stretch/>
        </p:blipFill>
        <p:spPr>
          <a:xfrm>
            <a:off x="395280" y="2492280"/>
            <a:ext cx="3195720" cy="21178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70" name=""/>
          <p:cNvSpPr/>
          <p:nvPr/>
        </p:nvSpPr>
        <p:spPr>
          <a:xfrm>
            <a:off x="3995640" y="1197000"/>
            <a:ext cx="976320" cy="216000"/>
          </a:xfrm>
          <a:prstGeom prst="leftArrow">
            <a:avLst>
              <a:gd name="adj1" fmla="val 50000"/>
              <a:gd name="adj2" fmla="val 113000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1" name=""/>
          <p:cNvGraphicFramePr/>
          <p:nvPr/>
        </p:nvGraphicFramePr>
        <p:xfrm>
          <a:off x="152280" y="152280"/>
          <a:ext cx="8839440" cy="666144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6614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A NORMALLY INNERVATED  MUSCLE THE  ACh  RECEPTORS , IN THE MUSCLE MEMBRANE ARE GROUPED UNDEDR THE NERVE ENDING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A DENERVATED MUSCLE, ON THE CONTRARY,  THE RECEPTORS ARE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CATTERED  ALL OVER THE  SURFACE OF THE  MUSCULAR FIBROCELL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IS PHOENOMENON ALLOWS THE INNERVATION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A DENERVATED MUSCLE IN  ANY SIT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IS IS THE </a:t>
                      </a:r>
                      <a:r>
                        <a:rPr b="1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 DIRECT MUSCOLAR </a:t>
                      </a: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1" lang="en-US" sz="20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NEUROTISATION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 PROPOSED IN  1970  THAT ALLOWS THE REINNERVATION  OF THOSE MUSCLES  FOR WHICH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NERVE SUTURE OR GRAFTS  ARE IMPOSSIBLE TO DO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T RIGHT  LIGTH MICROSCOPY OF AN EXPERIMENTAL DIRECT NEUROTISATION::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ERE THE ,MOTOR END-PLATES WITNESS THE REINNERVATION THE MUSCOLAR FIBRES ARE TROPHI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2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EREAS  THOSE NOT YET REINNERVATED ARE DISTROPHI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72" name="" descr=""/>
          <p:cNvPicPr/>
          <p:nvPr/>
        </p:nvPicPr>
        <p:blipFill>
          <a:blip r:embed="rId1"/>
          <a:stretch/>
        </p:blipFill>
        <p:spPr>
          <a:xfrm>
            <a:off x="395280" y="3860640"/>
            <a:ext cx="2521080" cy="2737080"/>
          </a:xfrm>
          <a:prstGeom prst="rect">
            <a:avLst/>
          </a:prstGeom>
          <a:ln w="76320">
            <a:solidFill>
              <a:srgbClr val="ff0000"/>
            </a:solidFill>
            <a:miter/>
          </a:ln>
        </p:spPr>
      </p:pic>
      <p:pic>
        <p:nvPicPr>
          <p:cNvPr id="273" name="" descr=""/>
          <p:cNvPicPr/>
          <p:nvPr/>
        </p:nvPicPr>
        <p:blipFill>
          <a:blip r:embed="rId2"/>
          <a:stretch/>
        </p:blipFill>
        <p:spPr>
          <a:xfrm>
            <a:off x="5940360" y="3933720"/>
            <a:ext cx="2806920" cy="2664000"/>
          </a:xfrm>
          <a:prstGeom prst="rect">
            <a:avLst/>
          </a:prstGeom>
          <a:ln w="76320">
            <a:solidFill>
              <a:srgbClr val="ff0000"/>
            </a:solidFill>
            <a:miter/>
          </a:ln>
        </p:spPr>
      </p:pic>
      <p:pic>
        <p:nvPicPr>
          <p:cNvPr id="274" name="" descr=""/>
          <p:cNvPicPr/>
          <p:nvPr/>
        </p:nvPicPr>
        <p:blipFill>
          <a:blip r:embed="rId3">
            <a:lum contrast="12000"/>
          </a:blip>
          <a:stretch/>
        </p:blipFill>
        <p:spPr>
          <a:xfrm>
            <a:off x="3419640" y="3933720"/>
            <a:ext cx="1798560" cy="2637000"/>
          </a:xfrm>
          <a:prstGeom prst="rect">
            <a:avLst/>
          </a:prstGeom>
          <a:ln w="76320">
            <a:solidFill>
              <a:srgbClr val="ff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5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 u="sng">
                          <a:solidFill>
                            <a:srgbClr val="ffff00"/>
                          </a:solidFill>
                          <a:uFillTx/>
                          <a:latin typeface="Arial"/>
                        </a:rPr>
                        <a:t>RETURN TO COMPLETE TROPHICITY OF THE MUSCULAR FIBRES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 u="sng">
                          <a:solidFill>
                            <a:srgbClr val="ffff00"/>
                          </a:solidFill>
                          <a:uFillTx/>
                          <a:latin typeface="Arial"/>
                        </a:rPr>
                        <a:t>AFTER  MATURATION OF THE MOTOR END-PLAT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76" name="" descr=""/>
          <p:cNvPicPr/>
          <p:nvPr/>
        </p:nvPicPr>
        <p:blipFill>
          <a:blip r:embed="rId1"/>
          <a:stretch/>
        </p:blipFill>
        <p:spPr>
          <a:xfrm>
            <a:off x="1619280" y="476280"/>
            <a:ext cx="5977080" cy="4608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7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EXEMPLE OF THE POSSIBILITIES OF DIRECT MUSCOLAR NEUROTISAT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IS PATIENT  ARRIVED TO ME ONE YEAR AFTER   AN INFECTED  WOUND AT ELBOW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ITH  SEPTIC ARTHRITIS  AND LOSS OF THE CUTANEOUS COVERING AND  OF THE PROXIMAL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2/3  OF THE EXTENSOR MUSCLES OF WRIST AND HAN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FTER RECLAMATION OF THE SEPTIC LESION AND COVERAGE  BY MEANS OF A   FREE PARASCAPULAR FLAP, DIRECT NEUROTISATION OF THE RESIDUAL  EXTENSOR MUSCLES OF WRIST AND HAND  WAS DONE ( DISTAL 1/3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Y MEANS OF A  TWO SEGMENTS OF SURAL NERVE GRAFT,  23 CM. LONG,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UTURED TO THE PROXIMAL STUMP OF THE RADIAL NERV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RESULT AT 7 MONTHS.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78" name="" descr=""/>
          <p:cNvPicPr/>
          <p:nvPr/>
        </p:nvPicPr>
        <p:blipFill>
          <a:blip r:embed="rId1">
            <a:lum contrast="24000"/>
          </a:blip>
          <a:stretch/>
        </p:blipFill>
        <p:spPr>
          <a:xfrm>
            <a:off x="468360" y="549360"/>
            <a:ext cx="4103640" cy="3095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pic>
        <p:nvPicPr>
          <p:cNvPr id="279" name="" descr=""/>
          <p:cNvPicPr/>
          <p:nvPr/>
        </p:nvPicPr>
        <p:blipFill>
          <a:blip r:embed="rId2">
            <a:lum contrast="18000"/>
          </a:blip>
          <a:stretch/>
        </p:blipFill>
        <p:spPr>
          <a:xfrm>
            <a:off x="4788000" y="549360"/>
            <a:ext cx="4032000" cy="3095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80" name=""/>
          <p:cNvSpPr/>
          <p:nvPr/>
        </p:nvSpPr>
        <p:spPr>
          <a:xfrm>
            <a:off x="7740720" y="4653000"/>
            <a:ext cx="976320" cy="144360"/>
          </a:xfrm>
          <a:prstGeom prst="rightArrow">
            <a:avLst>
              <a:gd name="adj1" fmla="val 50000"/>
              <a:gd name="adj2" fmla="val 169077"/>
            </a:avLst>
          </a:prstGeom>
          <a:solidFill>
            <a:srgbClr val="00cc99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1" name=""/>
          <p:cNvSpPr/>
          <p:nvPr/>
        </p:nvSpPr>
        <p:spPr>
          <a:xfrm rot="15908400">
            <a:off x="5019480" y="3196800"/>
            <a:ext cx="976320" cy="287640"/>
          </a:xfrm>
          <a:prstGeom prst="rightArrow">
            <a:avLst>
              <a:gd name="adj1" fmla="val 50000"/>
              <a:gd name="adj2" fmla="val 84856"/>
            </a:avLst>
          </a:prstGeom>
          <a:solidFill>
            <a:srgbClr val="ff00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2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OTHER CONCEPT MUST BE CLEAR 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A NERVE GRAFT IS NOT ANYMORE A NERVE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T IS ONLY A BIOLOGICAL TUBE   (EPINEURAL)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CONTAINING HUNDREDS OF ENDONEURAL TUBE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800" spc="-1" strike="noStrike">
                          <a:solidFill>
                            <a:srgbClr val="ff3300"/>
                          </a:solidFill>
                          <a:latin typeface="Arial"/>
                        </a:rPr>
                        <a:t>WITHOUT AXONS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( WHICH UNDERGO   LYSIS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UT CONTAINING PROLIFERATED SCHWANN CELL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CCORDING TO THE CLASSICAL WALLERIAN DEGENERATION PARADIGMA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83" name="" descr=""/>
          <p:cNvPicPr/>
          <p:nvPr/>
        </p:nvPicPr>
        <p:blipFill>
          <a:blip r:embed="rId1"/>
          <a:stretch/>
        </p:blipFill>
        <p:spPr>
          <a:xfrm>
            <a:off x="1979640" y="3213000"/>
            <a:ext cx="5184720" cy="30956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84" name=""/>
          <p:cNvSpPr/>
          <p:nvPr/>
        </p:nvSpPr>
        <p:spPr>
          <a:xfrm>
            <a:off x="2103480" y="5727600"/>
            <a:ext cx="491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NERVO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5" name=""/>
          <p:cNvSpPr/>
          <p:nvPr/>
        </p:nvSpPr>
        <p:spPr>
          <a:xfrm>
            <a:off x="5724360" y="5661000"/>
            <a:ext cx="1511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INNESTO  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6" name=""/>
          <p:cNvGraphicFramePr/>
          <p:nvPr/>
        </p:nvGraphicFramePr>
        <p:xfrm>
          <a:off x="755640" y="1052640"/>
          <a:ext cx="7777080" cy="4681440"/>
        </p:xfrm>
        <a:graphic>
          <a:graphicData uri="http://schemas.openxmlformats.org/drawingml/2006/table">
            <a:tbl>
              <a:tblPr/>
              <a:tblGrid>
                <a:gridCol w="7777080"/>
              </a:tblGrid>
              <a:tr h="46814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2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 </a:t>
                      </a:r>
                      <a:r>
                        <a:rPr b="0" lang="en-US" sz="1600" spc="-1" strike="noStrike">
                          <a:solidFill>
                            <a:srgbClr val="ff00ff"/>
                          </a:solidFill>
                          <a:latin typeface="Arial"/>
                        </a:rPr>
                        <a:t>ALL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NERVE REPAIR ( SUTURES OR GRAFTS 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PERFECT JUXTAPOSITIONS OCCUR                                                                           (VERY IMPERFECT OR LESS IMPERFECT )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ITH CHANGE OF FUNCTION BECAUSE AXONS DESTINED TO A MUSCL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R TO A CUTANEOUS ZONE ARE CONNECTED TO DISTAL AXONS DESTINED TO DIFFERENT  MUSCLES  OR CUTANEOUS  ZONE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R  EVEN THE FUNCTION CHANGES BECAUSE OF THE TRANSFER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F A NEUROMUSCOLAR UNIT OR OF A SENSORY NERVE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FROM ONE TO ANOTHER ZONE OF THE SAME LIMB OR EVEN OF A DIFFERENT LIMB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( CONTRALATERAL OR CAUDAL 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7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RESULT OF THESE OPERATIONS  WILL BE MORE OR LESS GOO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DEPENDING ON THE PLASTIC CAPACITY OF THE BRA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OSE CORTICAL AREAS HAVE TO LEARN NEW FUNCTION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OR WHOSE NEURONS SCATTERED IN DIFFERENT AREAS  OF THE CORTEX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MUST  GET ORGANIZED  TO ACTIVATE TOGETHER ( EVEN IF REMOTE  ONE FROM THE OTHER )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WHILE OTHER NEURONS SCATTERED IN THE SAME AREAS ARE NOT ACTIVATE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F THEIR FUNCTION IS NOT REQUIRED  BY VOLITION                             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ELECTIVE </a:t>
                      </a:r>
                      <a:r>
                        <a:rPr b="1" lang="en-US" sz="24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PLASTICITY BY SINGLE NEURONS                 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88" name="" descr=""/>
          <p:cNvPicPr/>
          <p:nvPr/>
        </p:nvPicPr>
        <p:blipFill>
          <a:blip r:embed="rId1">
            <a:lum contrast="18000"/>
          </a:blip>
          <a:stretch/>
        </p:blipFill>
        <p:spPr>
          <a:xfrm>
            <a:off x="1187280" y="2997360"/>
            <a:ext cx="7309080" cy="3240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89" name=""/>
          <p:cNvGraphicFramePr/>
          <p:nvPr/>
        </p:nvGraphicFramePr>
        <p:xfrm>
          <a:off x="152280" y="404640"/>
          <a:ext cx="8839440" cy="557244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55724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0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11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4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pic>
        <p:nvPicPr>
          <p:cNvPr id="290" name="" descr=""/>
          <p:cNvPicPr/>
          <p:nvPr/>
        </p:nvPicPr>
        <p:blipFill>
          <a:blip r:embed="rId1"/>
          <a:stretch/>
        </p:blipFill>
        <p:spPr>
          <a:xfrm>
            <a:off x="684360" y="1557360"/>
            <a:ext cx="7704000" cy="35020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91" name=""/>
          <p:cNvSpPr/>
          <p:nvPr/>
        </p:nvSpPr>
        <p:spPr>
          <a:xfrm>
            <a:off x="867600" y="5321160"/>
            <a:ext cx="7112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ffff00"/>
                </a:solidFill>
                <a:latin typeface="Arial"/>
              </a:rPr>
              <a:t>BRAIN AREAS OF NERVES</a:t>
            </a:r>
            <a:r>
              <a:rPr b="0" lang="en-US" sz="2400" spc="-1" strike="noStrike">
                <a:solidFill>
                  <a:srgbClr val="ffff00"/>
                </a:solidFill>
                <a:latin typeface="Times New Roman"/>
              </a:rPr>
              <a:t>            </a:t>
            </a:r>
            <a:r>
              <a:rPr b="0" lang="en-US" sz="1400" spc="-1" strike="noStrike">
                <a:solidFill>
                  <a:srgbClr val="ffff00"/>
                </a:solidFill>
                <a:latin typeface="Arial"/>
              </a:rPr>
              <a:t>                      BRAIN AREAS FOR MUSCLES 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2" name="" descr=""/>
          <p:cNvPicPr/>
          <p:nvPr/>
        </p:nvPicPr>
        <p:blipFill>
          <a:blip r:embed="rId1"/>
          <a:stretch/>
        </p:blipFill>
        <p:spPr>
          <a:xfrm>
            <a:off x="2124000" y="115920"/>
            <a:ext cx="5081760" cy="655308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  <p:sp>
        <p:nvSpPr>
          <p:cNvPr id="293" name=""/>
          <p:cNvSpPr/>
          <p:nvPr/>
        </p:nvSpPr>
        <p:spPr>
          <a:xfrm>
            <a:off x="3780000" y="4221000"/>
            <a:ext cx="144360" cy="144720"/>
          </a:xfrm>
          <a:custGeom>
            <a:avLst/>
            <a:gdLst>
              <a:gd name="textAreaLeft" fmla="*/ 32760 w 144360"/>
              <a:gd name="textAreaRight" fmla="*/ 111600 w 144360"/>
              <a:gd name="textAreaTop" fmla="*/ 32760 h 144720"/>
              <a:gd name="textAreaBottom" fmla="*/ 111960 h 14472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400" bIns="32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4" name=""/>
          <p:cNvSpPr/>
          <p:nvPr/>
        </p:nvSpPr>
        <p:spPr>
          <a:xfrm>
            <a:off x="3635280" y="4365720"/>
            <a:ext cx="144720" cy="144360"/>
          </a:xfrm>
          <a:custGeom>
            <a:avLst/>
            <a:gdLst>
              <a:gd name="textAreaLeft" fmla="*/ 32760 w 144720"/>
              <a:gd name="textAreaRight" fmla="*/ 111960 w 144720"/>
              <a:gd name="textAreaTop" fmla="*/ 32760 h 144360"/>
              <a:gd name="textAreaBottom" fmla="*/ 111600 h 14436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5" name=""/>
          <p:cNvSpPr/>
          <p:nvPr/>
        </p:nvSpPr>
        <p:spPr>
          <a:xfrm>
            <a:off x="3708360" y="4437000"/>
            <a:ext cx="144360" cy="144360"/>
          </a:xfrm>
          <a:custGeom>
            <a:avLst/>
            <a:gdLst>
              <a:gd name="textAreaLeft" fmla="*/ 32760 w 144360"/>
              <a:gd name="textAreaRight" fmla="*/ 111600 w 144360"/>
              <a:gd name="textAreaTop" fmla="*/ 32760 h 144360"/>
              <a:gd name="textAreaBottom" fmla="*/ 111600 h 14436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6" name=""/>
          <p:cNvSpPr/>
          <p:nvPr/>
        </p:nvSpPr>
        <p:spPr>
          <a:xfrm>
            <a:off x="3851280" y="4437000"/>
            <a:ext cx="144360" cy="144360"/>
          </a:xfrm>
          <a:custGeom>
            <a:avLst/>
            <a:gdLst>
              <a:gd name="textAreaLeft" fmla="*/ 32760 w 144360"/>
              <a:gd name="textAreaRight" fmla="*/ 111600 w 144360"/>
              <a:gd name="textAreaTop" fmla="*/ 32760 h 144360"/>
              <a:gd name="textAreaBottom" fmla="*/ 111600 h 14436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97" name=""/>
          <p:cNvSpPr/>
          <p:nvPr/>
        </p:nvSpPr>
        <p:spPr>
          <a:xfrm>
            <a:off x="3995640" y="4365720"/>
            <a:ext cx="144720" cy="144360"/>
          </a:xfrm>
          <a:custGeom>
            <a:avLst/>
            <a:gdLst>
              <a:gd name="textAreaLeft" fmla="*/ 32760 w 144720"/>
              <a:gd name="textAreaRight" fmla="*/ 111960 w 144720"/>
              <a:gd name="textAreaTop" fmla="*/ 32760 h 144360"/>
              <a:gd name="textAreaBottom" fmla="*/ 111600 h 14436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ff66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4.72222E-006 -4.07407E-006 C -0.00174 0.00069 -0.00469 0.00347 -0.00469 0.00347 C -0.00608 0.00625 -0.00955 0.00995 -0.01198 0.01111 C -0.01337 0.01389 -0.0158 0.01597 -0.01823 0.01667 C -0.02066 0.01875 -0.02327 0.02106 -0.02605 0.02222 C -0.0283 0.02454 -0.03056 0.02639 -0.03282 0.02847 C -0.03386 0.0294 -0.03594 0.03125 -0.03594 0.03125 C -0.0382 0.03588 -0.04584 0.04398 -0.04948 0.04653 C -0.05122 0.04977 -0.05296 0.05046 -0.05521 0.05278 C -0.05973 0.05764 -0.06407 0.06389 -0.06823 0.06944 C -0.06927 0.07083 -0.07118 0.07523 -0.07188 0.07639 C -0.07414 0.08032 -0.07709 0.08333 -0.07917 0.0875 C -0.0816 0.09213 -0.08351 0.09699 -0.08594 0.10139 C -0.08698 0.10579 -0.08855 0.11019 -0.09063 0.11389 C -0.09167 0.11829 -0.09514 0.12153 -0.09688 0.12569 C -0.09914 0.13102 -0.10122 0.13657 -0.10365 0.14167 C -0.10434 0.1456 -0.10556 0.14954 -0.1073 0.15278 C -0.10782 0.15556 -0.10886 0.15764 -0.10938 0.16042 C -0.11164 0.1706 -0.1132 0.18102 -0.11563 0.19097 C -0.11615 0.19514 -0.11667 0.19861 -0.11719 0.20278 C -0.11667 0.21204 -0.11702 0.22523 -0.11302 0.23333 C -0.11181 0.23981 -0.10921 0.24491 -0.10677 0.25069 C -0.10504 0.25463 -0.10452 0.25856 -0.10209 0.26181 C -0.10105 0.26574 -0.09497 0.27801 -0.09219 0.28056 C -0.0908 0.28333 -0.0816 0.29167 -0.07865 0.29306 C -0.07743 0.29352 -0.07587 0.2956 -0.075 0.29444 E">
                                      <p:cBhvr>
                                        <p:cTn id="6" dur="2000" fill="hold"/>
                                        <p:tgtEl>
                                          <p:spTgt spid="293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7" nodeType="withEffect" fill="hold" presetClass="path" presetID="0" repeatCount="indefinite">
                                  <p:stCondLst>
                                    <p:cond delay="500"/>
                                  </p:stCondLst>
                                  <p:childTnLst>
                                    <p:animMotion origin="layout" path="M 5.27778E-006 4.07407E-006 C -0.00294 0.00208 -0.00624 0.00277 -0.00937 0.00416 C -0.01267 0.00555 -0.01562 0.00902 -0.01874 0.01111 C -0.02447 0.01504 -0.02881 0.02222 -0.03333 0.02777 C -0.03541 0.03032 -0.03801 0.03217 -0.0401 0.03472 C -0.04687 0.04282 -0.04097 0.03541 -0.04426 0.04166 C -0.04548 0.04398 -0.04756 0.04537 -0.04895 0.04722 C -0.04982 0.05069 -0.0519 0.05301 -0.05312 0.05625 C -0.05364 0.05787 -0.05364 0.05949 -0.05416 0.06111 C -0.05538 0.06435 -0.05728 0.06736 -0.05885 0.07014 C -0.0618 0.07546 -0.06371 0.08148 -0.06666 0.0868 C -0.06857 0.09421 -0.06996 0.10162 -0.07187 0.10902 C -0.07274 0.1125 -0.07291 0.1162 -0.07447 0.11944 C -0.07499 0.12453 -0.07586 0.12916 -0.07708 0.13402 C -0.07812 0.14444 -0.07985 0.15671 -0.08228 0.16666 C -0.08263 0.17824 -0.08333 0.1868 -0.08385 0.19791 C -0.08333 0.20416 -0.08385 0.20833 -0.08437 0.21458 C -0.0835 0.21898 -0.08315 0.22338 -0.08228 0.22777 C -0.08194 0.22963 -0.08072 0.23102 -0.0802 0.23264 C -0.07864 0.23773 -0.0769 0.24189 -0.07447 0.24652 C -0.07378 0.24791 -0.07152 0.25277 -0.07031 0.25277 E">
                                      <p:cBhvr>
                                        <p:cTn id="8" dur="2000" fill="hold"/>
                                        <p:tgtEl>
                                          <p:spTgt spid="294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9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3.05556E-006 -3.7037E-006 C -0.00869 0.00162 -0.0158 0.01042 -0.02292 0.01667 C -0.02605 0.01945 -0.03021 0.02222 -0.03282 0.0257 C -0.03768 0.03218 -0.03351 0.02801 -0.03698 0.03125 C -0.04011 0.0375 -0.04462 0.04283 -0.04792 0.04931 C -0.04914 0.05185 -0.05261 0.05625 -0.05261 0.05625 C -0.05365 0.06065 -0.05625 0.06528 -0.05782 0.06945 C -0.05955 0.07408 -0.06094 0.07894 -0.06303 0.08333 C -0.06511 0.09259 -0.06667 0.10162 -0.06823 0.11111 C -0.06875 0.11412 -0.0698 0.11644 -0.07032 0.11945 C -0.07136 0.12593 -0.07223 0.1338 -0.07448 0.13958 C -0.07535 0.15208 -0.07639 0.16482 -0.07448 0.17708 C -0.07431 0.19236 -0.07466 0.20787 -0.07292 0.22292 C -0.07223 0.22847 -0.0691 0.23472 -0.06771 0.24028 C -0.06667 0.24421 -0.06632 0.25255 -0.06407 0.25556 E">
                                      <p:cBhvr>
                                        <p:cTn id="10" dur="3000" fill="hold"/>
                                        <p:tgtEl>
                                          <p:spTgt spid="295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11" nodeType="withEffect" fill="hold" presetClass="path" presetID="0" repeatCount="indefinite">
                                  <p:stCondLst>
                                    <p:cond delay="500"/>
                                  </p:stCondLst>
                                  <p:childTnLst>
                                    <p:animMotion origin="layout" path="M 3.88889E-006 -3.7037E-007 C -0.00399 0.00347 -0.00695 0.00903 -0.01094 0.0125 C -0.01337 0.01736 -0.01701 0.02453 -0.02135 0.02639 C -0.02257 0.0287 -0.02535 0.03333 -0.02708 0.03403 C -0.03108 0.03935 -0.03507 0.04653 -0.03958 0.05069 C -0.04063 0.05486 -0.0434 0.05949 -0.04531 0.06319 C -0.04948 0.07153 -0.05313 0.07986 -0.05729 0.08819 C -0.06076 0.09491 -0.06233 0.10324 -0.0651 0.11041 C -0.06719 0.12453 -0.07118 0.13889 -0.07396 0.15278 C -0.07448 0.15578 -0.0757 0.1581 -0.07604 0.16111 C -0.07691 0.16828 -0.0783 0.17546 -0.07917 0.18264 C -0.07986 0.18935 -0.08004 0.19629 -0.08125 0.20278 C -0.08142 0.20555 -0.08264 0.2125 -0.08177 0.21597 C -0.08142 0.22523 -0.08108 0.23287 -0.07969 0.24166 C -0.07865 0.24791 -0.07552 0.25602 -0.07552 0.2625 E">
                                      <p:cBhvr>
                                        <p:cTn id="12" dur="2000" fill="hold"/>
                                        <p:tgtEl>
                                          <p:spTgt spid="296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13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2.5E-006 5.18519E-006 C 0.00069 0.00278 0.00226 0.00371 0.00312 0.00626 C 0.00573 0.01297 0.00746 0.02107 0.00833 0.02848 C 0.00885 0.0419 0.0099 0.05487 0.01094 0.06806 C 0.01059 0.08149 0.01059 0.09538 0.00729 0.10834 C 0.00608 0.12038 0.00382 0.13264 0.00156 0.14445 C 0.00087 0.14769 -0.0007 0.15093 -0.00156 0.15417 C -0.00191 0.15556 -0.0026 0.15834 -0.0026 0.15834 C -0.0033 0.16436 -0.00556 0.16899 -0.00729 0.17431 C -0.00938 0.18056 -0.01076 0.18727 -0.01458 0.19237 C -0.01563 0.19676 -0.01615 0.19723 -0.01823 0.2007 C -0.01892 0.20209 -0.01962 0.20348 -0.02031 0.20487 C -0.02066 0.20556 -0.02135 0.20695 -0.02135 0.20695 C -0.02274 0.21436 -0.0283 0.22176 -0.03229 0.22709 C -0.03976 0.23704 -0.04792 0.24538 -0.05677 0.25278 C -0.06215 0.25718 -0.06788 0.26181 -0.07344 0.26598 C -0.07344 0.26598 -0.08021 0.27223 -0.08021 0.26945 E">
                                      <p:cBhvr>
                                        <p:cTn id="14" dur="3000" fill="hold"/>
                                        <p:tgtEl>
                                          <p:spTgt spid="297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8" name=""/>
          <p:cNvGraphicFramePr/>
          <p:nvPr/>
        </p:nvGraphicFramePr>
        <p:xfrm>
          <a:off x="539640" y="620640"/>
          <a:ext cx="7993080" cy="5545080"/>
        </p:xfrm>
        <a:graphic>
          <a:graphicData uri="http://schemas.openxmlformats.org/drawingml/2006/table">
            <a:tbl>
              <a:tblPr/>
              <a:tblGrid>
                <a:gridCol w="7993080"/>
              </a:tblGrid>
              <a:tr h="5545080">
                <a:tc>
                  <a:txBody>
                    <a:bodyPr lIns="90000" rIns="90000" tIns="46800" bIns="46800" anchor="t">
                      <a:noAutofit/>
                    </a:bodyPr>
                    <a:p>
                      <a:pPr marL="533520" indent="-533520"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marL="533520" indent="-533520"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E NEURAL TUBE GENERATES 5 VESCICLES AND THE BRA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684360" y="33300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0" name="" descr=""/>
          <p:cNvPicPr/>
          <p:nvPr/>
        </p:nvPicPr>
        <p:blipFill>
          <a:blip r:embed="rId1"/>
          <a:stretch/>
        </p:blipFill>
        <p:spPr>
          <a:xfrm>
            <a:off x="2340000" y="1844640"/>
            <a:ext cx="4275000" cy="388800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8" name="" descr=""/>
          <p:cNvPicPr/>
          <p:nvPr/>
        </p:nvPicPr>
        <p:blipFill>
          <a:blip r:embed="rId1"/>
          <a:stretch/>
        </p:blipFill>
        <p:spPr>
          <a:xfrm>
            <a:off x="2154240" y="0"/>
            <a:ext cx="5081760" cy="6669000"/>
          </a:xfrm>
          <a:prstGeom prst="rect">
            <a:avLst/>
          </a:prstGeom>
          <a:ln w="0">
            <a:noFill/>
          </a:ln>
        </p:spPr>
      </p:pic>
      <p:sp>
        <p:nvSpPr>
          <p:cNvPr id="299" name=""/>
          <p:cNvSpPr/>
          <p:nvPr/>
        </p:nvSpPr>
        <p:spPr>
          <a:xfrm>
            <a:off x="3708360" y="4221000"/>
            <a:ext cx="144360" cy="144720"/>
          </a:xfrm>
          <a:custGeom>
            <a:avLst/>
            <a:gdLst>
              <a:gd name="textAreaLeft" fmla="*/ 32760 w 144360"/>
              <a:gd name="textAreaRight" fmla="*/ 111600 w 144360"/>
              <a:gd name="textAreaTop" fmla="*/ 32760 h 144720"/>
              <a:gd name="textAreaBottom" fmla="*/ 111960 h 14472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400" bIns="324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0" name=""/>
          <p:cNvSpPr/>
          <p:nvPr/>
        </p:nvSpPr>
        <p:spPr>
          <a:xfrm>
            <a:off x="3780000" y="4437000"/>
            <a:ext cx="144360" cy="144360"/>
          </a:xfrm>
          <a:custGeom>
            <a:avLst/>
            <a:gdLst>
              <a:gd name="textAreaLeft" fmla="*/ 32760 w 144360"/>
              <a:gd name="textAreaRight" fmla="*/ 111600 w 144360"/>
              <a:gd name="textAreaTop" fmla="*/ 32760 h 144360"/>
              <a:gd name="textAreaBottom" fmla="*/ 111600 h 14436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1" name=""/>
          <p:cNvSpPr/>
          <p:nvPr/>
        </p:nvSpPr>
        <p:spPr>
          <a:xfrm>
            <a:off x="3564000" y="4365720"/>
            <a:ext cx="144360" cy="144360"/>
          </a:xfrm>
          <a:custGeom>
            <a:avLst/>
            <a:gdLst>
              <a:gd name="textAreaLeft" fmla="*/ 32760 w 144360"/>
              <a:gd name="textAreaRight" fmla="*/ 111600 w 144360"/>
              <a:gd name="textAreaTop" fmla="*/ 32760 h 144360"/>
              <a:gd name="textAreaBottom" fmla="*/ 111600 h 14436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2" name=""/>
          <p:cNvSpPr/>
          <p:nvPr/>
        </p:nvSpPr>
        <p:spPr>
          <a:xfrm>
            <a:off x="3924360" y="4365720"/>
            <a:ext cx="144360" cy="144360"/>
          </a:xfrm>
          <a:custGeom>
            <a:avLst/>
            <a:gdLst>
              <a:gd name="textAreaLeft" fmla="*/ 32760 w 144360"/>
              <a:gd name="textAreaRight" fmla="*/ 111600 w 144360"/>
              <a:gd name="textAreaTop" fmla="*/ 32760 h 144360"/>
              <a:gd name="textAreaBottom" fmla="*/ 111600 h 14436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ff66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3" name=""/>
          <p:cNvSpPr/>
          <p:nvPr/>
        </p:nvSpPr>
        <p:spPr>
          <a:xfrm>
            <a:off x="3635280" y="4437000"/>
            <a:ext cx="144720" cy="144360"/>
          </a:xfrm>
          <a:custGeom>
            <a:avLst/>
            <a:gdLst>
              <a:gd name="textAreaLeft" fmla="*/ 32760 w 144720"/>
              <a:gd name="textAreaRight" fmla="*/ 111960 w 144720"/>
              <a:gd name="textAreaTop" fmla="*/ 32760 h 144360"/>
              <a:gd name="textAreaBottom" fmla="*/ 111600 h 144360"/>
            </a:gdLst>
            <a:ahLst/>
            <a:rect l="textAreaLeft" t="textAreaTop" r="textAreaRight" b="textAreaBottom"/>
            <a:pathLst>
              <a:path w="21600" h="21600">
                <a:moveTo>
                  <a:pt x="0" y="10800"/>
                </a:moveTo>
                <a:lnTo>
                  <a:pt x="2532" y="11523"/>
                </a:lnTo>
                <a:lnTo>
                  <a:pt x="198" y="12861"/>
                </a:lnTo>
                <a:lnTo>
                  <a:pt x="2822" y="13088"/>
                </a:lnTo>
                <a:lnTo>
                  <a:pt x="786" y="14846"/>
                </a:lnTo>
                <a:lnTo>
                  <a:pt x="3472" y="14697"/>
                </a:lnTo>
                <a:lnTo>
                  <a:pt x="1742" y="16682"/>
                </a:lnTo>
                <a:lnTo>
                  <a:pt x="4350" y="16023"/>
                </a:lnTo>
                <a:lnTo>
                  <a:pt x="3163" y="18437"/>
                </a:lnTo>
                <a:lnTo>
                  <a:pt x="5465" y="17158"/>
                </a:lnTo>
                <a:lnTo>
                  <a:pt x="4761" y="19754"/>
                </a:lnTo>
                <a:lnTo>
                  <a:pt x="6776" y="18059"/>
                </a:lnTo>
                <a:lnTo>
                  <a:pt x="6580" y="20741"/>
                </a:lnTo>
                <a:lnTo>
                  <a:pt x="8373" y="18737"/>
                </a:lnTo>
                <a:lnTo>
                  <a:pt x="8555" y="21364"/>
                </a:lnTo>
                <a:lnTo>
                  <a:pt x="9932" y="19055"/>
                </a:lnTo>
                <a:lnTo>
                  <a:pt x="10800" y="21600"/>
                </a:lnTo>
                <a:lnTo>
                  <a:pt x="11523" y="19068"/>
                </a:lnTo>
                <a:lnTo>
                  <a:pt x="12861" y="21402"/>
                </a:lnTo>
                <a:lnTo>
                  <a:pt x="13088" y="18778"/>
                </a:lnTo>
                <a:lnTo>
                  <a:pt x="14846" y="20814"/>
                </a:lnTo>
                <a:lnTo>
                  <a:pt x="14697" y="18128"/>
                </a:lnTo>
                <a:lnTo>
                  <a:pt x="16682" y="19858"/>
                </a:lnTo>
                <a:lnTo>
                  <a:pt x="16023" y="17250"/>
                </a:lnTo>
                <a:lnTo>
                  <a:pt x="18437" y="18437"/>
                </a:lnTo>
                <a:lnTo>
                  <a:pt x="17158" y="16135"/>
                </a:lnTo>
                <a:lnTo>
                  <a:pt x="19754" y="16839"/>
                </a:lnTo>
                <a:lnTo>
                  <a:pt x="18059" y="14824"/>
                </a:lnTo>
                <a:lnTo>
                  <a:pt x="20741" y="15020"/>
                </a:lnTo>
                <a:lnTo>
                  <a:pt x="18737" y="13227"/>
                </a:lnTo>
                <a:lnTo>
                  <a:pt x="21364" y="13045"/>
                </a:lnTo>
                <a:lnTo>
                  <a:pt x="19055" y="11668"/>
                </a:lnTo>
                <a:lnTo>
                  <a:pt x="21600" y="10800"/>
                </a:lnTo>
                <a:lnTo>
                  <a:pt x="19068" y="10077"/>
                </a:lnTo>
                <a:lnTo>
                  <a:pt x="21402" y="8739"/>
                </a:lnTo>
                <a:lnTo>
                  <a:pt x="18778" y="8512"/>
                </a:lnTo>
                <a:lnTo>
                  <a:pt x="20814" y="6754"/>
                </a:lnTo>
                <a:lnTo>
                  <a:pt x="18128" y="6903"/>
                </a:lnTo>
                <a:lnTo>
                  <a:pt x="19858" y="4918"/>
                </a:lnTo>
                <a:lnTo>
                  <a:pt x="17250" y="5577"/>
                </a:lnTo>
                <a:lnTo>
                  <a:pt x="18437" y="3163"/>
                </a:lnTo>
                <a:lnTo>
                  <a:pt x="16135" y="4442"/>
                </a:lnTo>
                <a:lnTo>
                  <a:pt x="16839" y="1846"/>
                </a:lnTo>
                <a:lnTo>
                  <a:pt x="14824" y="3541"/>
                </a:lnTo>
                <a:lnTo>
                  <a:pt x="15020" y="859"/>
                </a:lnTo>
                <a:lnTo>
                  <a:pt x="13227" y="2863"/>
                </a:lnTo>
                <a:lnTo>
                  <a:pt x="13045" y="236"/>
                </a:lnTo>
                <a:lnTo>
                  <a:pt x="11668" y="2545"/>
                </a:lnTo>
                <a:lnTo>
                  <a:pt x="10800" y="0"/>
                </a:lnTo>
                <a:lnTo>
                  <a:pt x="10077" y="2532"/>
                </a:lnTo>
                <a:lnTo>
                  <a:pt x="8739" y="198"/>
                </a:lnTo>
                <a:lnTo>
                  <a:pt x="8512" y="2822"/>
                </a:lnTo>
                <a:lnTo>
                  <a:pt x="6754" y="786"/>
                </a:lnTo>
                <a:lnTo>
                  <a:pt x="6903" y="3472"/>
                </a:lnTo>
                <a:lnTo>
                  <a:pt x="4918" y="1742"/>
                </a:lnTo>
                <a:lnTo>
                  <a:pt x="5577" y="4350"/>
                </a:lnTo>
                <a:lnTo>
                  <a:pt x="3163" y="3163"/>
                </a:lnTo>
                <a:lnTo>
                  <a:pt x="4442" y="5465"/>
                </a:lnTo>
                <a:lnTo>
                  <a:pt x="1846" y="4761"/>
                </a:lnTo>
                <a:lnTo>
                  <a:pt x="3541" y="6776"/>
                </a:lnTo>
                <a:lnTo>
                  <a:pt x="859" y="6580"/>
                </a:lnTo>
                <a:lnTo>
                  <a:pt x="2863" y="8373"/>
                </a:lnTo>
                <a:lnTo>
                  <a:pt x="236" y="8555"/>
                </a:lnTo>
                <a:lnTo>
                  <a:pt x="2545" y="9932"/>
                </a:lnTo>
                <a:lnTo>
                  <a:pt x="0" y="10800"/>
                </a:lnTo>
                <a:close/>
              </a:path>
            </a:pathLst>
          </a:cu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2040" bIns="320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5" dur="indefinite" restart="never" nodeType="tmRoot">
          <p:childTnLst>
            <p:seq>
              <p:cTn id="16" dur="indefinite" nodeType="mainSeq"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38889E-006 -7.40741E-006 C 0.00885 0.00185 0.01562 0.01087 0.02396 0.01458 C 0.02552 0.01666 0.02691 0.01712 0.02864 0.01874 C 0.03107 0.0236 0.03541 0.0287 0.03906 0.03194 C 0.04166 0.03703 0.04479 0.04143 0.04739 0.04652 C 0.05277 0.0574 0.05659 0.07291 0.05781 0.0861 C 0.05764 0.10208 0.05764 0.11805 0.05729 0.13402 C 0.05711 0.13865 0.05555 0.14351 0.05468 0.14791 C 0.05243 0.15925 0.04965 0.17013 0.04687 0.18124 C 0.04461 0.19004 0.04305 0.20231 0.03698 0.20763 C 0.03524 0.2111 0.03402 0.21458 0.03229 0.21805 C 0.03159 0.21944 0.03073 0.22222 0.03073 0.22222 E">
                                      <p:cBhvr>
                                        <p:cTn id="20" dur="2000" fill="hold"/>
                                        <p:tgtEl>
                                          <p:spTgt spid="299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1" nodeType="withEffect" fill="hold" presetClass="path" presetID="0" repeatCount="indefinite">
                                  <p:stCondLst>
                                    <p:cond delay="500"/>
                                  </p:stCondLst>
                                  <p:childTnLst>
                                    <p:animMotion origin="layout" path="M 8.33333E-007 -0.00046 C 0.00382 -0.00208 0.00694 0.00324 0.00937 0.00648 C 0.01805 0.01806 0.02135 0.03565 0.0224 0.05162 C 0.02274 0.05787 0.02309 0.06412 0.02396 0.07037 C 0.02378 0.08588 0.02708 0.10208 0.02344 0.1169 C 0.0217 0.13241 0.01875 0.14769 0.01562 0.16273 C 0.01476 0.1669 0.01424 0.17315 0.0125 0.17662 C 0.01059 0.18032 0.00937 0.18449 0.00781 0.18843 E">
                                      <p:cBhvr>
                                        <p:cTn id="22" dur="2000" fill="hold"/>
                                        <p:tgtEl>
                                          <p:spTgt spid="302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3" nodeType="withEffect" fill="hold" presetClass="path" presetID="0" repeatCount="indefinite">
                                  <p:stCondLst>
                                    <p:cond delay="500"/>
                                  </p:stCondLst>
                                  <p:childTnLst>
                                    <p:animMotion origin="layout" path="M 5.55556E-007 -7.03704E-006 C -0.00556 0.01087 -0.01076 0.02361 -0.0125 0.0368 C -0.01319 0.04143 -0.01389 0.04606 -0.01458 0.05069 C -0.01493 0.053 -0.01562 0.05763 -0.01562 0.05763 C -0.01597 0.06967 -0.01528 0.07569 -0.01719 0.08541 C -0.01701 0.09236 -0.01858 0.13726 -0.01562 0.15069 C -0.01528 0.15231 -0.01389 0.15324 -0.01354 0.15486 C -0.01337 0.15555 -0.01319 0.15624 -0.01302 0.15694 C -0.01146 0.16435 -0.01059 0.17268 -0.00885 0.17986 C -0.00868 0.18078 -0.00677 0.18611 -0.00729 0.1868 E">
                                      <p:cBhvr>
                                        <p:cTn id="24" dur="3000" fill="hold"/>
                                        <p:tgtEl>
                                          <p:spTgt spid="300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5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2.22222E-006 7.40741E-007 C -0.00243 0.00208 -0.00347 0.00416 -0.00572 0.00625 C -0.00954 0.01365 -0.0125 0.02176 -0.01406 0.03055 C -0.0151 0.03611 -0.01493 0.03541 -0.01614 0.04027 C -0.01649 0.04166 -0.01718 0.04444 -0.01718 0.04444 C -0.0177 0.05115 -0.01909 0.05717 -0.01979 0.06389 C -0.02013 0.07639 -0.02031 0.08889 -0.01927 0.10139 C -0.01875 0.10648 -0.01632 0.11157 -0.01562 0.11666 C -0.01458 0.12314 -0.01267 0.13958 -0.01041 0.14514 C -0.00833 0.15023 -0.00382 0.15879 -0.0026 0.16389 C -0.00138 0.16875 -0.00017 0.17338 0.00157 0.17777 E">
                                      <p:cBhvr>
                                        <p:cTn id="26" dur="2000" fill="hold"/>
                                        <p:tgtEl>
                                          <p:spTgt spid="303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  <p:par>
                                <p:cTn id="27" nodeType="withEffect" fill="hold" presetClass="path" presetID="0" repeatCount="indefinite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3.05556E-006 -2.59259E-006 C -0.00156 0.00602 -0.00503 0.00973 -0.00781 0.01459 C -0.0125 0.02269 -0.01701 0.03658 -0.01875 0.04653 C -0.01996 0.05371 -0.02153 0.06088 -0.02239 0.06806 C -0.02274 0.07084 -0.02309 0.07361 -0.02343 0.07639 C -0.02361 0.07778 -0.02396 0.08056 -0.02396 0.08056 C -0.02378 0.09422 -0.02378 0.10787 -0.02343 0.12153 C -0.02326 0.12547 -0.02187 0.13125 -0.02135 0.13473 C -0.01979 0.14514 -0.01857 0.15556 -0.01666 0.16598 C -0.01528 0.17361 -0.01337 0.18079 -0.01146 0.1882 C -0.01111 0.18982 -0.00972 0.19074 -0.00937 0.19236 C -0.00885 0.19445 -0.00816 0.19676 -0.00729 0.19861 C -0.00659 0.2 -0.00555 0.20116 -0.00521 0.20278 C -0.00503 0.20348 -0.00468 0.20486 -0.00468 0.20486 E">
                                      <p:cBhvr>
                                        <p:cTn id="28" dur="3000" fill="hold"/>
                                        <p:tgtEl>
                                          <p:spTgt spid="301"/>
                                        </p:tgtEl>
                                      </p:cBhvr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4" name=""/>
          <p:cNvGraphicFramePr/>
          <p:nvPr/>
        </p:nvGraphicFramePr>
        <p:xfrm>
          <a:off x="1042920" y="1341360"/>
          <a:ext cx="7488360" cy="3743280"/>
        </p:xfrm>
        <a:graphic>
          <a:graphicData uri="http://schemas.openxmlformats.org/drawingml/2006/table">
            <a:tbl>
              <a:tblPr/>
              <a:tblGrid>
                <a:gridCol w="7488360"/>
              </a:tblGrid>
              <a:tr h="37432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IS PLASTICITY ( BETTER IN YOUNG AGE 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S BETTER IF IT IS HELPED BY 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INTELLIGENT,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CONTINUOUS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PERSEVERANT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SENSORY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AND MOTOR 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6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REEDUCATIO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5" name=""/>
          <p:cNvGraphicFramePr/>
          <p:nvPr/>
        </p:nvGraphicFramePr>
        <p:xfrm>
          <a:off x="152280" y="152280"/>
          <a:ext cx="8839440" cy="664236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8648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BEST REGARDS FROM THE PIONEERS OF MICROSURGERY (ELECTED BY   W.S.R.M. )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306" name="" descr=""/>
          <p:cNvPicPr/>
          <p:nvPr/>
        </p:nvPicPr>
        <p:blipFill>
          <a:blip r:embed="rId1"/>
          <a:stretch/>
        </p:blipFill>
        <p:spPr>
          <a:xfrm>
            <a:off x="1189080" y="1484280"/>
            <a:ext cx="6765840" cy="4969080"/>
          </a:xfrm>
          <a:prstGeom prst="rect">
            <a:avLst/>
          </a:prstGeom>
          <a:ln w="0">
            <a:noFill/>
          </a:ln>
        </p:spPr>
      </p:pic>
      <p:sp>
        <p:nvSpPr>
          <p:cNvPr id="307" name=""/>
          <p:cNvSpPr/>
          <p:nvPr/>
        </p:nvSpPr>
        <p:spPr>
          <a:xfrm>
            <a:off x="732240" y="6159600"/>
            <a:ext cx="6974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ffff"/>
                </a:solidFill>
                <a:latin typeface="Arial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             </a:t>
            </a:r>
            <a:r>
              <a:rPr b="0" lang="en-US" sz="2000" spc="-1" strike="noStrike">
                <a:solidFill>
                  <a:srgbClr val="ffff00"/>
                </a:solidFill>
                <a:latin typeface="Arial"/>
              </a:rPr>
              <a:t>MAYER   BRUNELLI  MILLESI    OWEN      TAMAI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8" name=""/>
          <p:cNvGraphicFramePr/>
          <p:nvPr/>
        </p:nvGraphicFramePr>
        <p:xfrm>
          <a:off x="152280" y="152280"/>
          <a:ext cx="8839440" cy="647712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7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24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ANK  YOU FOR YOUR ATTENTION</a:t>
                      </a: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2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</a:t>
                      </a: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7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                                </a:t>
                      </a:r>
                      <a:r>
                        <a:rPr b="0" lang="en-US" sz="1800" spc="-1" strike="noStrike">
                          <a:solidFill>
                            <a:srgbClr val="ffff00"/>
                          </a:solidFill>
                          <a:latin typeface="Arial"/>
                        </a:rPr>
                        <a:t>THE VENETIAN CASTLE OF BRESCIA</a:t>
                      </a: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309" name="" descr=""/>
          <p:cNvPicPr/>
          <p:nvPr/>
        </p:nvPicPr>
        <p:blipFill>
          <a:blip r:embed="rId1"/>
          <a:stretch/>
        </p:blipFill>
        <p:spPr>
          <a:xfrm>
            <a:off x="1116000" y="1197000"/>
            <a:ext cx="6769080" cy="480204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1" name=""/>
          <p:cNvGraphicFramePr/>
          <p:nvPr/>
        </p:nvGraphicFramePr>
        <p:xfrm>
          <a:off x="152280" y="189000"/>
          <a:ext cx="8839440" cy="6476760"/>
        </p:xfrm>
        <a:graphic>
          <a:graphicData uri="http://schemas.openxmlformats.org/drawingml/2006/table">
            <a:tbl>
              <a:tblPr/>
              <a:tblGrid>
                <a:gridCol w="8839440"/>
              </a:tblGrid>
              <a:tr h="6476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NERVOUS SYSTEM IS MADE OF  </a:t>
                      </a:r>
                      <a:r>
                        <a:rPr b="0" lang="en-US" sz="14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NEURON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(ABOUT  100 BILIONS ONLY IN THE BRAIN CORTEX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ND  PROBABLY  100 BILIONS MORE IN THE NUCLEI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ND OF </a:t>
                      </a:r>
                      <a:r>
                        <a:rPr b="0" lang="en-US" sz="14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GLIAL CELLS</a:t>
                      </a: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(10.000 TO 50.000 BILIONS IN THE HUMAN BRAIN )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DURING THE EMBRYONIC  DEVELOPMENT  NEURONS  HAVE TO FIND THEIR WA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INSIDE THE BRAIN AND SPINAL CORD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ROUG  LONG DISTANCES .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FIRST FOLLOWING THE ROAD  TRACED    BY THE MIGRATION  OF THE GLIAL CELL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OWARDS THE CORTEX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99"/>
                    </a:solidFill>
                  </a:tcPr>
                </a:tc>
              </a:tr>
            </a:tbl>
          </a:graphicData>
        </a:graphic>
      </p:graphicFrame>
      <p:sp>
        <p:nvSpPr>
          <p:cNvPr id="72" name=""/>
          <p:cNvSpPr/>
          <p:nvPr/>
        </p:nvSpPr>
        <p:spPr>
          <a:xfrm>
            <a:off x="1835280" y="4292640"/>
            <a:ext cx="5400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1692360" y="4869000"/>
            <a:ext cx="55450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3132000" y="1341360"/>
            <a:ext cx="2592360" cy="2808360"/>
          </a:xfrm>
          <a:prstGeom prst="rect">
            <a:avLst/>
          </a:prstGeom>
          <a:ln w="76320">
            <a:solidFill>
              <a:srgbClr val="00ff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000066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5" name=""/>
          <p:cNvGraphicFramePr/>
          <p:nvPr/>
        </p:nvGraphicFramePr>
        <p:xfrm>
          <a:off x="755640" y="549360"/>
          <a:ext cx="7704000" cy="5575320"/>
        </p:xfrm>
        <a:graphic>
          <a:graphicData uri="http://schemas.openxmlformats.org/drawingml/2006/table">
            <a:tbl>
              <a:tblPr/>
              <a:tblGrid>
                <a:gridCol w="7704000"/>
              </a:tblGrid>
              <a:tr h="55753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4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AFTERWARDS THE AXONS GENERATED BY THE NEURON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FOLLOW THE STIMULI OF  </a:t>
                      </a:r>
                      <a:r>
                        <a:rPr b="1" lang="it-IT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GUIDE MOLECULES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CELL SDURFACE MOLECULES  ( C.A.M.)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20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OR DIFFUSIBLE MOLECULES. 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ESE MOLECULES </a:t>
                      </a:r>
                      <a:r>
                        <a:rPr b="1" lang="it-IT" sz="2400" spc="-1" strike="noStrike">
                          <a:solidFill>
                            <a:srgbClr val="ff0066"/>
                          </a:solidFill>
                          <a:latin typeface="Arial"/>
                        </a:rPr>
                        <a:t>ATTRACTING OR  REPELLING</a:t>
                      </a:r>
                      <a:r>
                        <a:rPr b="0" lang="it-IT" sz="2000" spc="-1" strike="noStrike">
                          <a:solidFill>
                            <a:srgbClr val="ff0066"/>
                          </a:solidFill>
                          <a:latin typeface="Arial"/>
                        </a:rPr>
                        <a:t>,</a:t>
                      </a: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0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4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i="1" lang="it-IT" sz="1600" spc="-1" strike="noStrike" u="sng">
                          <a:solidFill>
                            <a:srgbClr val="ffff66"/>
                          </a:solidFill>
                          <a:uFillTx/>
                          <a:latin typeface="Arial"/>
                        </a:rPr>
                        <a:t>IN THE PERIPHERAL NERVOUS SYSTEM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DERIVE FROM THE DISTAL NERVE STUMP OR FROM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THE MOTOR END PLATES OF THE  MUSCL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400" spc="-1" strike="noStrike">
                          <a:solidFill>
                            <a:srgbClr val="ffff66"/>
                          </a:solidFill>
                          <a:latin typeface="Arial"/>
                        </a:rPr>
                        <a:t>WHICH ALSO SECRETE A VARIETY OF GROWTH FACTOR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anchor="t" marL="90000" marR="90000">
                    <a:lnL w="28080">
                      <a:solidFill>
                        <a:srgbClr val="ffff00"/>
                      </a:solidFill>
                    </a:lnL>
                    <a:lnR w="28080">
                      <a:solidFill>
                        <a:srgbClr val="ffff00"/>
                      </a:solidFill>
                    </a:lnR>
                    <a:lnT w="28080">
                      <a:solidFill>
                        <a:srgbClr val="ffff00"/>
                      </a:solidFill>
                    </a:lnT>
                    <a:lnB w="28080">
                      <a:solidFill>
                        <a:srgbClr val="ffff00"/>
                      </a:solidFill>
                    </a:lnB>
                    <a:solidFill>
                      <a:srgbClr val="0000ff"/>
                    </a:solidFill>
                  </a:tcPr>
                </a:tc>
              </a:tr>
            </a:tbl>
          </a:graphicData>
        </a:graphic>
      </p:graphicFrame>
      <p:sp>
        <p:nvSpPr>
          <p:cNvPr id="76" name=""/>
          <p:cNvSpPr/>
          <p:nvPr/>
        </p:nvSpPr>
        <p:spPr>
          <a:xfrm>
            <a:off x="1908000" y="4221000"/>
            <a:ext cx="540072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1692360" y="4869000"/>
            <a:ext cx="55450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1-07-25T15:17:29Z</dcterms:created>
  <dc:creator>gisp</dc:creator>
  <dc:description/>
  <dc:language>en-US</dc:language>
  <cp:lastModifiedBy>Dip.Biologia Biologia</cp:lastModifiedBy>
  <dcterms:modified xsi:type="dcterms:W3CDTF">2010-01-12T11:16:48Z</dcterms:modified>
  <cp:revision>354</cp:revision>
  <dc:subject/>
  <dc:title>Presentazione di PowerPoint</dc:title>
</cp:coreProperties>
</file>